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screen4x3"/>
  <p:notesSz cx="6858000" cy="9144000"/>
  <p:defaultTextStyle>
    <a:defPPr>
      <a:defRPr lang="nb-NO"/>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969">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showGuides="1">
      <p:cViewPr>
        <p:scale>
          <a:sx n="100" d="100"/>
          <a:sy n="100" d="100"/>
        </p:scale>
        <p:origin x="1704" y="-444"/>
      </p:cViewPr>
      <p:guideLst>
        <p:guide orient="horz" pos="3969"/>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D:\important%20data%202013\exp%202010\Growth%20experiments%202010.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5"/>
    </mc:Choice>
    <mc:Fallback>
      <c:style val="5"/>
    </mc:Fallback>
  </mc:AlternateContent>
  <c:chart>
    <c:autoTitleDeleted val="0"/>
    <c:plotArea>
      <c:layout>
        <c:manualLayout>
          <c:layoutTarget val="inner"/>
          <c:xMode val="edge"/>
          <c:yMode val="edge"/>
          <c:x val="0.13089129483814524"/>
          <c:y val="0.15788203557888625"/>
          <c:w val="0.71895734908136388"/>
          <c:h val="0.64280475357247235"/>
        </c:manualLayout>
      </c:layout>
      <c:barChart>
        <c:barDir val="col"/>
        <c:grouping val="clustered"/>
        <c:varyColors val="0"/>
        <c:ser>
          <c:idx val="0"/>
          <c:order val="0"/>
          <c:invertIfNegative val="0"/>
          <c:dPt>
            <c:idx val="0"/>
            <c:invertIfNegative val="0"/>
            <c:bubble3D val="0"/>
            <c:spPr>
              <a:solidFill>
                <a:schemeClr val="bg1">
                  <a:lumMod val="65000"/>
                </a:schemeClr>
              </a:solidFill>
            </c:spPr>
          </c:dPt>
          <c:dPt>
            <c:idx val="1"/>
            <c:invertIfNegative val="0"/>
            <c:bubble3D val="0"/>
            <c:spPr>
              <a:solidFill>
                <a:schemeClr val="bg1">
                  <a:lumMod val="65000"/>
                </a:schemeClr>
              </a:solidFill>
            </c:spPr>
          </c:dPt>
          <c:dPt>
            <c:idx val="2"/>
            <c:invertIfNegative val="0"/>
            <c:bubble3D val="0"/>
            <c:spPr>
              <a:solidFill>
                <a:schemeClr val="bg1">
                  <a:lumMod val="65000"/>
                </a:schemeClr>
              </a:solidFill>
            </c:spPr>
          </c:dPt>
          <c:errBars>
            <c:errBarType val="plus"/>
            <c:errValType val="cust"/>
            <c:noEndCap val="0"/>
            <c:plus>
              <c:numRef>
                <c:f>Sheet1!$H$39:$J$39</c:f>
                <c:numCache>
                  <c:formatCode>General</c:formatCode>
                  <c:ptCount val="3"/>
                  <c:pt idx="0">
                    <c:v>10.66979166666667</c:v>
                  </c:pt>
                  <c:pt idx="1">
                    <c:v>12.611111111111093</c:v>
                  </c:pt>
                  <c:pt idx="2">
                    <c:v>8.3194444444444571</c:v>
                  </c:pt>
                </c:numCache>
              </c:numRef>
            </c:plus>
            <c:minus>
              <c:numRef>
                <c:f>Sheet1!$H$39:$J$39</c:f>
                <c:numCache>
                  <c:formatCode>General</c:formatCode>
                  <c:ptCount val="3"/>
                  <c:pt idx="0">
                    <c:v>10.66979166666667</c:v>
                  </c:pt>
                  <c:pt idx="1">
                    <c:v>12.611111111111093</c:v>
                  </c:pt>
                  <c:pt idx="2">
                    <c:v>8.3194444444444571</c:v>
                  </c:pt>
                </c:numCache>
              </c:numRef>
            </c:minus>
          </c:errBars>
          <c:cat>
            <c:strLit>
              <c:ptCount val="1"/>
              <c:pt idx="0">
                <c:v>cut at AXB 10</c:v>
              </c:pt>
            </c:strLit>
          </c:cat>
          <c:val>
            <c:numRef>
              <c:f>Sheet1!$H$38:$J$38</c:f>
              <c:numCache>
                <c:formatCode>General</c:formatCode>
                <c:ptCount val="3"/>
                <c:pt idx="0">
                  <c:v>41.829166666666588</c:v>
                </c:pt>
                <c:pt idx="1">
                  <c:v>25.83333333333329</c:v>
                </c:pt>
                <c:pt idx="2">
                  <c:v>67.236111111111114</c:v>
                </c:pt>
              </c:numCache>
            </c:numRef>
          </c:val>
        </c:ser>
        <c:dLbls>
          <c:showLegendKey val="0"/>
          <c:showVal val="0"/>
          <c:showCatName val="0"/>
          <c:showSerName val="0"/>
          <c:showPercent val="0"/>
          <c:showBubbleSize val="0"/>
        </c:dLbls>
        <c:gapWidth val="59"/>
        <c:axId val="491356224"/>
        <c:axId val="491356616"/>
      </c:barChart>
      <c:catAx>
        <c:axId val="491356224"/>
        <c:scaling>
          <c:orientation val="minMax"/>
        </c:scaling>
        <c:delete val="0"/>
        <c:axPos val="b"/>
        <c:numFmt formatCode="General" sourceLinked="1"/>
        <c:majorTickMark val="out"/>
        <c:minorTickMark val="none"/>
        <c:tickLblPos val="nextTo"/>
        <c:txPr>
          <a:bodyPr/>
          <a:lstStyle/>
          <a:p>
            <a:pPr>
              <a:defRPr sz="1000">
                <a:latin typeface="Arial" pitchFamily="34" charset="0"/>
                <a:cs typeface="Arial" pitchFamily="34" charset="0"/>
              </a:defRPr>
            </a:pPr>
            <a:endParaRPr lang="en-US"/>
          </a:p>
        </c:txPr>
        <c:crossAx val="491356616"/>
        <c:crosses val="autoZero"/>
        <c:auto val="1"/>
        <c:lblAlgn val="ctr"/>
        <c:lblOffset val="100"/>
        <c:noMultiLvlLbl val="0"/>
      </c:catAx>
      <c:valAx>
        <c:axId val="491356616"/>
        <c:scaling>
          <c:orientation val="minMax"/>
        </c:scaling>
        <c:delete val="0"/>
        <c:axPos val="l"/>
        <c:numFmt formatCode="General" sourceLinked="1"/>
        <c:majorTickMark val="out"/>
        <c:minorTickMark val="none"/>
        <c:tickLblPos val="nextTo"/>
        <c:txPr>
          <a:bodyPr/>
          <a:lstStyle/>
          <a:p>
            <a:pPr>
              <a:defRPr sz="1200">
                <a:latin typeface="Arial" panose="020B0604020202020204" pitchFamily="34" charset="0"/>
                <a:cs typeface="Arial" panose="020B0604020202020204" pitchFamily="34" charset="0"/>
              </a:defRPr>
            </a:pPr>
            <a:endParaRPr lang="en-US"/>
          </a:p>
        </c:txPr>
        <c:crossAx val="491356224"/>
        <c:crosses val="autoZero"/>
        <c:crossBetween val="between"/>
      </c:valAx>
    </c:plotArea>
    <c:plotVisOnly val="1"/>
    <c:dispBlanksAs val="gap"/>
    <c:showDLblsOverMax val="0"/>
  </c:chart>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nb-NO"/>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nb-NO"/>
          </a:p>
        </p:txBody>
      </p:sp>
      <p:sp>
        <p:nvSpPr>
          <p:cNvPr id="4" name="Date Placeholder 3"/>
          <p:cNvSpPr>
            <a:spLocks noGrp="1"/>
          </p:cNvSpPr>
          <p:nvPr>
            <p:ph type="dt" sz="half" idx="10"/>
          </p:nvPr>
        </p:nvSpPr>
        <p:spPr/>
        <p:txBody>
          <a:bodyPr/>
          <a:lstStyle/>
          <a:p>
            <a:fld id="{80703178-684F-4F7E-9BBE-CC7212C07150}" type="datetimeFigureOut">
              <a:rPr lang="nb-NO" smtClean="0"/>
              <a:pPr/>
              <a:t>28.07.2015</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E417AB3A-907E-46D9-B399-67EC613B6393}" type="slidenum">
              <a:rPr lang="nb-NO" smtClean="0"/>
              <a:pPr/>
              <a:t>‹#›</a:t>
            </a:fld>
            <a:endParaRPr lang="nb-NO"/>
          </a:p>
        </p:txBody>
      </p:sp>
    </p:spTree>
    <p:extLst>
      <p:ext uri="{BB962C8B-B14F-4D97-AF65-F5344CB8AC3E}">
        <p14:creationId xmlns:p14="http://schemas.microsoft.com/office/powerpoint/2010/main" val="32871747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nb-NO"/>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b-NO"/>
          </a:p>
        </p:txBody>
      </p:sp>
      <p:sp>
        <p:nvSpPr>
          <p:cNvPr id="4" name="Date Placeholder 3"/>
          <p:cNvSpPr>
            <a:spLocks noGrp="1"/>
          </p:cNvSpPr>
          <p:nvPr>
            <p:ph type="dt" sz="half" idx="10"/>
          </p:nvPr>
        </p:nvSpPr>
        <p:spPr/>
        <p:txBody>
          <a:bodyPr/>
          <a:lstStyle/>
          <a:p>
            <a:fld id="{80703178-684F-4F7E-9BBE-CC7212C07150}" type="datetimeFigureOut">
              <a:rPr lang="nb-NO" smtClean="0"/>
              <a:pPr/>
              <a:t>28.07.2015</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E417AB3A-907E-46D9-B399-67EC613B6393}" type="slidenum">
              <a:rPr lang="nb-NO" smtClean="0"/>
              <a:pPr/>
              <a:t>‹#›</a:t>
            </a:fld>
            <a:endParaRPr lang="nb-NO"/>
          </a:p>
        </p:txBody>
      </p:sp>
    </p:spTree>
    <p:extLst>
      <p:ext uri="{BB962C8B-B14F-4D97-AF65-F5344CB8AC3E}">
        <p14:creationId xmlns:p14="http://schemas.microsoft.com/office/powerpoint/2010/main" val="34212425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nb-NO"/>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b-NO"/>
          </a:p>
        </p:txBody>
      </p:sp>
      <p:sp>
        <p:nvSpPr>
          <p:cNvPr id="4" name="Date Placeholder 3"/>
          <p:cNvSpPr>
            <a:spLocks noGrp="1"/>
          </p:cNvSpPr>
          <p:nvPr>
            <p:ph type="dt" sz="half" idx="10"/>
          </p:nvPr>
        </p:nvSpPr>
        <p:spPr/>
        <p:txBody>
          <a:bodyPr/>
          <a:lstStyle/>
          <a:p>
            <a:fld id="{80703178-684F-4F7E-9BBE-CC7212C07150}" type="datetimeFigureOut">
              <a:rPr lang="nb-NO" smtClean="0"/>
              <a:pPr/>
              <a:t>28.07.2015</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E417AB3A-907E-46D9-B399-67EC613B6393}" type="slidenum">
              <a:rPr lang="nb-NO" smtClean="0"/>
              <a:pPr/>
              <a:t>‹#›</a:t>
            </a:fld>
            <a:endParaRPr lang="nb-NO"/>
          </a:p>
        </p:txBody>
      </p:sp>
    </p:spTree>
    <p:extLst>
      <p:ext uri="{BB962C8B-B14F-4D97-AF65-F5344CB8AC3E}">
        <p14:creationId xmlns:p14="http://schemas.microsoft.com/office/powerpoint/2010/main" val="12556154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nb-NO"/>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b-NO"/>
          </a:p>
        </p:txBody>
      </p:sp>
      <p:sp>
        <p:nvSpPr>
          <p:cNvPr id="4" name="Date Placeholder 3"/>
          <p:cNvSpPr>
            <a:spLocks noGrp="1"/>
          </p:cNvSpPr>
          <p:nvPr>
            <p:ph type="dt" sz="half" idx="10"/>
          </p:nvPr>
        </p:nvSpPr>
        <p:spPr/>
        <p:txBody>
          <a:bodyPr/>
          <a:lstStyle/>
          <a:p>
            <a:fld id="{80703178-684F-4F7E-9BBE-CC7212C07150}" type="datetimeFigureOut">
              <a:rPr lang="nb-NO" smtClean="0"/>
              <a:pPr/>
              <a:t>28.07.2015</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E417AB3A-907E-46D9-B399-67EC613B6393}" type="slidenum">
              <a:rPr lang="nb-NO" smtClean="0"/>
              <a:pPr/>
              <a:t>‹#›</a:t>
            </a:fld>
            <a:endParaRPr lang="nb-NO"/>
          </a:p>
        </p:txBody>
      </p:sp>
    </p:spTree>
    <p:extLst>
      <p:ext uri="{BB962C8B-B14F-4D97-AF65-F5344CB8AC3E}">
        <p14:creationId xmlns:p14="http://schemas.microsoft.com/office/powerpoint/2010/main" val="41627631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nb-NO"/>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0703178-684F-4F7E-9BBE-CC7212C07150}" type="datetimeFigureOut">
              <a:rPr lang="nb-NO" smtClean="0"/>
              <a:pPr/>
              <a:t>28.07.2015</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E417AB3A-907E-46D9-B399-67EC613B6393}" type="slidenum">
              <a:rPr lang="nb-NO" smtClean="0"/>
              <a:pPr/>
              <a:t>‹#›</a:t>
            </a:fld>
            <a:endParaRPr lang="nb-NO"/>
          </a:p>
        </p:txBody>
      </p:sp>
    </p:spTree>
    <p:extLst>
      <p:ext uri="{BB962C8B-B14F-4D97-AF65-F5344CB8AC3E}">
        <p14:creationId xmlns:p14="http://schemas.microsoft.com/office/powerpoint/2010/main" val="22545058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nb-NO"/>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b-NO"/>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b-NO"/>
          </a:p>
        </p:txBody>
      </p:sp>
      <p:sp>
        <p:nvSpPr>
          <p:cNvPr id="5" name="Date Placeholder 4"/>
          <p:cNvSpPr>
            <a:spLocks noGrp="1"/>
          </p:cNvSpPr>
          <p:nvPr>
            <p:ph type="dt" sz="half" idx="10"/>
          </p:nvPr>
        </p:nvSpPr>
        <p:spPr/>
        <p:txBody>
          <a:bodyPr/>
          <a:lstStyle/>
          <a:p>
            <a:fld id="{80703178-684F-4F7E-9BBE-CC7212C07150}" type="datetimeFigureOut">
              <a:rPr lang="nb-NO" smtClean="0"/>
              <a:pPr/>
              <a:t>28.07.2015</a:t>
            </a:fld>
            <a:endParaRPr lang="nb-NO"/>
          </a:p>
        </p:txBody>
      </p:sp>
      <p:sp>
        <p:nvSpPr>
          <p:cNvPr id="6" name="Footer Placeholder 5"/>
          <p:cNvSpPr>
            <a:spLocks noGrp="1"/>
          </p:cNvSpPr>
          <p:nvPr>
            <p:ph type="ftr" sz="quarter" idx="11"/>
          </p:nvPr>
        </p:nvSpPr>
        <p:spPr/>
        <p:txBody>
          <a:bodyPr/>
          <a:lstStyle/>
          <a:p>
            <a:endParaRPr lang="nb-NO"/>
          </a:p>
        </p:txBody>
      </p:sp>
      <p:sp>
        <p:nvSpPr>
          <p:cNvPr id="7" name="Slide Number Placeholder 6"/>
          <p:cNvSpPr>
            <a:spLocks noGrp="1"/>
          </p:cNvSpPr>
          <p:nvPr>
            <p:ph type="sldNum" sz="quarter" idx="12"/>
          </p:nvPr>
        </p:nvSpPr>
        <p:spPr/>
        <p:txBody>
          <a:bodyPr/>
          <a:lstStyle/>
          <a:p>
            <a:fld id="{E417AB3A-907E-46D9-B399-67EC613B6393}" type="slidenum">
              <a:rPr lang="nb-NO" smtClean="0"/>
              <a:pPr/>
              <a:t>‹#›</a:t>
            </a:fld>
            <a:endParaRPr lang="nb-NO"/>
          </a:p>
        </p:txBody>
      </p:sp>
    </p:spTree>
    <p:extLst>
      <p:ext uri="{BB962C8B-B14F-4D97-AF65-F5344CB8AC3E}">
        <p14:creationId xmlns:p14="http://schemas.microsoft.com/office/powerpoint/2010/main" val="23602985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nb-NO"/>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b-NO"/>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b-NO"/>
          </a:p>
        </p:txBody>
      </p:sp>
      <p:sp>
        <p:nvSpPr>
          <p:cNvPr id="7" name="Date Placeholder 6"/>
          <p:cNvSpPr>
            <a:spLocks noGrp="1"/>
          </p:cNvSpPr>
          <p:nvPr>
            <p:ph type="dt" sz="half" idx="10"/>
          </p:nvPr>
        </p:nvSpPr>
        <p:spPr/>
        <p:txBody>
          <a:bodyPr/>
          <a:lstStyle/>
          <a:p>
            <a:fld id="{80703178-684F-4F7E-9BBE-CC7212C07150}" type="datetimeFigureOut">
              <a:rPr lang="nb-NO" smtClean="0"/>
              <a:pPr/>
              <a:t>28.07.2015</a:t>
            </a:fld>
            <a:endParaRPr lang="nb-NO"/>
          </a:p>
        </p:txBody>
      </p:sp>
      <p:sp>
        <p:nvSpPr>
          <p:cNvPr id="8" name="Footer Placeholder 7"/>
          <p:cNvSpPr>
            <a:spLocks noGrp="1"/>
          </p:cNvSpPr>
          <p:nvPr>
            <p:ph type="ftr" sz="quarter" idx="11"/>
          </p:nvPr>
        </p:nvSpPr>
        <p:spPr/>
        <p:txBody>
          <a:bodyPr/>
          <a:lstStyle/>
          <a:p>
            <a:endParaRPr lang="nb-NO"/>
          </a:p>
        </p:txBody>
      </p:sp>
      <p:sp>
        <p:nvSpPr>
          <p:cNvPr id="9" name="Slide Number Placeholder 8"/>
          <p:cNvSpPr>
            <a:spLocks noGrp="1"/>
          </p:cNvSpPr>
          <p:nvPr>
            <p:ph type="sldNum" sz="quarter" idx="12"/>
          </p:nvPr>
        </p:nvSpPr>
        <p:spPr/>
        <p:txBody>
          <a:bodyPr/>
          <a:lstStyle/>
          <a:p>
            <a:fld id="{E417AB3A-907E-46D9-B399-67EC613B6393}" type="slidenum">
              <a:rPr lang="nb-NO" smtClean="0"/>
              <a:pPr/>
              <a:t>‹#›</a:t>
            </a:fld>
            <a:endParaRPr lang="nb-NO"/>
          </a:p>
        </p:txBody>
      </p:sp>
    </p:spTree>
    <p:extLst>
      <p:ext uri="{BB962C8B-B14F-4D97-AF65-F5344CB8AC3E}">
        <p14:creationId xmlns:p14="http://schemas.microsoft.com/office/powerpoint/2010/main" val="41900691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nb-NO"/>
          </a:p>
        </p:txBody>
      </p:sp>
      <p:sp>
        <p:nvSpPr>
          <p:cNvPr id="3" name="Date Placeholder 2"/>
          <p:cNvSpPr>
            <a:spLocks noGrp="1"/>
          </p:cNvSpPr>
          <p:nvPr>
            <p:ph type="dt" sz="half" idx="10"/>
          </p:nvPr>
        </p:nvSpPr>
        <p:spPr/>
        <p:txBody>
          <a:bodyPr/>
          <a:lstStyle/>
          <a:p>
            <a:fld id="{80703178-684F-4F7E-9BBE-CC7212C07150}" type="datetimeFigureOut">
              <a:rPr lang="nb-NO" smtClean="0"/>
              <a:pPr/>
              <a:t>28.07.2015</a:t>
            </a:fld>
            <a:endParaRPr lang="nb-NO"/>
          </a:p>
        </p:txBody>
      </p:sp>
      <p:sp>
        <p:nvSpPr>
          <p:cNvPr id="4" name="Footer Placeholder 3"/>
          <p:cNvSpPr>
            <a:spLocks noGrp="1"/>
          </p:cNvSpPr>
          <p:nvPr>
            <p:ph type="ftr" sz="quarter" idx="11"/>
          </p:nvPr>
        </p:nvSpPr>
        <p:spPr/>
        <p:txBody>
          <a:bodyPr/>
          <a:lstStyle/>
          <a:p>
            <a:endParaRPr lang="nb-NO"/>
          </a:p>
        </p:txBody>
      </p:sp>
      <p:sp>
        <p:nvSpPr>
          <p:cNvPr id="5" name="Slide Number Placeholder 4"/>
          <p:cNvSpPr>
            <a:spLocks noGrp="1"/>
          </p:cNvSpPr>
          <p:nvPr>
            <p:ph type="sldNum" sz="quarter" idx="12"/>
          </p:nvPr>
        </p:nvSpPr>
        <p:spPr/>
        <p:txBody>
          <a:bodyPr/>
          <a:lstStyle/>
          <a:p>
            <a:fld id="{E417AB3A-907E-46D9-B399-67EC613B6393}" type="slidenum">
              <a:rPr lang="nb-NO" smtClean="0"/>
              <a:pPr/>
              <a:t>‹#›</a:t>
            </a:fld>
            <a:endParaRPr lang="nb-NO"/>
          </a:p>
        </p:txBody>
      </p:sp>
    </p:spTree>
    <p:extLst>
      <p:ext uri="{BB962C8B-B14F-4D97-AF65-F5344CB8AC3E}">
        <p14:creationId xmlns:p14="http://schemas.microsoft.com/office/powerpoint/2010/main" val="12017654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0703178-684F-4F7E-9BBE-CC7212C07150}" type="datetimeFigureOut">
              <a:rPr lang="nb-NO" smtClean="0"/>
              <a:pPr/>
              <a:t>28.07.2015</a:t>
            </a:fld>
            <a:endParaRPr lang="nb-NO"/>
          </a:p>
        </p:txBody>
      </p:sp>
      <p:sp>
        <p:nvSpPr>
          <p:cNvPr id="3" name="Footer Placeholder 2"/>
          <p:cNvSpPr>
            <a:spLocks noGrp="1"/>
          </p:cNvSpPr>
          <p:nvPr>
            <p:ph type="ftr" sz="quarter" idx="11"/>
          </p:nvPr>
        </p:nvSpPr>
        <p:spPr/>
        <p:txBody>
          <a:bodyPr/>
          <a:lstStyle/>
          <a:p>
            <a:endParaRPr lang="nb-NO"/>
          </a:p>
        </p:txBody>
      </p:sp>
      <p:sp>
        <p:nvSpPr>
          <p:cNvPr id="4" name="Slide Number Placeholder 3"/>
          <p:cNvSpPr>
            <a:spLocks noGrp="1"/>
          </p:cNvSpPr>
          <p:nvPr>
            <p:ph type="sldNum" sz="quarter" idx="12"/>
          </p:nvPr>
        </p:nvSpPr>
        <p:spPr/>
        <p:txBody>
          <a:bodyPr/>
          <a:lstStyle/>
          <a:p>
            <a:fld id="{E417AB3A-907E-46D9-B399-67EC613B6393}" type="slidenum">
              <a:rPr lang="nb-NO" smtClean="0"/>
              <a:pPr/>
              <a:t>‹#›</a:t>
            </a:fld>
            <a:endParaRPr lang="nb-NO"/>
          </a:p>
        </p:txBody>
      </p:sp>
    </p:spTree>
    <p:extLst>
      <p:ext uri="{BB962C8B-B14F-4D97-AF65-F5344CB8AC3E}">
        <p14:creationId xmlns:p14="http://schemas.microsoft.com/office/powerpoint/2010/main" val="21269158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nb-NO"/>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b-NO"/>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0703178-684F-4F7E-9BBE-CC7212C07150}" type="datetimeFigureOut">
              <a:rPr lang="nb-NO" smtClean="0"/>
              <a:pPr/>
              <a:t>28.07.2015</a:t>
            </a:fld>
            <a:endParaRPr lang="nb-NO"/>
          </a:p>
        </p:txBody>
      </p:sp>
      <p:sp>
        <p:nvSpPr>
          <p:cNvPr id="6" name="Footer Placeholder 5"/>
          <p:cNvSpPr>
            <a:spLocks noGrp="1"/>
          </p:cNvSpPr>
          <p:nvPr>
            <p:ph type="ftr" sz="quarter" idx="11"/>
          </p:nvPr>
        </p:nvSpPr>
        <p:spPr/>
        <p:txBody>
          <a:bodyPr/>
          <a:lstStyle/>
          <a:p>
            <a:endParaRPr lang="nb-NO"/>
          </a:p>
        </p:txBody>
      </p:sp>
      <p:sp>
        <p:nvSpPr>
          <p:cNvPr id="7" name="Slide Number Placeholder 6"/>
          <p:cNvSpPr>
            <a:spLocks noGrp="1"/>
          </p:cNvSpPr>
          <p:nvPr>
            <p:ph type="sldNum" sz="quarter" idx="12"/>
          </p:nvPr>
        </p:nvSpPr>
        <p:spPr/>
        <p:txBody>
          <a:bodyPr/>
          <a:lstStyle/>
          <a:p>
            <a:fld id="{E417AB3A-907E-46D9-B399-67EC613B6393}" type="slidenum">
              <a:rPr lang="nb-NO" smtClean="0"/>
              <a:pPr/>
              <a:t>‹#›</a:t>
            </a:fld>
            <a:endParaRPr lang="nb-NO"/>
          </a:p>
        </p:txBody>
      </p:sp>
    </p:spTree>
    <p:extLst>
      <p:ext uri="{BB962C8B-B14F-4D97-AF65-F5344CB8AC3E}">
        <p14:creationId xmlns:p14="http://schemas.microsoft.com/office/powerpoint/2010/main" val="38351345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nb-NO"/>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nb-NO"/>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0703178-684F-4F7E-9BBE-CC7212C07150}" type="datetimeFigureOut">
              <a:rPr lang="nb-NO" smtClean="0"/>
              <a:pPr/>
              <a:t>28.07.2015</a:t>
            </a:fld>
            <a:endParaRPr lang="nb-NO"/>
          </a:p>
        </p:txBody>
      </p:sp>
      <p:sp>
        <p:nvSpPr>
          <p:cNvPr id="6" name="Footer Placeholder 5"/>
          <p:cNvSpPr>
            <a:spLocks noGrp="1"/>
          </p:cNvSpPr>
          <p:nvPr>
            <p:ph type="ftr" sz="quarter" idx="11"/>
          </p:nvPr>
        </p:nvSpPr>
        <p:spPr/>
        <p:txBody>
          <a:bodyPr/>
          <a:lstStyle/>
          <a:p>
            <a:endParaRPr lang="nb-NO"/>
          </a:p>
        </p:txBody>
      </p:sp>
      <p:sp>
        <p:nvSpPr>
          <p:cNvPr id="7" name="Slide Number Placeholder 6"/>
          <p:cNvSpPr>
            <a:spLocks noGrp="1"/>
          </p:cNvSpPr>
          <p:nvPr>
            <p:ph type="sldNum" sz="quarter" idx="12"/>
          </p:nvPr>
        </p:nvSpPr>
        <p:spPr/>
        <p:txBody>
          <a:bodyPr/>
          <a:lstStyle/>
          <a:p>
            <a:fld id="{E417AB3A-907E-46D9-B399-67EC613B6393}" type="slidenum">
              <a:rPr lang="nb-NO" smtClean="0"/>
              <a:pPr/>
              <a:t>‹#›</a:t>
            </a:fld>
            <a:endParaRPr lang="nb-NO"/>
          </a:p>
        </p:txBody>
      </p:sp>
    </p:spTree>
    <p:extLst>
      <p:ext uri="{BB962C8B-B14F-4D97-AF65-F5344CB8AC3E}">
        <p14:creationId xmlns:p14="http://schemas.microsoft.com/office/powerpoint/2010/main" val="7349479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nb-NO"/>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b-NO"/>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80703178-684F-4F7E-9BBE-CC7212C07150}" type="datetimeFigureOut">
              <a:rPr lang="nb-NO" smtClean="0"/>
              <a:pPr/>
              <a:t>28.07.2015</a:t>
            </a:fld>
            <a:endParaRPr lang="nb-NO"/>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nb-NO"/>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E417AB3A-907E-46D9-B399-67EC613B6393}" type="slidenum">
              <a:rPr lang="nb-NO" smtClean="0"/>
              <a:pPr/>
              <a:t>‹#›</a:t>
            </a:fld>
            <a:endParaRPr lang="nb-NO"/>
          </a:p>
        </p:txBody>
      </p:sp>
    </p:spTree>
    <p:extLst>
      <p:ext uri="{BB962C8B-B14F-4D97-AF65-F5344CB8AC3E}">
        <p14:creationId xmlns:p14="http://schemas.microsoft.com/office/powerpoint/2010/main" val="202877375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nb-NO"/>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4230442" y="171603"/>
            <a:ext cx="2531462" cy="369332"/>
          </a:xfrm>
          <a:prstGeom prst="rect">
            <a:avLst/>
          </a:prstGeom>
          <a:noFill/>
        </p:spPr>
        <p:txBody>
          <a:bodyPr wrap="none" rtlCol="0">
            <a:spAutoFit/>
          </a:bodyPr>
          <a:lstStyle/>
          <a:p>
            <a:r>
              <a:rPr lang="nb-NO" dirty="0" smtClean="0">
                <a:latin typeface="Arial" pitchFamily="34" charset="0"/>
                <a:cs typeface="Arial" pitchFamily="34" charset="0"/>
              </a:rPr>
              <a:t>Supplementary Fig.S1.</a:t>
            </a:r>
            <a:endParaRPr lang="nb-NO" dirty="0">
              <a:latin typeface="Arial" pitchFamily="34" charset="0"/>
              <a:cs typeface="Arial" pitchFamily="34" charset="0"/>
            </a:endParaRPr>
          </a:p>
        </p:txBody>
      </p:sp>
      <p:grpSp>
        <p:nvGrpSpPr>
          <p:cNvPr id="2" name="Group 1"/>
          <p:cNvGrpSpPr/>
          <p:nvPr/>
        </p:nvGrpSpPr>
        <p:grpSpPr>
          <a:xfrm>
            <a:off x="1841841" y="762834"/>
            <a:ext cx="4105538" cy="5386897"/>
            <a:chOff x="1374552" y="625790"/>
            <a:chExt cx="4105538" cy="5386897"/>
          </a:xfrm>
        </p:grpSpPr>
        <p:sp>
          <p:nvSpPr>
            <p:cNvPr id="119" name="TextBox 118"/>
            <p:cNvSpPr txBox="1"/>
            <p:nvPr/>
          </p:nvSpPr>
          <p:spPr>
            <a:xfrm>
              <a:off x="1854630" y="3000862"/>
              <a:ext cx="3625460" cy="246221"/>
            </a:xfrm>
            <a:prstGeom prst="rect">
              <a:avLst/>
            </a:prstGeom>
            <a:noFill/>
          </p:spPr>
          <p:txBody>
            <a:bodyPr wrap="square" rtlCol="0">
              <a:spAutoFit/>
            </a:bodyPr>
            <a:lstStyle/>
            <a:p>
              <a:r>
                <a:rPr lang="en-US" sz="1000" dirty="0" smtClean="0">
                  <a:latin typeface="Arial" panose="020B0604020202020204" pitchFamily="34" charset="0"/>
                  <a:cs typeface="Arial" panose="020B0604020202020204" pitchFamily="34" charset="0"/>
                </a:rPr>
                <a:t>      Decapitated</a:t>
              </a:r>
              <a:endParaRPr lang="en-US" sz="1000" dirty="0">
                <a:latin typeface="Arial" panose="020B0604020202020204" pitchFamily="34" charset="0"/>
                <a:cs typeface="Arial" panose="020B0604020202020204" pitchFamily="34" charset="0"/>
              </a:endParaRPr>
            </a:p>
          </p:txBody>
        </p:sp>
        <p:sp>
          <p:nvSpPr>
            <p:cNvPr id="296" name="TextBox 295"/>
            <p:cNvSpPr txBox="1"/>
            <p:nvPr/>
          </p:nvSpPr>
          <p:spPr>
            <a:xfrm>
              <a:off x="1374552" y="625790"/>
              <a:ext cx="295274" cy="276999"/>
            </a:xfrm>
            <a:prstGeom prst="rect">
              <a:avLst/>
            </a:prstGeom>
            <a:noFill/>
          </p:spPr>
          <p:txBody>
            <a:bodyPr wrap="none" rtlCol="0">
              <a:spAutoFit/>
            </a:bodyPr>
            <a:lstStyle/>
            <a:p>
              <a:r>
                <a:rPr lang="nb-NO" sz="1200" b="1" dirty="0">
                  <a:latin typeface="Arial" pitchFamily="34" charset="0"/>
                  <a:cs typeface="Arial" pitchFamily="34" charset="0"/>
                </a:rPr>
                <a:t>A</a:t>
              </a:r>
            </a:p>
          </p:txBody>
        </p:sp>
        <p:grpSp>
          <p:nvGrpSpPr>
            <p:cNvPr id="310" name="Group 309"/>
            <p:cNvGrpSpPr/>
            <p:nvPr/>
          </p:nvGrpSpPr>
          <p:grpSpPr>
            <a:xfrm>
              <a:off x="1854630" y="768614"/>
              <a:ext cx="1160826" cy="2101641"/>
              <a:chOff x="1628800" y="3960000"/>
              <a:chExt cx="1160826" cy="2101641"/>
            </a:xfrm>
          </p:grpSpPr>
          <p:grpSp>
            <p:nvGrpSpPr>
              <p:cNvPr id="120" name="Group 119"/>
              <p:cNvGrpSpPr/>
              <p:nvPr/>
            </p:nvGrpSpPr>
            <p:grpSpPr>
              <a:xfrm>
                <a:off x="1628800" y="4248479"/>
                <a:ext cx="1124989" cy="1813162"/>
                <a:chOff x="683915" y="447574"/>
                <a:chExt cx="2807964" cy="5126560"/>
              </a:xfrm>
            </p:grpSpPr>
            <p:grpSp>
              <p:nvGrpSpPr>
                <p:cNvPr id="121" name="Group 99"/>
                <p:cNvGrpSpPr/>
                <p:nvPr/>
              </p:nvGrpSpPr>
              <p:grpSpPr>
                <a:xfrm rot="19727531">
                  <a:off x="2177516" y="447574"/>
                  <a:ext cx="139413" cy="224576"/>
                  <a:chOff x="2714171" y="2104571"/>
                  <a:chExt cx="740229" cy="464458"/>
                </a:xfrm>
              </p:grpSpPr>
              <p:sp>
                <p:nvSpPr>
                  <p:cNvPr id="223" name="Freeform 222"/>
                  <p:cNvSpPr/>
                  <p:nvPr/>
                </p:nvSpPr>
                <p:spPr>
                  <a:xfrm>
                    <a:off x="2931886" y="2336800"/>
                    <a:ext cx="319314" cy="154819"/>
                  </a:xfrm>
                  <a:custGeom>
                    <a:avLst/>
                    <a:gdLst>
                      <a:gd name="connsiteX0" fmla="*/ 0 w 319314"/>
                      <a:gd name="connsiteY0" fmla="*/ 0 h 154819"/>
                      <a:gd name="connsiteX1" fmla="*/ 87085 w 319314"/>
                      <a:gd name="connsiteY1" fmla="*/ 87086 h 154819"/>
                      <a:gd name="connsiteX2" fmla="*/ 232228 w 319314"/>
                      <a:gd name="connsiteY2" fmla="*/ 145143 h 154819"/>
                      <a:gd name="connsiteX3" fmla="*/ 319314 w 319314"/>
                      <a:gd name="connsiteY3" fmla="*/ 145143 h 154819"/>
                    </a:gdLst>
                    <a:ahLst/>
                    <a:cxnLst>
                      <a:cxn ang="0">
                        <a:pos x="connsiteX0" y="connsiteY0"/>
                      </a:cxn>
                      <a:cxn ang="0">
                        <a:pos x="connsiteX1" y="connsiteY1"/>
                      </a:cxn>
                      <a:cxn ang="0">
                        <a:pos x="connsiteX2" y="connsiteY2"/>
                      </a:cxn>
                      <a:cxn ang="0">
                        <a:pos x="connsiteX3" y="connsiteY3"/>
                      </a:cxn>
                    </a:cxnLst>
                    <a:rect l="l" t="t" r="r" b="b"/>
                    <a:pathLst>
                      <a:path w="319314" h="154819">
                        <a:moveTo>
                          <a:pt x="0" y="0"/>
                        </a:moveTo>
                        <a:cubicBezTo>
                          <a:pt x="24190" y="31448"/>
                          <a:pt x="48380" y="62896"/>
                          <a:pt x="87085" y="87086"/>
                        </a:cubicBezTo>
                        <a:cubicBezTo>
                          <a:pt x="125790" y="111276"/>
                          <a:pt x="193523" y="135467"/>
                          <a:pt x="232228" y="145143"/>
                        </a:cubicBezTo>
                        <a:cubicBezTo>
                          <a:pt x="270933" y="154819"/>
                          <a:pt x="295123" y="149981"/>
                          <a:pt x="319314" y="145143"/>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24" name="Freeform 223"/>
                  <p:cNvSpPr/>
                  <p:nvPr/>
                </p:nvSpPr>
                <p:spPr>
                  <a:xfrm>
                    <a:off x="3077029" y="2220686"/>
                    <a:ext cx="290285" cy="120952"/>
                  </a:xfrm>
                  <a:custGeom>
                    <a:avLst/>
                    <a:gdLst>
                      <a:gd name="connsiteX0" fmla="*/ 0 w 290285"/>
                      <a:gd name="connsiteY0" fmla="*/ 0 h 120952"/>
                      <a:gd name="connsiteX1" fmla="*/ 188685 w 290285"/>
                      <a:gd name="connsiteY1" fmla="*/ 101600 h 120952"/>
                      <a:gd name="connsiteX2" fmla="*/ 290285 w 290285"/>
                      <a:gd name="connsiteY2" fmla="*/ 116114 h 120952"/>
                    </a:gdLst>
                    <a:ahLst/>
                    <a:cxnLst>
                      <a:cxn ang="0">
                        <a:pos x="connsiteX0" y="connsiteY0"/>
                      </a:cxn>
                      <a:cxn ang="0">
                        <a:pos x="connsiteX1" y="connsiteY1"/>
                      </a:cxn>
                      <a:cxn ang="0">
                        <a:pos x="connsiteX2" y="connsiteY2"/>
                      </a:cxn>
                    </a:cxnLst>
                    <a:rect l="l" t="t" r="r" b="b"/>
                    <a:pathLst>
                      <a:path w="290285" h="120952">
                        <a:moveTo>
                          <a:pt x="0" y="0"/>
                        </a:moveTo>
                        <a:cubicBezTo>
                          <a:pt x="70152" y="41124"/>
                          <a:pt x="140304" y="82248"/>
                          <a:pt x="188685" y="101600"/>
                        </a:cubicBezTo>
                        <a:cubicBezTo>
                          <a:pt x="237066" y="120952"/>
                          <a:pt x="263675" y="118533"/>
                          <a:pt x="290285" y="116114"/>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25" name="Freeform 224"/>
                  <p:cNvSpPr/>
                  <p:nvPr/>
                </p:nvSpPr>
                <p:spPr>
                  <a:xfrm>
                    <a:off x="2743200" y="2119086"/>
                    <a:ext cx="14514" cy="275771"/>
                  </a:xfrm>
                  <a:custGeom>
                    <a:avLst/>
                    <a:gdLst>
                      <a:gd name="connsiteX0" fmla="*/ 14514 w 14514"/>
                      <a:gd name="connsiteY0" fmla="*/ 275771 h 275771"/>
                      <a:gd name="connsiteX1" fmla="*/ 0 w 14514"/>
                      <a:gd name="connsiteY1" fmla="*/ 174171 h 275771"/>
                      <a:gd name="connsiteX2" fmla="*/ 14514 w 14514"/>
                      <a:gd name="connsiteY2" fmla="*/ 0 h 275771"/>
                    </a:gdLst>
                    <a:ahLst/>
                    <a:cxnLst>
                      <a:cxn ang="0">
                        <a:pos x="connsiteX0" y="connsiteY0"/>
                      </a:cxn>
                      <a:cxn ang="0">
                        <a:pos x="connsiteX1" y="connsiteY1"/>
                      </a:cxn>
                      <a:cxn ang="0">
                        <a:pos x="connsiteX2" y="connsiteY2"/>
                      </a:cxn>
                    </a:cxnLst>
                    <a:rect l="l" t="t" r="r" b="b"/>
                    <a:pathLst>
                      <a:path w="14514" h="275771">
                        <a:moveTo>
                          <a:pt x="14514" y="275771"/>
                        </a:moveTo>
                        <a:cubicBezTo>
                          <a:pt x="7257" y="247952"/>
                          <a:pt x="0" y="220133"/>
                          <a:pt x="0" y="174171"/>
                        </a:cubicBezTo>
                        <a:cubicBezTo>
                          <a:pt x="0" y="128209"/>
                          <a:pt x="7257" y="64104"/>
                          <a:pt x="14514"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26" name="Freeform 225"/>
                  <p:cNvSpPr/>
                  <p:nvPr/>
                </p:nvSpPr>
                <p:spPr>
                  <a:xfrm>
                    <a:off x="2714171" y="2467429"/>
                    <a:ext cx="217715" cy="101600"/>
                  </a:xfrm>
                  <a:custGeom>
                    <a:avLst/>
                    <a:gdLst>
                      <a:gd name="connsiteX0" fmla="*/ 0 w 217715"/>
                      <a:gd name="connsiteY0" fmla="*/ 0 h 101600"/>
                      <a:gd name="connsiteX1" fmla="*/ 116115 w 217715"/>
                      <a:gd name="connsiteY1" fmla="*/ 72571 h 101600"/>
                      <a:gd name="connsiteX2" fmla="*/ 217715 w 217715"/>
                      <a:gd name="connsiteY2" fmla="*/ 101600 h 101600"/>
                    </a:gdLst>
                    <a:ahLst/>
                    <a:cxnLst>
                      <a:cxn ang="0">
                        <a:pos x="connsiteX0" y="connsiteY0"/>
                      </a:cxn>
                      <a:cxn ang="0">
                        <a:pos x="connsiteX1" y="connsiteY1"/>
                      </a:cxn>
                      <a:cxn ang="0">
                        <a:pos x="connsiteX2" y="connsiteY2"/>
                      </a:cxn>
                    </a:cxnLst>
                    <a:rect l="l" t="t" r="r" b="b"/>
                    <a:pathLst>
                      <a:path w="217715" h="101600">
                        <a:moveTo>
                          <a:pt x="0" y="0"/>
                        </a:moveTo>
                        <a:cubicBezTo>
                          <a:pt x="39914" y="27819"/>
                          <a:pt x="79829" y="55638"/>
                          <a:pt x="116115" y="72571"/>
                        </a:cubicBezTo>
                        <a:cubicBezTo>
                          <a:pt x="152401" y="89504"/>
                          <a:pt x="185058" y="95552"/>
                          <a:pt x="217715" y="10160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27" name="Freeform 226"/>
                  <p:cNvSpPr/>
                  <p:nvPr/>
                </p:nvSpPr>
                <p:spPr>
                  <a:xfrm>
                    <a:off x="3207657" y="2104571"/>
                    <a:ext cx="246743" cy="33867"/>
                  </a:xfrm>
                  <a:custGeom>
                    <a:avLst/>
                    <a:gdLst>
                      <a:gd name="connsiteX0" fmla="*/ 0 w 246743"/>
                      <a:gd name="connsiteY0" fmla="*/ 29029 h 33867"/>
                      <a:gd name="connsiteX1" fmla="*/ 159657 w 246743"/>
                      <a:gd name="connsiteY1" fmla="*/ 29029 h 33867"/>
                      <a:gd name="connsiteX2" fmla="*/ 246743 w 246743"/>
                      <a:gd name="connsiteY2" fmla="*/ 0 h 33867"/>
                    </a:gdLst>
                    <a:ahLst/>
                    <a:cxnLst>
                      <a:cxn ang="0">
                        <a:pos x="connsiteX0" y="connsiteY0"/>
                      </a:cxn>
                      <a:cxn ang="0">
                        <a:pos x="connsiteX1" y="connsiteY1"/>
                      </a:cxn>
                      <a:cxn ang="0">
                        <a:pos x="connsiteX2" y="connsiteY2"/>
                      </a:cxn>
                    </a:cxnLst>
                    <a:rect l="l" t="t" r="r" b="b"/>
                    <a:pathLst>
                      <a:path w="246743" h="33867">
                        <a:moveTo>
                          <a:pt x="0" y="29029"/>
                        </a:moveTo>
                        <a:cubicBezTo>
                          <a:pt x="59266" y="31448"/>
                          <a:pt x="118533" y="33867"/>
                          <a:pt x="159657" y="29029"/>
                        </a:cubicBezTo>
                        <a:cubicBezTo>
                          <a:pt x="200781" y="24191"/>
                          <a:pt x="223762" y="12095"/>
                          <a:pt x="2467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grpSp>
              <p:nvGrpSpPr>
                <p:cNvPr id="122" name="Group 108"/>
                <p:cNvGrpSpPr/>
                <p:nvPr/>
              </p:nvGrpSpPr>
              <p:grpSpPr>
                <a:xfrm rot="20574756">
                  <a:off x="1992779" y="772979"/>
                  <a:ext cx="648072" cy="676440"/>
                  <a:chOff x="2206171" y="1548190"/>
                  <a:chExt cx="1340152" cy="1180496"/>
                </a:xfrm>
              </p:grpSpPr>
              <p:sp>
                <p:nvSpPr>
                  <p:cNvPr id="215" name="Freeform 214"/>
                  <p:cNvSpPr/>
                  <p:nvPr/>
                </p:nvSpPr>
                <p:spPr>
                  <a:xfrm>
                    <a:off x="2206171" y="1548190"/>
                    <a:ext cx="1340152" cy="1180496"/>
                  </a:xfrm>
                  <a:custGeom>
                    <a:avLst/>
                    <a:gdLst>
                      <a:gd name="connsiteX0" fmla="*/ 0 w 1340152"/>
                      <a:gd name="connsiteY0" fmla="*/ 1180496 h 1180496"/>
                      <a:gd name="connsiteX1" fmla="*/ 290286 w 1340152"/>
                      <a:gd name="connsiteY1" fmla="*/ 962781 h 1180496"/>
                      <a:gd name="connsiteX2" fmla="*/ 653143 w 1340152"/>
                      <a:gd name="connsiteY2" fmla="*/ 1078896 h 1180496"/>
                      <a:gd name="connsiteX3" fmla="*/ 1204686 w 1340152"/>
                      <a:gd name="connsiteY3" fmla="*/ 832153 h 1180496"/>
                      <a:gd name="connsiteX4" fmla="*/ 1320800 w 1340152"/>
                      <a:gd name="connsiteY4" fmla="*/ 91924 h 1180496"/>
                      <a:gd name="connsiteX5" fmla="*/ 1088572 w 1340152"/>
                      <a:gd name="connsiteY5" fmla="*/ 280610 h 1180496"/>
                      <a:gd name="connsiteX6" fmla="*/ 638629 w 1340152"/>
                      <a:gd name="connsiteY6" fmla="*/ 396724 h 1180496"/>
                      <a:gd name="connsiteX7" fmla="*/ 391886 w 1340152"/>
                      <a:gd name="connsiteY7" fmla="*/ 745067 h 1180496"/>
                      <a:gd name="connsiteX8" fmla="*/ 319315 w 1340152"/>
                      <a:gd name="connsiteY8" fmla="*/ 919239 h 1180496"/>
                      <a:gd name="connsiteX9" fmla="*/ 58058 w 1340152"/>
                      <a:gd name="connsiteY9" fmla="*/ 1107924 h 11804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340152" h="1180496">
                        <a:moveTo>
                          <a:pt x="0" y="1180496"/>
                        </a:moveTo>
                        <a:cubicBezTo>
                          <a:pt x="90714" y="1080105"/>
                          <a:pt x="181429" y="979714"/>
                          <a:pt x="290286" y="962781"/>
                        </a:cubicBezTo>
                        <a:cubicBezTo>
                          <a:pt x="399143" y="945848"/>
                          <a:pt x="500743" y="1100667"/>
                          <a:pt x="653143" y="1078896"/>
                        </a:cubicBezTo>
                        <a:cubicBezTo>
                          <a:pt x="805543" y="1057125"/>
                          <a:pt x="1093410" y="996648"/>
                          <a:pt x="1204686" y="832153"/>
                        </a:cubicBezTo>
                        <a:cubicBezTo>
                          <a:pt x="1315962" y="667658"/>
                          <a:pt x="1340152" y="183848"/>
                          <a:pt x="1320800" y="91924"/>
                        </a:cubicBezTo>
                        <a:cubicBezTo>
                          <a:pt x="1301448" y="0"/>
                          <a:pt x="1202267" y="229810"/>
                          <a:pt x="1088572" y="280610"/>
                        </a:cubicBezTo>
                        <a:cubicBezTo>
                          <a:pt x="974877" y="331410"/>
                          <a:pt x="754743" y="319315"/>
                          <a:pt x="638629" y="396724"/>
                        </a:cubicBezTo>
                        <a:cubicBezTo>
                          <a:pt x="522515" y="474133"/>
                          <a:pt x="445105" y="657981"/>
                          <a:pt x="391886" y="745067"/>
                        </a:cubicBezTo>
                        <a:cubicBezTo>
                          <a:pt x="338667" y="832153"/>
                          <a:pt x="374953" y="858763"/>
                          <a:pt x="319315" y="919239"/>
                        </a:cubicBezTo>
                        <a:cubicBezTo>
                          <a:pt x="263677" y="979715"/>
                          <a:pt x="160867" y="1043819"/>
                          <a:pt x="58058" y="1107924"/>
                        </a:cubicBezTo>
                      </a:path>
                    </a:pathLst>
                  </a:custGeom>
                  <a:solidFill>
                    <a:srgbClr val="97E44A"/>
                  </a:solidFill>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16" name="Freeform 215"/>
                  <p:cNvSpPr/>
                  <p:nvPr/>
                </p:nvSpPr>
                <p:spPr>
                  <a:xfrm>
                    <a:off x="2525486" y="1669143"/>
                    <a:ext cx="996647" cy="812800"/>
                  </a:xfrm>
                  <a:custGeom>
                    <a:avLst/>
                    <a:gdLst>
                      <a:gd name="connsiteX0" fmla="*/ 0 w 996647"/>
                      <a:gd name="connsiteY0" fmla="*/ 812800 h 812800"/>
                      <a:gd name="connsiteX1" fmla="*/ 261257 w 996647"/>
                      <a:gd name="connsiteY1" fmla="*/ 696686 h 812800"/>
                      <a:gd name="connsiteX2" fmla="*/ 624114 w 996647"/>
                      <a:gd name="connsiteY2" fmla="*/ 449943 h 812800"/>
                      <a:gd name="connsiteX3" fmla="*/ 943428 w 996647"/>
                      <a:gd name="connsiteY3" fmla="*/ 116114 h 812800"/>
                      <a:gd name="connsiteX4" fmla="*/ 943428 w 996647"/>
                      <a:gd name="connsiteY4" fmla="*/ 0 h 8128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996647" h="812800">
                        <a:moveTo>
                          <a:pt x="0" y="812800"/>
                        </a:moveTo>
                        <a:cubicBezTo>
                          <a:pt x="78619" y="784981"/>
                          <a:pt x="157238" y="757162"/>
                          <a:pt x="261257" y="696686"/>
                        </a:cubicBezTo>
                        <a:cubicBezTo>
                          <a:pt x="365276" y="636210"/>
                          <a:pt x="510419" y="546705"/>
                          <a:pt x="624114" y="449943"/>
                        </a:cubicBezTo>
                        <a:cubicBezTo>
                          <a:pt x="737809" y="353181"/>
                          <a:pt x="890209" y="191104"/>
                          <a:pt x="943428" y="116114"/>
                        </a:cubicBezTo>
                        <a:cubicBezTo>
                          <a:pt x="996647" y="41124"/>
                          <a:pt x="970037" y="20562"/>
                          <a:pt x="943428"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17" name="Freeform 216"/>
                  <p:cNvSpPr/>
                  <p:nvPr/>
                </p:nvSpPr>
                <p:spPr>
                  <a:xfrm>
                    <a:off x="2931886" y="2336800"/>
                    <a:ext cx="319314" cy="154819"/>
                  </a:xfrm>
                  <a:custGeom>
                    <a:avLst/>
                    <a:gdLst>
                      <a:gd name="connsiteX0" fmla="*/ 0 w 319314"/>
                      <a:gd name="connsiteY0" fmla="*/ 0 h 154819"/>
                      <a:gd name="connsiteX1" fmla="*/ 87085 w 319314"/>
                      <a:gd name="connsiteY1" fmla="*/ 87086 h 154819"/>
                      <a:gd name="connsiteX2" fmla="*/ 232228 w 319314"/>
                      <a:gd name="connsiteY2" fmla="*/ 145143 h 154819"/>
                      <a:gd name="connsiteX3" fmla="*/ 319314 w 319314"/>
                      <a:gd name="connsiteY3" fmla="*/ 145143 h 154819"/>
                    </a:gdLst>
                    <a:ahLst/>
                    <a:cxnLst>
                      <a:cxn ang="0">
                        <a:pos x="connsiteX0" y="connsiteY0"/>
                      </a:cxn>
                      <a:cxn ang="0">
                        <a:pos x="connsiteX1" y="connsiteY1"/>
                      </a:cxn>
                      <a:cxn ang="0">
                        <a:pos x="connsiteX2" y="connsiteY2"/>
                      </a:cxn>
                      <a:cxn ang="0">
                        <a:pos x="connsiteX3" y="connsiteY3"/>
                      </a:cxn>
                    </a:cxnLst>
                    <a:rect l="l" t="t" r="r" b="b"/>
                    <a:pathLst>
                      <a:path w="319314" h="154819">
                        <a:moveTo>
                          <a:pt x="0" y="0"/>
                        </a:moveTo>
                        <a:cubicBezTo>
                          <a:pt x="24190" y="31448"/>
                          <a:pt x="48380" y="62896"/>
                          <a:pt x="87085" y="87086"/>
                        </a:cubicBezTo>
                        <a:cubicBezTo>
                          <a:pt x="125790" y="111276"/>
                          <a:pt x="193523" y="135467"/>
                          <a:pt x="232228" y="145143"/>
                        </a:cubicBezTo>
                        <a:cubicBezTo>
                          <a:pt x="270933" y="154819"/>
                          <a:pt x="295123" y="149981"/>
                          <a:pt x="319314" y="145143"/>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18" name="Freeform 217"/>
                  <p:cNvSpPr/>
                  <p:nvPr/>
                </p:nvSpPr>
                <p:spPr>
                  <a:xfrm>
                    <a:off x="3077029" y="2220686"/>
                    <a:ext cx="290285" cy="120952"/>
                  </a:xfrm>
                  <a:custGeom>
                    <a:avLst/>
                    <a:gdLst>
                      <a:gd name="connsiteX0" fmla="*/ 0 w 290285"/>
                      <a:gd name="connsiteY0" fmla="*/ 0 h 120952"/>
                      <a:gd name="connsiteX1" fmla="*/ 188685 w 290285"/>
                      <a:gd name="connsiteY1" fmla="*/ 101600 h 120952"/>
                      <a:gd name="connsiteX2" fmla="*/ 290285 w 290285"/>
                      <a:gd name="connsiteY2" fmla="*/ 116114 h 120952"/>
                    </a:gdLst>
                    <a:ahLst/>
                    <a:cxnLst>
                      <a:cxn ang="0">
                        <a:pos x="connsiteX0" y="connsiteY0"/>
                      </a:cxn>
                      <a:cxn ang="0">
                        <a:pos x="connsiteX1" y="connsiteY1"/>
                      </a:cxn>
                      <a:cxn ang="0">
                        <a:pos x="connsiteX2" y="connsiteY2"/>
                      </a:cxn>
                    </a:cxnLst>
                    <a:rect l="l" t="t" r="r" b="b"/>
                    <a:pathLst>
                      <a:path w="290285" h="120952">
                        <a:moveTo>
                          <a:pt x="0" y="0"/>
                        </a:moveTo>
                        <a:cubicBezTo>
                          <a:pt x="70152" y="41124"/>
                          <a:pt x="140304" y="82248"/>
                          <a:pt x="188685" y="101600"/>
                        </a:cubicBezTo>
                        <a:cubicBezTo>
                          <a:pt x="237066" y="120952"/>
                          <a:pt x="263675" y="118533"/>
                          <a:pt x="290285" y="116114"/>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19" name="Freeform 218"/>
                  <p:cNvSpPr/>
                  <p:nvPr/>
                </p:nvSpPr>
                <p:spPr>
                  <a:xfrm>
                    <a:off x="2743200" y="2119086"/>
                    <a:ext cx="14514" cy="275771"/>
                  </a:xfrm>
                  <a:custGeom>
                    <a:avLst/>
                    <a:gdLst>
                      <a:gd name="connsiteX0" fmla="*/ 14514 w 14514"/>
                      <a:gd name="connsiteY0" fmla="*/ 275771 h 275771"/>
                      <a:gd name="connsiteX1" fmla="*/ 0 w 14514"/>
                      <a:gd name="connsiteY1" fmla="*/ 174171 h 275771"/>
                      <a:gd name="connsiteX2" fmla="*/ 14514 w 14514"/>
                      <a:gd name="connsiteY2" fmla="*/ 0 h 275771"/>
                    </a:gdLst>
                    <a:ahLst/>
                    <a:cxnLst>
                      <a:cxn ang="0">
                        <a:pos x="connsiteX0" y="connsiteY0"/>
                      </a:cxn>
                      <a:cxn ang="0">
                        <a:pos x="connsiteX1" y="connsiteY1"/>
                      </a:cxn>
                      <a:cxn ang="0">
                        <a:pos x="connsiteX2" y="connsiteY2"/>
                      </a:cxn>
                    </a:cxnLst>
                    <a:rect l="l" t="t" r="r" b="b"/>
                    <a:pathLst>
                      <a:path w="14514" h="275771">
                        <a:moveTo>
                          <a:pt x="14514" y="275771"/>
                        </a:moveTo>
                        <a:cubicBezTo>
                          <a:pt x="7257" y="247952"/>
                          <a:pt x="0" y="220133"/>
                          <a:pt x="0" y="174171"/>
                        </a:cubicBezTo>
                        <a:cubicBezTo>
                          <a:pt x="0" y="128209"/>
                          <a:pt x="7257" y="64104"/>
                          <a:pt x="14514"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20" name="Freeform 219"/>
                  <p:cNvSpPr/>
                  <p:nvPr/>
                </p:nvSpPr>
                <p:spPr>
                  <a:xfrm>
                    <a:off x="2931886" y="1988457"/>
                    <a:ext cx="43543" cy="217714"/>
                  </a:xfrm>
                  <a:custGeom>
                    <a:avLst/>
                    <a:gdLst>
                      <a:gd name="connsiteX0" fmla="*/ 43543 w 43543"/>
                      <a:gd name="connsiteY0" fmla="*/ 217714 h 217714"/>
                      <a:gd name="connsiteX1" fmla="*/ 0 w 43543"/>
                      <a:gd name="connsiteY1" fmla="*/ 130629 h 217714"/>
                      <a:gd name="connsiteX2" fmla="*/ 43543 w 43543"/>
                      <a:gd name="connsiteY2" fmla="*/ 0 h 217714"/>
                    </a:gdLst>
                    <a:ahLst/>
                    <a:cxnLst>
                      <a:cxn ang="0">
                        <a:pos x="connsiteX0" y="connsiteY0"/>
                      </a:cxn>
                      <a:cxn ang="0">
                        <a:pos x="connsiteX1" y="connsiteY1"/>
                      </a:cxn>
                      <a:cxn ang="0">
                        <a:pos x="connsiteX2" y="connsiteY2"/>
                      </a:cxn>
                    </a:cxnLst>
                    <a:rect l="l" t="t" r="r" b="b"/>
                    <a:pathLst>
                      <a:path w="43543" h="217714">
                        <a:moveTo>
                          <a:pt x="43543" y="217714"/>
                        </a:moveTo>
                        <a:cubicBezTo>
                          <a:pt x="21771" y="192314"/>
                          <a:pt x="0" y="166915"/>
                          <a:pt x="0" y="130629"/>
                        </a:cubicBezTo>
                        <a:cubicBezTo>
                          <a:pt x="0" y="94343"/>
                          <a:pt x="21771" y="47171"/>
                          <a:pt x="435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21" name="Freeform 220"/>
                  <p:cNvSpPr/>
                  <p:nvPr/>
                </p:nvSpPr>
                <p:spPr>
                  <a:xfrm>
                    <a:off x="2714171" y="2467429"/>
                    <a:ext cx="217715" cy="101600"/>
                  </a:xfrm>
                  <a:custGeom>
                    <a:avLst/>
                    <a:gdLst>
                      <a:gd name="connsiteX0" fmla="*/ 0 w 217715"/>
                      <a:gd name="connsiteY0" fmla="*/ 0 h 101600"/>
                      <a:gd name="connsiteX1" fmla="*/ 116115 w 217715"/>
                      <a:gd name="connsiteY1" fmla="*/ 72571 h 101600"/>
                      <a:gd name="connsiteX2" fmla="*/ 217715 w 217715"/>
                      <a:gd name="connsiteY2" fmla="*/ 101600 h 101600"/>
                    </a:gdLst>
                    <a:ahLst/>
                    <a:cxnLst>
                      <a:cxn ang="0">
                        <a:pos x="connsiteX0" y="connsiteY0"/>
                      </a:cxn>
                      <a:cxn ang="0">
                        <a:pos x="connsiteX1" y="connsiteY1"/>
                      </a:cxn>
                      <a:cxn ang="0">
                        <a:pos x="connsiteX2" y="connsiteY2"/>
                      </a:cxn>
                    </a:cxnLst>
                    <a:rect l="l" t="t" r="r" b="b"/>
                    <a:pathLst>
                      <a:path w="217715" h="101600">
                        <a:moveTo>
                          <a:pt x="0" y="0"/>
                        </a:moveTo>
                        <a:cubicBezTo>
                          <a:pt x="39914" y="27819"/>
                          <a:pt x="79829" y="55638"/>
                          <a:pt x="116115" y="72571"/>
                        </a:cubicBezTo>
                        <a:cubicBezTo>
                          <a:pt x="152401" y="89504"/>
                          <a:pt x="185058" y="95552"/>
                          <a:pt x="217715" y="10160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22" name="Freeform 221"/>
                  <p:cNvSpPr/>
                  <p:nvPr/>
                </p:nvSpPr>
                <p:spPr>
                  <a:xfrm>
                    <a:off x="3207657" y="2104571"/>
                    <a:ext cx="246743" cy="33867"/>
                  </a:xfrm>
                  <a:custGeom>
                    <a:avLst/>
                    <a:gdLst>
                      <a:gd name="connsiteX0" fmla="*/ 0 w 246743"/>
                      <a:gd name="connsiteY0" fmla="*/ 29029 h 33867"/>
                      <a:gd name="connsiteX1" fmla="*/ 159657 w 246743"/>
                      <a:gd name="connsiteY1" fmla="*/ 29029 h 33867"/>
                      <a:gd name="connsiteX2" fmla="*/ 246743 w 246743"/>
                      <a:gd name="connsiteY2" fmla="*/ 0 h 33867"/>
                    </a:gdLst>
                    <a:ahLst/>
                    <a:cxnLst>
                      <a:cxn ang="0">
                        <a:pos x="connsiteX0" y="connsiteY0"/>
                      </a:cxn>
                      <a:cxn ang="0">
                        <a:pos x="connsiteX1" y="connsiteY1"/>
                      </a:cxn>
                      <a:cxn ang="0">
                        <a:pos x="connsiteX2" y="connsiteY2"/>
                      </a:cxn>
                    </a:cxnLst>
                    <a:rect l="l" t="t" r="r" b="b"/>
                    <a:pathLst>
                      <a:path w="246743" h="33867">
                        <a:moveTo>
                          <a:pt x="0" y="29029"/>
                        </a:moveTo>
                        <a:cubicBezTo>
                          <a:pt x="59266" y="31448"/>
                          <a:pt x="118533" y="33867"/>
                          <a:pt x="159657" y="29029"/>
                        </a:cubicBezTo>
                        <a:cubicBezTo>
                          <a:pt x="200781" y="24191"/>
                          <a:pt x="223762" y="12095"/>
                          <a:pt x="2467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grpSp>
              <p:nvGrpSpPr>
                <p:cNvPr id="123" name="Group 44"/>
                <p:cNvGrpSpPr/>
                <p:nvPr/>
              </p:nvGrpSpPr>
              <p:grpSpPr>
                <a:xfrm rot="19854724">
                  <a:off x="1979204" y="1857114"/>
                  <a:ext cx="853661" cy="811854"/>
                  <a:chOff x="2206171" y="1548190"/>
                  <a:chExt cx="1340152" cy="1180496"/>
                </a:xfrm>
              </p:grpSpPr>
              <p:sp>
                <p:nvSpPr>
                  <p:cNvPr id="207" name="Freeform 34"/>
                  <p:cNvSpPr/>
                  <p:nvPr/>
                </p:nvSpPr>
                <p:spPr>
                  <a:xfrm>
                    <a:off x="2206171" y="1548190"/>
                    <a:ext cx="1340152" cy="1180496"/>
                  </a:xfrm>
                  <a:custGeom>
                    <a:avLst/>
                    <a:gdLst>
                      <a:gd name="connsiteX0" fmla="*/ 0 w 1340152"/>
                      <a:gd name="connsiteY0" fmla="*/ 1180496 h 1180496"/>
                      <a:gd name="connsiteX1" fmla="*/ 290286 w 1340152"/>
                      <a:gd name="connsiteY1" fmla="*/ 962781 h 1180496"/>
                      <a:gd name="connsiteX2" fmla="*/ 653143 w 1340152"/>
                      <a:gd name="connsiteY2" fmla="*/ 1078896 h 1180496"/>
                      <a:gd name="connsiteX3" fmla="*/ 1204686 w 1340152"/>
                      <a:gd name="connsiteY3" fmla="*/ 832153 h 1180496"/>
                      <a:gd name="connsiteX4" fmla="*/ 1320800 w 1340152"/>
                      <a:gd name="connsiteY4" fmla="*/ 91924 h 1180496"/>
                      <a:gd name="connsiteX5" fmla="*/ 1088572 w 1340152"/>
                      <a:gd name="connsiteY5" fmla="*/ 280610 h 1180496"/>
                      <a:gd name="connsiteX6" fmla="*/ 638629 w 1340152"/>
                      <a:gd name="connsiteY6" fmla="*/ 396724 h 1180496"/>
                      <a:gd name="connsiteX7" fmla="*/ 391886 w 1340152"/>
                      <a:gd name="connsiteY7" fmla="*/ 745067 h 1180496"/>
                      <a:gd name="connsiteX8" fmla="*/ 319315 w 1340152"/>
                      <a:gd name="connsiteY8" fmla="*/ 919239 h 1180496"/>
                      <a:gd name="connsiteX9" fmla="*/ 58058 w 1340152"/>
                      <a:gd name="connsiteY9" fmla="*/ 1107924 h 11804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340152" h="1180496">
                        <a:moveTo>
                          <a:pt x="0" y="1180496"/>
                        </a:moveTo>
                        <a:cubicBezTo>
                          <a:pt x="90714" y="1080105"/>
                          <a:pt x="181429" y="979714"/>
                          <a:pt x="290286" y="962781"/>
                        </a:cubicBezTo>
                        <a:cubicBezTo>
                          <a:pt x="399143" y="945848"/>
                          <a:pt x="500743" y="1100667"/>
                          <a:pt x="653143" y="1078896"/>
                        </a:cubicBezTo>
                        <a:cubicBezTo>
                          <a:pt x="805543" y="1057125"/>
                          <a:pt x="1093410" y="996648"/>
                          <a:pt x="1204686" y="832153"/>
                        </a:cubicBezTo>
                        <a:cubicBezTo>
                          <a:pt x="1315962" y="667658"/>
                          <a:pt x="1340152" y="183848"/>
                          <a:pt x="1320800" y="91924"/>
                        </a:cubicBezTo>
                        <a:cubicBezTo>
                          <a:pt x="1301448" y="0"/>
                          <a:pt x="1202267" y="229810"/>
                          <a:pt x="1088572" y="280610"/>
                        </a:cubicBezTo>
                        <a:cubicBezTo>
                          <a:pt x="974877" y="331410"/>
                          <a:pt x="754743" y="319315"/>
                          <a:pt x="638629" y="396724"/>
                        </a:cubicBezTo>
                        <a:cubicBezTo>
                          <a:pt x="522515" y="474133"/>
                          <a:pt x="445105" y="657981"/>
                          <a:pt x="391886" y="745067"/>
                        </a:cubicBezTo>
                        <a:cubicBezTo>
                          <a:pt x="338667" y="832153"/>
                          <a:pt x="374953" y="858763"/>
                          <a:pt x="319315" y="919239"/>
                        </a:cubicBezTo>
                        <a:cubicBezTo>
                          <a:pt x="263677" y="979715"/>
                          <a:pt x="160867" y="1043819"/>
                          <a:pt x="58058" y="1107924"/>
                        </a:cubicBezTo>
                      </a:path>
                    </a:pathLst>
                  </a:custGeom>
                  <a:solidFill>
                    <a:srgbClr val="97E44A"/>
                  </a:solidFill>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08" name="Freeform 35"/>
                  <p:cNvSpPr/>
                  <p:nvPr/>
                </p:nvSpPr>
                <p:spPr>
                  <a:xfrm>
                    <a:off x="2525486" y="1669143"/>
                    <a:ext cx="996647" cy="812800"/>
                  </a:xfrm>
                  <a:custGeom>
                    <a:avLst/>
                    <a:gdLst>
                      <a:gd name="connsiteX0" fmla="*/ 0 w 996647"/>
                      <a:gd name="connsiteY0" fmla="*/ 812800 h 812800"/>
                      <a:gd name="connsiteX1" fmla="*/ 261257 w 996647"/>
                      <a:gd name="connsiteY1" fmla="*/ 696686 h 812800"/>
                      <a:gd name="connsiteX2" fmla="*/ 624114 w 996647"/>
                      <a:gd name="connsiteY2" fmla="*/ 449943 h 812800"/>
                      <a:gd name="connsiteX3" fmla="*/ 943428 w 996647"/>
                      <a:gd name="connsiteY3" fmla="*/ 116114 h 812800"/>
                      <a:gd name="connsiteX4" fmla="*/ 943428 w 996647"/>
                      <a:gd name="connsiteY4" fmla="*/ 0 h 8128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996647" h="812800">
                        <a:moveTo>
                          <a:pt x="0" y="812800"/>
                        </a:moveTo>
                        <a:cubicBezTo>
                          <a:pt x="78619" y="784981"/>
                          <a:pt x="157238" y="757162"/>
                          <a:pt x="261257" y="696686"/>
                        </a:cubicBezTo>
                        <a:cubicBezTo>
                          <a:pt x="365276" y="636210"/>
                          <a:pt x="510419" y="546705"/>
                          <a:pt x="624114" y="449943"/>
                        </a:cubicBezTo>
                        <a:cubicBezTo>
                          <a:pt x="737809" y="353181"/>
                          <a:pt x="890209" y="191104"/>
                          <a:pt x="943428" y="116114"/>
                        </a:cubicBezTo>
                        <a:cubicBezTo>
                          <a:pt x="996647" y="41124"/>
                          <a:pt x="970037" y="20562"/>
                          <a:pt x="943428"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09" name="Freeform 36"/>
                  <p:cNvSpPr/>
                  <p:nvPr/>
                </p:nvSpPr>
                <p:spPr>
                  <a:xfrm>
                    <a:off x="2931886" y="2336800"/>
                    <a:ext cx="319314" cy="154819"/>
                  </a:xfrm>
                  <a:custGeom>
                    <a:avLst/>
                    <a:gdLst>
                      <a:gd name="connsiteX0" fmla="*/ 0 w 319314"/>
                      <a:gd name="connsiteY0" fmla="*/ 0 h 154819"/>
                      <a:gd name="connsiteX1" fmla="*/ 87085 w 319314"/>
                      <a:gd name="connsiteY1" fmla="*/ 87086 h 154819"/>
                      <a:gd name="connsiteX2" fmla="*/ 232228 w 319314"/>
                      <a:gd name="connsiteY2" fmla="*/ 145143 h 154819"/>
                      <a:gd name="connsiteX3" fmla="*/ 319314 w 319314"/>
                      <a:gd name="connsiteY3" fmla="*/ 145143 h 154819"/>
                    </a:gdLst>
                    <a:ahLst/>
                    <a:cxnLst>
                      <a:cxn ang="0">
                        <a:pos x="connsiteX0" y="connsiteY0"/>
                      </a:cxn>
                      <a:cxn ang="0">
                        <a:pos x="connsiteX1" y="connsiteY1"/>
                      </a:cxn>
                      <a:cxn ang="0">
                        <a:pos x="connsiteX2" y="connsiteY2"/>
                      </a:cxn>
                      <a:cxn ang="0">
                        <a:pos x="connsiteX3" y="connsiteY3"/>
                      </a:cxn>
                    </a:cxnLst>
                    <a:rect l="l" t="t" r="r" b="b"/>
                    <a:pathLst>
                      <a:path w="319314" h="154819">
                        <a:moveTo>
                          <a:pt x="0" y="0"/>
                        </a:moveTo>
                        <a:cubicBezTo>
                          <a:pt x="24190" y="31448"/>
                          <a:pt x="48380" y="62896"/>
                          <a:pt x="87085" y="87086"/>
                        </a:cubicBezTo>
                        <a:cubicBezTo>
                          <a:pt x="125790" y="111276"/>
                          <a:pt x="193523" y="135467"/>
                          <a:pt x="232228" y="145143"/>
                        </a:cubicBezTo>
                        <a:cubicBezTo>
                          <a:pt x="270933" y="154819"/>
                          <a:pt x="295123" y="149981"/>
                          <a:pt x="319314" y="145143"/>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10" name="Freeform 37"/>
                  <p:cNvSpPr/>
                  <p:nvPr/>
                </p:nvSpPr>
                <p:spPr>
                  <a:xfrm>
                    <a:off x="3077029" y="2220686"/>
                    <a:ext cx="290285" cy="120952"/>
                  </a:xfrm>
                  <a:custGeom>
                    <a:avLst/>
                    <a:gdLst>
                      <a:gd name="connsiteX0" fmla="*/ 0 w 290285"/>
                      <a:gd name="connsiteY0" fmla="*/ 0 h 120952"/>
                      <a:gd name="connsiteX1" fmla="*/ 188685 w 290285"/>
                      <a:gd name="connsiteY1" fmla="*/ 101600 h 120952"/>
                      <a:gd name="connsiteX2" fmla="*/ 290285 w 290285"/>
                      <a:gd name="connsiteY2" fmla="*/ 116114 h 120952"/>
                    </a:gdLst>
                    <a:ahLst/>
                    <a:cxnLst>
                      <a:cxn ang="0">
                        <a:pos x="connsiteX0" y="connsiteY0"/>
                      </a:cxn>
                      <a:cxn ang="0">
                        <a:pos x="connsiteX1" y="connsiteY1"/>
                      </a:cxn>
                      <a:cxn ang="0">
                        <a:pos x="connsiteX2" y="connsiteY2"/>
                      </a:cxn>
                    </a:cxnLst>
                    <a:rect l="l" t="t" r="r" b="b"/>
                    <a:pathLst>
                      <a:path w="290285" h="120952">
                        <a:moveTo>
                          <a:pt x="0" y="0"/>
                        </a:moveTo>
                        <a:cubicBezTo>
                          <a:pt x="70152" y="41124"/>
                          <a:pt x="140304" y="82248"/>
                          <a:pt x="188685" y="101600"/>
                        </a:cubicBezTo>
                        <a:cubicBezTo>
                          <a:pt x="237066" y="120952"/>
                          <a:pt x="263675" y="118533"/>
                          <a:pt x="290285" y="116114"/>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11" name="Freeform 38"/>
                  <p:cNvSpPr/>
                  <p:nvPr/>
                </p:nvSpPr>
                <p:spPr>
                  <a:xfrm>
                    <a:off x="2743200" y="2119086"/>
                    <a:ext cx="14514" cy="275771"/>
                  </a:xfrm>
                  <a:custGeom>
                    <a:avLst/>
                    <a:gdLst>
                      <a:gd name="connsiteX0" fmla="*/ 14514 w 14514"/>
                      <a:gd name="connsiteY0" fmla="*/ 275771 h 275771"/>
                      <a:gd name="connsiteX1" fmla="*/ 0 w 14514"/>
                      <a:gd name="connsiteY1" fmla="*/ 174171 h 275771"/>
                      <a:gd name="connsiteX2" fmla="*/ 14514 w 14514"/>
                      <a:gd name="connsiteY2" fmla="*/ 0 h 275771"/>
                    </a:gdLst>
                    <a:ahLst/>
                    <a:cxnLst>
                      <a:cxn ang="0">
                        <a:pos x="connsiteX0" y="connsiteY0"/>
                      </a:cxn>
                      <a:cxn ang="0">
                        <a:pos x="connsiteX1" y="connsiteY1"/>
                      </a:cxn>
                      <a:cxn ang="0">
                        <a:pos x="connsiteX2" y="connsiteY2"/>
                      </a:cxn>
                    </a:cxnLst>
                    <a:rect l="l" t="t" r="r" b="b"/>
                    <a:pathLst>
                      <a:path w="14514" h="275771">
                        <a:moveTo>
                          <a:pt x="14514" y="275771"/>
                        </a:moveTo>
                        <a:cubicBezTo>
                          <a:pt x="7257" y="247952"/>
                          <a:pt x="0" y="220133"/>
                          <a:pt x="0" y="174171"/>
                        </a:cubicBezTo>
                        <a:cubicBezTo>
                          <a:pt x="0" y="128209"/>
                          <a:pt x="7257" y="64104"/>
                          <a:pt x="14514"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12" name="Freeform 39"/>
                  <p:cNvSpPr/>
                  <p:nvPr/>
                </p:nvSpPr>
                <p:spPr>
                  <a:xfrm>
                    <a:off x="2931886" y="1988457"/>
                    <a:ext cx="43543" cy="217714"/>
                  </a:xfrm>
                  <a:custGeom>
                    <a:avLst/>
                    <a:gdLst>
                      <a:gd name="connsiteX0" fmla="*/ 43543 w 43543"/>
                      <a:gd name="connsiteY0" fmla="*/ 217714 h 217714"/>
                      <a:gd name="connsiteX1" fmla="*/ 0 w 43543"/>
                      <a:gd name="connsiteY1" fmla="*/ 130629 h 217714"/>
                      <a:gd name="connsiteX2" fmla="*/ 43543 w 43543"/>
                      <a:gd name="connsiteY2" fmla="*/ 0 h 217714"/>
                    </a:gdLst>
                    <a:ahLst/>
                    <a:cxnLst>
                      <a:cxn ang="0">
                        <a:pos x="connsiteX0" y="connsiteY0"/>
                      </a:cxn>
                      <a:cxn ang="0">
                        <a:pos x="connsiteX1" y="connsiteY1"/>
                      </a:cxn>
                      <a:cxn ang="0">
                        <a:pos x="connsiteX2" y="connsiteY2"/>
                      </a:cxn>
                    </a:cxnLst>
                    <a:rect l="l" t="t" r="r" b="b"/>
                    <a:pathLst>
                      <a:path w="43543" h="217714">
                        <a:moveTo>
                          <a:pt x="43543" y="217714"/>
                        </a:moveTo>
                        <a:cubicBezTo>
                          <a:pt x="21771" y="192314"/>
                          <a:pt x="0" y="166915"/>
                          <a:pt x="0" y="130629"/>
                        </a:cubicBezTo>
                        <a:cubicBezTo>
                          <a:pt x="0" y="94343"/>
                          <a:pt x="21771" y="47171"/>
                          <a:pt x="435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13" name="Freeform 40"/>
                  <p:cNvSpPr/>
                  <p:nvPr/>
                </p:nvSpPr>
                <p:spPr>
                  <a:xfrm>
                    <a:off x="2714171" y="2467429"/>
                    <a:ext cx="217715" cy="101600"/>
                  </a:xfrm>
                  <a:custGeom>
                    <a:avLst/>
                    <a:gdLst>
                      <a:gd name="connsiteX0" fmla="*/ 0 w 217715"/>
                      <a:gd name="connsiteY0" fmla="*/ 0 h 101600"/>
                      <a:gd name="connsiteX1" fmla="*/ 116115 w 217715"/>
                      <a:gd name="connsiteY1" fmla="*/ 72571 h 101600"/>
                      <a:gd name="connsiteX2" fmla="*/ 217715 w 217715"/>
                      <a:gd name="connsiteY2" fmla="*/ 101600 h 101600"/>
                    </a:gdLst>
                    <a:ahLst/>
                    <a:cxnLst>
                      <a:cxn ang="0">
                        <a:pos x="connsiteX0" y="connsiteY0"/>
                      </a:cxn>
                      <a:cxn ang="0">
                        <a:pos x="connsiteX1" y="connsiteY1"/>
                      </a:cxn>
                      <a:cxn ang="0">
                        <a:pos x="connsiteX2" y="connsiteY2"/>
                      </a:cxn>
                    </a:cxnLst>
                    <a:rect l="l" t="t" r="r" b="b"/>
                    <a:pathLst>
                      <a:path w="217715" h="101600">
                        <a:moveTo>
                          <a:pt x="0" y="0"/>
                        </a:moveTo>
                        <a:cubicBezTo>
                          <a:pt x="39914" y="27819"/>
                          <a:pt x="79829" y="55638"/>
                          <a:pt x="116115" y="72571"/>
                        </a:cubicBezTo>
                        <a:cubicBezTo>
                          <a:pt x="152401" y="89504"/>
                          <a:pt x="185058" y="95552"/>
                          <a:pt x="217715" y="10160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14" name="Freeform 41"/>
                  <p:cNvSpPr/>
                  <p:nvPr/>
                </p:nvSpPr>
                <p:spPr>
                  <a:xfrm>
                    <a:off x="3207657" y="2104571"/>
                    <a:ext cx="246743" cy="33867"/>
                  </a:xfrm>
                  <a:custGeom>
                    <a:avLst/>
                    <a:gdLst>
                      <a:gd name="connsiteX0" fmla="*/ 0 w 246743"/>
                      <a:gd name="connsiteY0" fmla="*/ 29029 h 33867"/>
                      <a:gd name="connsiteX1" fmla="*/ 159657 w 246743"/>
                      <a:gd name="connsiteY1" fmla="*/ 29029 h 33867"/>
                      <a:gd name="connsiteX2" fmla="*/ 246743 w 246743"/>
                      <a:gd name="connsiteY2" fmla="*/ 0 h 33867"/>
                    </a:gdLst>
                    <a:ahLst/>
                    <a:cxnLst>
                      <a:cxn ang="0">
                        <a:pos x="connsiteX0" y="connsiteY0"/>
                      </a:cxn>
                      <a:cxn ang="0">
                        <a:pos x="connsiteX1" y="connsiteY1"/>
                      </a:cxn>
                      <a:cxn ang="0">
                        <a:pos x="connsiteX2" y="connsiteY2"/>
                      </a:cxn>
                    </a:cxnLst>
                    <a:rect l="l" t="t" r="r" b="b"/>
                    <a:pathLst>
                      <a:path w="246743" h="33867">
                        <a:moveTo>
                          <a:pt x="0" y="29029"/>
                        </a:moveTo>
                        <a:cubicBezTo>
                          <a:pt x="59266" y="31448"/>
                          <a:pt x="118533" y="33867"/>
                          <a:pt x="159657" y="29029"/>
                        </a:cubicBezTo>
                        <a:cubicBezTo>
                          <a:pt x="200781" y="24191"/>
                          <a:pt x="223762" y="12095"/>
                          <a:pt x="2467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grpSp>
              <p:nvGrpSpPr>
                <p:cNvPr id="124" name="Group 45"/>
                <p:cNvGrpSpPr/>
                <p:nvPr/>
              </p:nvGrpSpPr>
              <p:grpSpPr>
                <a:xfrm>
                  <a:off x="2124075" y="1340768"/>
                  <a:ext cx="863749" cy="820456"/>
                  <a:chOff x="2206171" y="1548190"/>
                  <a:chExt cx="1340152" cy="1180496"/>
                </a:xfrm>
              </p:grpSpPr>
              <p:sp>
                <p:nvSpPr>
                  <p:cNvPr id="199" name="Freeform 198"/>
                  <p:cNvSpPr/>
                  <p:nvPr/>
                </p:nvSpPr>
                <p:spPr>
                  <a:xfrm>
                    <a:off x="2206171" y="1548190"/>
                    <a:ext cx="1340152" cy="1180496"/>
                  </a:xfrm>
                  <a:custGeom>
                    <a:avLst/>
                    <a:gdLst>
                      <a:gd name="connsiteX0" fmla="*/ 0 w 1340152"/>
                      <a:gd name="connsiteY0" fmla="*/ 1180496 h 1180496"/>
                      <a:gd name="connsiteX1" fmla="*/ 290286 w 1340152"/>
                      <a:gd name="connsiteY1" fmla="*/ 962781 h 1180496"/>
                      <a:gd name="connsiteX2" fmla="*/ 653143 w 1340152"/>
                      <a:gd name="connsiteY2" fmla="*/ 1078896 h 1180496"/>
                      <a:gd name="connsiteX3" fmla="*/ 1204686 w 1340152"/>
                      <a:gd name="connsiteY3" fmla="*/ 832153 h 1180496"/>
                      <a:gd name="connsiteX4" fmla="*/ 1320800 w 1340152"/>
                      <a:gd name="connsiteY4" fmla="*/ 91924 h 1180496"/>
                      <a:gd name="connsiteX5" fmla="*/ 1088572 w 1340152"/>
                      <a:gd name="connsiteY5" fmla="*/ 280610 h 1180496"/>
                      <a:gd name="connsiteX6" fmla="*/ 638629 w 1340152"/>
                      <a:gd name="connsiteY6" fmla="*/ 396724 h 1180496"/>
                      <a:gd name="connsiteX7" fmla="*/ 391886 w 1340152"/>
                      <a:gd name="connsiteY7" fmla="*/ 745067 h 1180496"/>
                      <a:gd name="connsiteX8" fmla="*/ 319315 w 1340152"/>
                      <a:gd name="connsiteY8" fmla="*/ 919239 h 1180496"/>
                      <a:gd name="connsiteX9" fmla="*/ 58058 w 1340152"/>
                      <a:gd name="connsiteY9" fmla="*/ 1107924 h 11804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340152" h="1180496">
                        <a:moveTo>
                          <a:pt x="0" y="1180496"/>
                        </a:moveTo>
                        <a:cubicBezTo>
                          <a:pt x="90714" y="1080105"/>
                          <a:pt x="181429" y="979714"/>
                          <a:pt x="290286" y="962781"/>
                        </a:cubicBezTo>
                        <a:cubicBezTo>
                          <a:pt x="399143" y="945848"/>
                          <a:pt x="500743" y="1100667"/>
                          <a:pt x="653143" y="1078896"/>
                        </a:cubicBezTo>
                        <a:cubicBezTo>
                          <a:pt x="805543" y="1057125"/>
                          <a:pt x="1093410" y="996648"/>
                          <a:pt x="1204686" y="832153"/>
                        </a:cubicBezTo>
                        <a:cubicBezTo>
                          <a:pt x="1315962" y="667658"/>
                          <a:pt x="1340152" y="183848"/>
                          <a:pt x="1320800" y="91924"/>
                        </a:cubicBezTo>
                        <a:cubicBezTo>
                          <a:pt x="1301448" y="0"/>
                          <a:pt x="1202267" y="229810"/>
                          <a:pt x="1088572" y="280610"/>
                        </a:cubicBezTo>
                        <a:cubicBezTo>
                          <a:pt x="974877" y="331410"/>
                          <a:pt x="754743" y="319315"/>
                          <a:pt x="638629" y="396724"/>
                        </a:cubicBezTo>
                        <a:cubicBezTo>
                          <a:pt x="522515" y="474133"/>
                          <a:pt x="445105" y="657981"/>
                          <a:pt x="391886" y="745067"/>
                        </a:cubicBezTo>
                        <a:cubicBezTo>
                          <a:pt x="338667" y="832153"/>
                          <a:pt x="374953" y="858763"/>
                          <a:pt x="319315" y="919239"/>
                        </a:cubicBezTo>
                        <a:cubicBezTo>
                          <a:pt x="263677" y="979715"/>
                          <a:pt x="160867" y="1043819"/>
                          <a:pt x="58058" y="1107924"/>
                        </a:cubicBezTo>
                      </a:path>
                    </a:pathLst>
                  </a:custGeom>
                  <a:solidFill>
                    <a:srgbClr val="97E44A"/>
                  </a:solidFill>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00" name="Freeform 199"/>
                  <p:cNvSpPr/>
                  <p:nvPr/>
                </p:nvSpPr>
                <p:spPr>
                  <a:xfrm>
                    <a:off x="2525486" y="1669143"/>
                    <a:ext cx="996647" cy="812800"/>
                  </a:xfrm>
                  <a:custGeom>
                    <a:avLst/>
                    <a:gdLst>
                      <a:gd name="connsiteX0" fmla="*/ 0 w 996647"/>
                      <a:gd name="connsiteY0" fmla="*/ 812800 h 812800"/>
                      <a:gd name="connsiteX1" fmla="*/ 261257 w 996647"/>
                      <a:gd name="connsiteY1" fmla="*/ 696686 h 812800"/>
                      <a:gd name="connsiteX2" fmla="*/ 624114 w 996647"/>
                      <a:gd name="connsiteY2" fmla="*/ 449943 h 812800"/>
                      <a:gd name="connsiteX3" fmla="*/ 943428 w 996647"/>
                      <a:gd name="connsiteY3" fmla="*/ 116114 h 812800"/>
                      <a:gd name="connsiteX4" fmla="*/ 943428 w 996647"/>
                      <a:gd name="connsiteY4" fmla="*/ 0 h 8128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996647" h="812800">
                        <a:moveTo>
                          <a:pt x="0" y="812800"/>
                        </a:moveTo>
                        <a:cubicBezTo>
                          <a:pt x="78619" y="784981"/>
                          <a:pt x="157238" y="757162"/>
                          <a:pt x="261257" y="696686"/>
                        </a:cubicBezTo>
                        <a:cubicBezTo>
                          <a:pt x="365276" y="636210"/>
                          <a:pt x="510419" y="546705"/>
                          <a:pt x="624114" y="449943"/>
                        </a:cubicBezTo>
                        <a:cubicBezTo>
                          <a:pt x="737809" y="353181"/>
                          <a:pt x="890209" y="191104"/>
                          <a:pt x="943428" y="116114"/>
                        </a:cubicBezTo>
                        <a:cubicBezTo>
                          <a:pt x="996647" y="41124"/>
                          <a:pt x="970037" y="20562"/>
                          <a:pt x="943428"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01" name="Freeform 200"/>
                  <p:cNvSpPr/>
                  <p:nvPr/>
                </p:nvSpPr>
                <p:spPr>
                  <a:xfrm>
                    <a:off x="2931886" y="2336800"/>
                    <a:ext cx="319314" cy="154819"/>
                  </a:xfrm>
                  <a:custGeom>
                    <a:avLst/>
                    <a:gdLst>
                      <a:gd name="connsiteX0" fmla="*/ 0 w 319314"/>
                      <a:gd name="connsiteY0" fmla="*/ 0 h 154819"/>
                      <a:gd name="connsiteX1" fmla="*/ 87085 w 319314"/>
                      <a:gd name="connsiteY1" fmla="*/ 87086 h 154819"/>
                      <a:gd name="connsiteX2" fmla="*/ 232228 w 319314"/>
                      <a:gd name="connsiteY2" fmla="*/ 145143 h 154819"/>
                      <a:gd name="connsiteX3" fmla="*/ 319314 w 319314"/>
                      <a:gd name="connsiteY3" fmla="*/ 145143 h 154819"/>
                    </a:gdLst>
                    <a:ahLst/>
                    <a:cxnLst>
                      <a:cxn ang="0">
                        <a:pos x="connsiteX0" y="connsiteY0"/>
                      </a:cxn>
                      <a:cxn ang="0">
                        <a:pos x="connsiteX1" y="connsiteY1"/>
                      </a:cxn>
                      <a:cxn ang="0">
                        <a:pos x="connsiteX2" y="connsiteY2"/>
                      </a:cxn>
                      <a:cxn ang="0">
                        <a:pos x="connsiteX3" y="connsiteY3"/>
                      </a:cxn>
                    </a:cxnLst>
                    <a:rect l="l" t="t" r="r" b="b"/>
                    <a:pathLst>
                      <a:path w="319314" h="154819">
                        <a:moveTo>
                          <a:pt x="0" y="0"/>
                        </a:moveTo>
                        <a:cubicBezTo>
                          <a:pt x="24190" y="31448"/>
                          <a:pt x="48380" y="62896"/>
                          <a:pt x="87085" y="87086"/>
                        </a:cubicBezTo>
                        <a:cubicBezTo>
                          <a:pt x="125790" y="111276"/>
                          <a:pt x="193523" y="135467"/>
                          <a:pt x="232228" y="145143"/>
                        </a:cubicBezTo>
                        <a:cubicBezTo>
                          <a:pt x="270933" y="154819"/>
                          <a:pt x="295123" y="149981"/>
                          <a:pt x="319314" y="145143"/>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02" name="Freeform 201"/>
                  <p:cNvSpPr/>
                  <p:nvPr/>
                </p:nvSpPr>
                <p:spPr>
                  <a:xfrm>
                    <a:off x="3077029" y="2220686"/>
                    <a:ext cx="290285" cy="120952"/>
                  </a:xfrm>
                  <a:custGeom>
                    <a:avLst/>
                    <a:gdLst>
                      <a:gd name="connsiteX0" fmla="*/ 0 w 290285"/>
                      <a:gd name="connsiteY0" fmla="*/ 0 h 120952"/>
                      <a:gd name="connsiteX1" fmla="*/ 188685 w 290285"/>
                      <a:gd name="connsiteY1" fmla="*/ 101600 h 120952"/>
                      <a:gd name="connsiteX2" fmla="*/ 290285 w 290285"/>
                      <a:gd name="connsiteY2" fmla="*/ 116114 h 120952"/>
                    </a:gdLst>
                    <a:ahLst/>
                    <a:cxnLst>
                      <a:cxn ang="0">
                        <a:pos x="connsiteX0" y="connsiteY0"/>
                      </a:cxn>
                      <a:cxn ang="0">
                        <a:pos x="connsiteX1" y="connsiteY1"/>
                      </a:cxn>
                      <a:cxn ang="0">
                        <a:pos x="connsiteX2" y="connsiteY2"/>
                      </a:cxn>
                    </a:cxnLst>
                    <a:rect l="l" t="t" r="r" b="b"/>
                    <a:pathLst>
                      <a:path w="290285" h="120952">
                        <a:moveTo>
                          <a:pt x="0" y="0"/>
                        </a:moveTo>
                        <a:cubicBezTo>
                          <a:pt x="70152" y="41124"/>
                          <a:pt x="140304" y="82248"/>
                          <a:pt x="188685" y="101600"/>
                        </a:cubicBezTo>
                        <a:cubicBezTo>
                          <a:pt x="237066" y="120952"/>
                          <a:pt x="263675" y="118533"/>
                          <a:pt x="290285" y="116114"/>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03" name="Freeform 202"/>
                  <p:cNvSpPr/>
                  <p:nvPr/>
                </p:nvSpPr>
                <p:spPr>
                  <a:xfrm>
                    <a:off x="2743200" y="2119086"/>
                    <a:ext cx="14514" cy="275771"/>
                  </a:xfrm>
                  <a:custGeom>
                    <a:avLst/>
                    <a:gdLst>
                      <a:gd name="connsiteX0" fmla="*/ 14514 w 14514"/>
                      <a:gd name="connsiteY0" fmla="*/ 275771 h 275771"/>
                      <a:gd name="connsiteX1" fmla="*/ 0 w 14514"/>
                      <a:gd name="connsiteY1" fmla="*/ 174171 h 275771"/>
                      <a:gd name="connsiteX2" fmla="*/ 14514 w 14514"/>
                      <a:gd name="connsiteY2" fmla="*/ 0 h 275771"/>
                    </a:gdLst>
                    <a:ahLst/>
                    <a:cxnLst>
                      <a:cxn ang="0">
                        <a:pos x="connsiteX0" y="connsiteY0"/>
                      </a:cxn>
                      <a:cxn ang="0">
                        <a:pos x="connsiteX1" y="connsiteY1"/>
                      </a:cxn>
                      <a:cxn ang="0">
                        <a:pos x="connsiteX2" y="connsiteY2"/>
                      </a:cxn>
                    </a:cxnLst>
                    <a:rect l="l" t="t" r="r" b="b"/>
                    <a:pathLst>
                      <a:path w="14514" h="275771">
                        <a:moveTo>
                          <a:pt x="14514" y="275771"/>
                        </a:moveTo>
                        <a:cubicBezTo>
                          <a:pt x="7257" y="247952"/>
                          <a:pt x="0" y="220133"/>
                          <a:pt x="0" y="174171"/>
                        </a:cubicBezTo>
                        <a:cubicBezTo>
                          <a:pt x="0" y="128209"/>
                          <a:pt x="7257" y="64104"/>
                          <a:pt x="14514"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04" name="Freeform 203"/>
                  <p:cNvSpPr/>
                  <p:nvPr/>
                </p:nvSpPr>
                <p:spPr>
                  <a:xfrm>
                    <a:off x="2931886" y="1988457"/>
                    <a:ext cx="43543" cy="217714"/>
                  </a:xfrm>
                  <a:custGeom>
                    <a:avLst/>
                    <a:gdLst>
                      <a:gd name="connsiteX0" fmla="*/ 43543 w 43543"/>
                      <a:gd name="connsiteY0" fmla="*/ 217714 h 217714"/>
                      <a:gd name="connsiteX1" fmla="*/ 0 w 43543"/>
                      <a:gd name="connsiteY1" fmla="*/ 130629 h 217714"/>
                      <a:gd name="connsiteX2" fmla="*/ 43543 w 43543"/>
                      <a:gd name="connsiteY2" fmla="*/ 0 h 217714"/>
                    </a:gdLst>
                    <a:ahLst/>
                    <a:cxnLst>
                      <a:cxn ang="0">
                        <a:pos x="connsiteX0" y="connsiteY0"/>
                      </a:cxn>
                      <a:cxn ang="0">
                        <a:pos x="connsiteX1" y="connsiteY1"/>
                      </a:cxn>
                      <a:cxn ang="0">
                        <a:pos x="connsiteX2" y="connsiteY2"/>
                      </a:cxn>
                    </a:cxnLst>
                    <a:rect l="l" t="t" r="r" b="b"/>
                    <a:pathLst>
                      <a:path w="43543" h="217714">
                        <a:moveTo>
                          <a:pt x="43543" y="217714"/>
                        </a:moveTo>
                        <a:cubicBezTo>
                          <a:pt x="21771" y="192314"/>
                          <a:pt x="0" y="166915"/>
                          <a:pt x="0" y="130629"/>
                        </a:cubicBezTo>
                        <a:cubicBezTo>
                          <a:pt x="0" y="94343"/>
                          <a:pt x="21771" y="47171"/>
                          <a:pt x="435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05" name="Freeform 204"/>
                  <p:cNvSpPr/>
                  <p:nvPr/>
                </p:nvSpPr>
                <p:spPr>
                  <a:xfrm>
                    <a:off x="2714171" y="2467429"/>
                    <a:ext cx="217715" cy="101600"/>
                  </a:xfrm>
                  <a:custGeom>
                    <a:avLst/>
                    <a:gdLst>
                      <a:gd name="connsiteX0" fmla="*/ 0 w 217715"/>
                      <a:gd name="connsiteY0" fmla="*/ 0 h 101600"/>
                      <a:gd name="connsiteX1" fmla="*/ 116115 w 217715"/>
                      <a:gd name="connsiteY1" fmla="*/ 72571 h 101600"/>
                      <a:gd name="connsiteX2" fmla="*/ 217715 w 217715"/>
                      <a:gd name="connsiteY2" fmla="*/ 101600 h 101600"/>
                    </a:gdLst>
                    <a:ahLst/>
                    <a:cxnLst>
                      <a:cxn ang="0">
                        <a:pos x="connsiteX0" y="connsiteY0"/>
                      </a:cxn>
                      <a:cxn ang="0">
                        <a:pos x="connsiteX1" y="connsiteY1"/>
                      </a:cxn>
                      <a:cxn ang="0">
                        <a:pos x="connsiteX2" y="connsiteY2"/>
                      </a:cxn>
                    </a:cxnLst>
                    <a:rect l="l" t="t" r="r" b="b"/>
                    <a:pathLst>
                      <a:path w="217715" h="101600">
                        <a:moveTo>
                          <a:pt x="0" y="0"/>
                        </a:moveTo>
                        <a:cubicBezTo>
                          <a:pt x="39914" y="27819"/>
                          <a:pt x="79829" y="55638"/>
                          <a:pt x="116115" y="72571"/>
                        </a:cubicBezTo>
                        <a:cubicBezTo>
                          <a:pt x="152401" y="89504"/>
                          <a:pt x="185058" y="95552"/>
                          <a:pt x="217715" y="10160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06" name="Freeform 205"/>
                  <p:cNvSpPr/>
                  <p:nvPr/>
                </p:nvSpPr>
                <p:spPr>
                  <a:xfrm>
                    <a:off x="3207657" y="2104571"/>
                    <a:ext cx="246743" cy="33867"/>
                  </a:xfrm>
                  <a:custGeom>
                    <a:avLst/>
                    <a:gdLst>
                      <a:gd name="connsiteX0" fmla="*/ 0 w 246743"/>
                      <a:gd name="connsiteY0" fmla="*/ 29029 h 33867"/>
                      <a:gd name="connsiteX1" fmla="*/ 159657 w 246743"/>
                      <a:gd name="connsiteY1" fmla="*/ 29029 h 33867"/>
                      <a:gd name="connsiteX2" fmla="*/ 246743 w 246743"/>
                      <a:gd name="connsiteY2" fmla="*/ 0 h 33867"/>
                    </a:gdLst>
                    <a:ahLst/>
                    <a:cxnLst>
                      <a:cxn ang="0">
                        <a:pos x="connsiteX0" y="connsiteY0"/>
                      </a:cxn>
                      <a:cxn ang="0">
                        <a:pos x="connsiteX1" y="connsiteY1"/>
                      </a:cxn>
                      <a:cxn ang="0">
                        <a:pos x="connsiteX2" y="connsiteY2"/>
                      </a:cxn>
                    </a:cxnLst>
                    <a:rect l="l" t="t" r="r" b="b"/>
                    <a:pathLst>
                      <a:path w="246743" h="33867">
                        <a:moveTo>
                          <a:pt x="0" y="29029"/>
                        </a:moveTo>
                        <a:cubicBezTo>
                          <a:pt x="59266" y="31448"/>
                          <a:pt x="118533" y="33867"/>
                          <a:pt x="159657" y="29029"/>
                        </a:cubicBezTo>
                        <a:cubicBezTo>
                          <a:pt x="200781" y="24191"/>
                          <a:pt x="223762" y="12095"/>
                          <a:pt x="2467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grpSp>
              <p:nvGrpSpPr>
                <p:cNvPr id="125" name="Group 54"/>
                <p:cNvGrpSpPr/>
                <p:nvPr/>
              </p:nvGrpSpPr>
              <p:grpSpPr>
                <a:xfrm rot="2289691" flipH="1">
                  <a:off x="1484445" y="1518630"/>
                  <a:ext cx="1124728" cy="1148531"/>
                  <a:chOff x="2206171" y="1548190"/>
                  <a:chExt cx="1340152" cy="1180496"/>
                </a:xfrm>
              </p:grpSpPr>
              <p:sp>
                <p:nvSpPr>
                  <p:cNvPr id="191" name="Freeform 190"/>
                  <p:cNvSpPr/>
                  <p:nvPr/>
                </p:nvSpPr>
                <p:spPr>
                  <a:xfrm>
                    <a:off x="2206171" y="1548190"/>
                    <a:ext cx="1340152" cy="1180496"/>
                  </a:xfrm>
                  <a:custGeom>
                    <a:avLst/>
                    <a:gdLst>
                      <a:gd name="connsiteX0" fmla="*/ 0 w 1340152"/>
                      <a:gd name="connsiteY0" fmla="*/ 1180496 h 1180496"/>
                      <a:gd name="connsiteX1" fmla="*/ 290286 w 1340152"/>
                      <a:gd name="connsiteY1" fmla="*/ 962781 h 1180496"/>
                      <a:gd name="connsiteX2" fmla="*/ 653143 w 1340152"/>
                      <a:gd name="connsiteY2" fmla="*/ 1078896 h 1180496"/>
                      <a:gd name="connsiteX3" fmla="*/ 1204686 w 1340152"/>
                      <a:gd name="connsiteY3" fmla="*/ 832153 h 1180496"/>
                      <a:gd name="connsiteX4" fmla="*/ 1320800 w 1340152"/>
                      <a:gd name="connsiteY4" fmla="*/ 91924 h 1180496"/>
                      <a:gd name="connsiteX5" fmla="*/ 1088572 w 1340152"/>
                      <a:gd name="connsiteY5" fmla="*/ 280610 h 1180496"/>
                      <a:gd name="connsiteX6" fmla="*/ 638629 w 1340152"/>
                      <a:gd name="connsiteY6" fmla="*/ 396724 h 1180496"/>
                      <a:gd name="connsiteX7" fmla="*/ 391886 w 1340152"/>
                      <a:gd name="connsiteY7" fmla="*/ 745067 h 1180496"/>
                      <a:gd name="connsiteX8" fmla="*/ 319315 w 1340152"/>
                      <a:gd name="connsiteY8" fmla="*/ 919239 h 1180496"/>
                      <a:gd name="connsiteX9" fmla="*/ 58058 w 1340152"/>
                      <a:gd name="connsiteY9" fmla="*/ 1107924 h 11804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340152" h="1180496">
                        <a:moveTo>
                          <a:pt x="0" y="1180496"/>
                        </a:moveTo>
                        <a:cubicBezTo>
                          <a:pt x="90714" y="1080105"/>
                          <a:pt x="181429" y="979714"/>
                          <a:pt x="290286" y="962781"/>
                        </a:cubicBezTo>
                        <a:cubicBezTo>
                          <a:pt x="399143" y="945848"/>
                          <a:pt x="500743" y="1100667"/>
                          <a:pt x="653143" y="1078896"/>
                        </a:cubicBezTo>
                        <a:cubicBezTo>
                          <a:pt x="805543" y="1057125"/>
                          <a:pt x="1093410" y="996648"/>
                          <a:pt x="1204686" y="832153"/>
                        </a:cubicBezTo>
                        <a:cubicBezTo>
                          <a:pt x="1315962" y="667658"/>
                          <a:pt x="1340152" y="183848"/>
                          <a:pt x="1320800" y="91924"/>
                        </a:cubicBezTo>
                        <a:cubicBezTo>
                          <a:pt x="1301448" y="0"/>
                          <a:pt x="1202267" y="229810"/>
                          <a:pt x="1088572" y="280610"/>
                        </a:cubicBezTo>
                        <a:cubicBezTo>
                          <a:pt x="974877" y="331410"/>
                          <a:pt x="754743" y="319315"/>
                          <a:pt x="638629" y="396724"/>
                        </a:cubicBezTo>
                        <a:cubicBezTo>
                          <a:pt x="522515" y="474133"/>
                          <a:pt x="445105" y="657981"/>
                          <a:pt x="391886" y="745067"/>
                        </a:cubicBezTo>
                        <a:cubicBezTo>
                          <a:pt x="338667" y="832153"/>
                          <a:pt x="374953" y="858763"/>
                          <a:pt x="319315" y="919239"/>
                        </a:cubicBezTo>
                        <a:cubicBezTo>
                          <a:pt x="263677" y="979715"/>
                          <a:pt x="160867" y="1043819"/>
                          <a:pt x="58058" y="1107924"/>
                        </a:cubicBezTo>
                      </a:path>
                    </a:pathLst>
                  </a:custGeom>
                  <a:solidFill>
                    <a:srgbClr val="97E44A"/>
                  </a:solidFill>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92" name="Freeform 191"/>
                  <p:cNvSpPr/>
                  <p:nvPr/>
                </p:nvSpPr>
                <p:spPr>
                  <a:xfrm>
                    <a:off x="2525486" y="1669143"/>
                    <a:ext cx="996647" cy="812800"/>
                  </a:xfrm>
                  <a:custGeom>
                    <a:avLst/>
                    <a:gdLst>
                      <a:gd name="connsiteX0" fmla="*/ 0 w 996647"/>
                      <a:gd name="connsiteY0" fmla="*/ 812800 h 812800"/>
                      <a:gd name="connsiteX1" fmla="*/ 261257 w 996647"/>
                      <a:gd name="connsiteY1" fmla="*/ 696686 h 812800"/>
                      <a:gd name="connsiteX2" fmla="*/ 624114 w 996647"/>
                      <a:gd name="connsiteY2" fmla="*/ 449943 h 812800"/>
                      <a:gd name="connsiteX3" fmla="*/ 943428 w 996647"/>
                      <a:gd name="connsiteY3" fmla="*/ 116114 h 812800"/>
                      <a:gd name="connsiteX4" fmla="*/ 943428 w 996647"/>
                      <a:gd name="connsiteY4" fmla="*/ 0 h 8128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996647" h="812800">
                        <a:moveTo>
                          <a:pt x="0" y="812800"/>
                        </a:moveTo>
                        <a:cubicBezTo>
                          <a:pt x="78619" y="784981"/>
                          <a:pt x="157238" y="757162"/>
                          <a:pt x="261257" y="696686"/>
                        </a:cubicBezTo>
                        <a:cubicBezTo>
                          <a:pt x="365276" y="636210"/>
                          <a:pt x="510419" y="546705"/>
                          <a:pt x="624114" y="449943"/>
                        </a:cubicBezTo>
                        <a:cubicBezTo>
                          <a:pt x="737809" y="353181"/>
                          <a:pt x="890209" y="191104"/>
                          <a:pt x="943428" y="116114"/>
                        </a:cubicBezTo>
                        <a:cubicBezTo>
                          <a:pt x="996647" y="41124"/>
                          <a:pt x="970037" y="20562"/>
                          <a:pt x="943428"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93" name="Freeform 192"/>
                  <p:cNvSpPr/>
                  <p:nvPr/>
                </p:nvSpPr>
                <p:spPr>
                  <a:xfrm>
                    <a:off x="2931886" y="2336800"/>
                    <a:ext cx="319314" cy="154819"/>
                  </a:xfrm>
                  <a:custGeom>
                    <a:avLst/>
                    <a:gdLst>
                      <a:gd name="connsiteX0" fmla="*/ 0 w 319314"/>
                      <a:gd name="connsiteY0" fmla="*/ 0 h 154819"/>
                      <a:gd name="connsiteX1" fmla="*/ 87085 w 319314"/>
                      <a:gd name="connsiteY1" fmla="*/ 87086 h 154819"/>
                      <a:gd name="connsiteX2" fmla="*/ 232228 w 319314"/>
                      <a:gd name="connsiteY2" fmla="*/ 145143 h 154819"/>
                      <a:gd name="connsiteX3" fmla="*/ 319314 w 319314"/>
                      <a:gd name="connsiteY3" fmla="*/ 145143 h 154819"/>
                    </a:gdLst>
                    <a:ahLst/>
                    <a:cxnLst>
                      <a:cxn ang="0">
                        <a:pos x="connsiteX0" y="connsiteY0"/>
                      </a:cxn>
                      <a:cxn ang="0">
                        <a:pos x="connsiteX1" y="connsiteY1"/>
                      </a:cxn>
                      <a:cxn ang="0">
                        <a:pos x="connsiteX2" y="connsiteY2"/>
                      </a:cxn>
                      <a:cxn ang="0">
                        <a:pos x="connsiteX3" y="connsiteY3"/>
                      </a:cxn>
                    </a:cxnLst>
                    <a:rect l="l" t="t" r="r" b="b"/>
                    <a:pathLst>
                      <a:path w="319314" h="154819">
                        <a:moveTo>
                          <a:pt x="0" y="0"/>
                        </a:moveTo>
                        <a:cubicBezTo>
                          <a:pt x="24190" y="31448"/>
                          <a:pt x="48380" y="62896"/>
                          <a:pt x="87085" y="87086"/>
                        </a:cubicBezTo>
                        <a:cubicBezTo>
                          <a:pt x="125790" y="111276"/>
                          <a:pt x="193523" y="135467"/>
                          <a:pt x="232228" y="145143"/>
                        </a:cubicBezTo>
                        <a:cubicBezTo>
                          <a:pt x="270933" y="154819"/>
                          <a:pt x="295123" y="149981"/>
                          <a:pt x="319314" y="145143"/>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94" name="Freeform 193"/>
                  <p:cNvSpPr/>
                  <p:nvPr/>
                </p:nvSpPr>
                <p:spPr>
                  <a:xfrm>
                    <a:off x="3077029" y="2220686"/>
                    <a:ext cx="290285" cy="120952"/>
                  </a:xfrm>
                  <a:custGeom>
                    <a:avLst/>
                    <a:gdLst>
                      <a:gd name="connsiteX0" fmla="*/ 0 w 290285"/>
                      <a:gd name="connsiteY0" fmla="*/ 0 h 120952"/>
                      <a:gd name="connsiteX1" fmla="*/ 188685 w 290285"/>
                      <a:gd name="connsiteY1" fmla="*/ 101600 h 120952"/>
                      <a:gd name="connsiteX2" fmla="*/ 290285 w 290285"/>
                      <a:gd name="connsiteY2" fmla="*/ 116114 h 120952"/>
                    </a:gdLst>
                    <a:ahLst/>
                    <a:cxnLst>
                      <a:cxn ang="0">
                        <a:pos x="connsiteX0" y="connsiteY0"/>
                      </a:cxn>
                      <a:cxn ang="0">
                        <a:pos x="connsiteX1" y="connsiteY1"/>
                      </a:cxn>
                      <a:cxn ang="0">
                        <a:pos x="connsiteX2" y="connsiteY2"/>
                      </a:cxn>
                    </a:cxnLst>
                    <a:rect l="l" t="t" r="r" b="b"/>
                    <a:pathLst>
                      <a:path w="290285" h="120952">
                        <a:moveTo>
                          <a:pt x="0" y="0"/>
                        </a:moveTo>
                        <a:cubicBezTo>
                          <a:pt x="70152" y="41124"/>
                          <a:pt x="140304" y="82248"/>
                          <a:pt x="188685" y="101600"/>
                        </a:cubicBezTo>
                        <a:cubicBezTo>
                          <a:pt x="237066" y="120952"/>
                          <a:pt x="263675" y="118533"/>
                          <a:pt x="290285" y="116114"/>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95" name="Freeform 194"/>
                  <p:cNvSpPr/>
                  <p:nvPr/>
                </p:nvSpPr>
                <p:spPr>
                  <a:xfrm>
                    <a:off x="2743200" y="2119086"/>
                    <a:ext cx="14514" cy="275771"/>
                  </a:xfrm>
                  <a:custGeom>
                    <a:avLst/>
                    <a:gdLst>
                      <a:gd name="connsiteX0" fmla="*/ 14514 w 14514"/>
                      <a:gd name="connsiteY0" fmla="*/ 275771 h 275771"/>
                      <a:gd name="connsiteX1" fmla="*/ 0 w 14514"/>
                      <a:gd name="connsiteY1" fmla="*/ 174171 h 275771"/>
                      <a:gd name="connsiteX2" fmla="*/ 14514 w 14514"/>
                      <a:gd name="connsiteY2" fmla="*/ 0 h 275771"/>
                    </a:gdLst>
                    <a:ahLst/>
                    <a:cxnLst>
                      <a:cxn ang="0">
                        <a:pos x="connsiteX0" y="connsiteY0"/>
                      </a:cxn>
                      <a:cxn ang="0">
                        <a:pos x="connsiteX1" y="connsiteY1"/>
                      </a:cxn>
                      <a:cxn ang="0">
                        <a:pos x="connsiteX2" y="connsiteY2"/>
                      </a:cxn>
                    </a:cxnLst>
                    <a:rect l="l" t="t" r="r" b="b"/>
                    <a:pathLst>
                      <a:path w="14514" h="275771">
                        <a:moveTo>
                          <a:pt x="14514" y="275771"/>
                        </a:moveTo>
                        <a:cubicBezTo>
                          <a:pt x="7257" y="247952"/>
                          <a:pt x="0" y="220133"/>
                          <a:pt x="0" y="174171"/>
                        </a:cubicBezTo>
                        <a:cubicBezTo>
                          <a:pt x="0" y="128209"/>
                          <a:pt x="7257" y="64104"/>
                          <a:pt x="14514"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96" name="Freeform 195"/>
                  <p:cNvSpPr/>
                  <p:nvPr/>
                </p:nvSpPr>
                <p:spPr>
                  <a:xfrm>
                    <a:off x="2931886" y="1988457"/>
                    <a:ext cx="43543" cy="217714"/>
                  </a:xfrm>
                  <a:custGeom>
                    <a:avLst/>
                    <a:gdLst>
                      <a:gd name="connsiteX0" fmla="*/ 43543 w 43543"/>
                      <a:gd name="connsiteY0" fmla="*/ 217714 h 217714"/>
                      <a:gd name="connsiteX1" fmla="*/ 0 w 43543"/>
                      <a:gd name="connsiteY1" fmla="*/ 130629 h 217714"/>
                      <a:gd name="connsiteX2" fmla="*/ 43543 w 43543"/>
                      <a:gd name="connsiteY2" fmla="*/ 0 h 217714"/>
                    </a:gdLst>
                    <a:ahLst/>
                    <a:cxnLst>
                      <a:cxn ang="0">
                        <a:pos x="connsiteX0" y="connsiteY0"/>
                      </a:cxn>
                      <a:cxn ang="0">
                        <a:pos x="connsiteX1" y="connsiteY1"/>
                      </a:cxn>
                      <a:cxn ang="0">
                        <a:pos x="connsiteX2" y="connsiteY2"/>
                      </a:cxn>
                    </a:cxnLst>
                    <a:rect l="l" t="t" r="r" b="b"/>
                    <a:pathLst>
                      <a:path w="43543" h="217714">
                        <a:moveTo>
                          <a:pt x="43543" y="217714"/>
                        </a:moveTo>
                        <a:cubicBezTo>
                          <a:pt x="21771" y="192314"/>
                          <a:pt x="0" y="166915"/>
                          <a:pt x="0" y="130629"/>
                        </a:cubicBezTo>
                        <a:cubicBezTo>
                          <a:pt x="0" y="94343"/>
                          <a:pt x="21771" y="47171"/>
                          <a:pt x="435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97" name="Freeform 196"/>
                  <p:cNvSpPr/>
                  <p:nvPr/>
                </p:nvSpPr>
                <p:spPr>
                  <a:xfrm>
                    <a:off x="2714171" y="2467429"/>
                    <a:ext cx="217715" cy="101600"/>
                  </a:xfrm>
                  <a:custGeom>
                    <a:avLst/>
                    <a:gdLst>
                      <a:gd name="connsiteX0" fmla="*/ 0 w 217715"/>
                      <a:gd name="connsiteY0" fmla="*/ 0 h 101600"/>
                      <a:gd name="connsiteX1" fmla="*/ 116115 w 217715"/>
                      <a:gd name="connsiteY1" fmla="*/ 72571 h 101600"/>
                      <a:gd name="connsiteX2" fmla="*/ 217715 w 217715"/>
                      <a:gd name="connsiteY2" fmla="*/ 101600 h 101600"/>
                    </a:gdLst>
                    <a:ahLst/>
                    <a:cxnLst>
                      <a:cxn ang="0">
                        <a:pos x="connsiteX0" y="connsiteY0"/>
                      </a:cxn>
                      <a:cxn ang="0">
                        <a:pos x="connsiteX1" y="connsiteY1"/>
                      </a:cxn>
                      <a:cxn ang="0">
                        <a:pos x="connsiteX2" y="connsiteY2"/>
                      </a:cxn>
                    </a:cxnLst>
                    <a:rect l="l" t="t" r="r" b="b"/>
                    <a:pathLst>
                      <a:path w="217715" h="101600">
                        <a:moveTo>
                          <a:pt x="0" y="0"/>
                        </a:moveTo>
                        <a:cubicBezTo>
                          <a:pt x="39914" y="27819"/>
                          <a:pt x="79829" y="55638"/>
                          <a:pt x="116115" y="72571"/>
                        </a:cubicBezTo>
                        <a:cubicBezTo>
                          <a:pt x="152401" y="89504"/>
                          <a:pt x="185058" y="95552"/>
                          <a:pt x="217715" y="10160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98" name="Freeform 197"/>
                  <p:cNvSpPr/>
                  <p:nvPr/>
                </p:nvSpPr>
                <p:spPr>
                  <a:xfrm>
                    <a:off x="3207657" y="2104571"/>
                    <a:ext cx="246743" cy="33867"/>
                  </a:xfrm>
                  <a:custGeom>
                    <a:avLst/>
                    <a:gdLst>
                      <a:gd name="connsiteX0" fmla="*/ 0 w 246743"/>
                      <a:gd name="connsiteY0" fmla="*/ 29029 h 33867"/>
                      <a:gd name="connsiteX1" fmla="*/ 159657 w 246743"/>
                      <a:gd name="connsiteY1" fmla="*/ 29029 h 33867"/>
                      <a:gd name="connsiteX2" fmla="*/ 246743 w 246743"/>
                      <a:gd name="connsiteY2" fmla="*/ 0 h 33867"/>
                    </a:gdLst>
                    <a:ahLst/>
                    <a:cxnLst>
                      <a:cxn ang="0">
                        <a:pos x="connsiteX0" y="connsiteY0"/>
                      </a:cxn>
                      <a:cxn ang="0">
                        <a:pos x="connsiteX1" y="connsiteY1"/>
                      </a:cxn>
                      <a:cxn ang="0">
                        <a:pos x="connsiteX2" y="connsiteY2"/>
                      </a:cxn>
                    </a:cxnLst>
                    <a:rect l="l" t="t" r="r" b="b"/>
                    <a:pathLst>
                      <a:path w="246743" h="33867">
                        <a:moveTo>
                          <a:pt x="0" y="29029"/>
                        </a:moveTo>
                        <a:cubicBezTo>
                          <a:pt x="59266" y="31448"/>
                          <a:pt x="118533" y="33867"/>
                          <a:pt x="159657" y="29029"/>
                        </a:cubicBezTo>
                        <a:cubicBezTo>
                          <a:pt x="200781" y="24191"/>
                          <a:pt x="223762" y="12095"/>
                          <a:pt x="2467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grpSp>
              <p:nvGrpSpPr>
                <p:cNvPr id="126" name="Group 81"/>
                <p:cNvGrpSpPr/>
                <p:nvPr/>
              </p:nvGrpSpPr>
              <p:grpSpPr>
                <a:xfrm rot="925196" flipH="1">
                  <a:off x="998399" y="2966108"/>
                  <a:ext cx="1348499" cy="925782"/>
                  <a:chOff x="2206171" y="1548190"/>
                  <a:chExt cx="1340152" cy="1180496"/>
                </a:xfrm>
              </p:grpSpPr>
              <p:sp>
                <p:nvSpPr>
                  <p:cNvPr id="183" name="Freeform 82"/>
                  <p:cNvSpPr/>
                  <p:nvPr/>
                </p:nvSpPr>
                <p:spPr>
                  <a:xfrm>
                    <a:off x="2206171" y="1548190"/>
                    <a:ext cx="1340152" cy="1180496"/>
                  </a:xfrm>
                  <a:custGeom>
                    <a:avLst/>
                    <a:gdLst>
                      <a:gd name="connsiteX0" fmla="*/ 0 w 1340152"/>
                      <a:gd name="connsiteY0" fmla="*/ 1180496 h 1180496"/>
                      <a:gd name="connsiteX1" fmla="*/ 290286 w 1340152"/>
                      <a:gd name="connsiteY1" fmla="*/ 962781 h 1180496"/>
                      <a:gd name="connsiteX2" fmla="*/ 653143 w 1340152"/>
                      <a:gd name="connsiteY2" fmla="*/ 1078896 h 1180496"/>
                      <a:gd name="connsiteX3" fmla="*/ 1204686 w 1340152"/>
                      <a:gd name="connsiteY3" fmla="*/ 832153 h 1180496"/>
                      <a:gd name="connsiteX4" fmla="*/ 1320800 w 1340152"/>
                      <a:gd name="connsiteY4" fmla="*/ 91924 h 1180496"/>
                      <a:gd name="connsiteX5" fmla="*/ 1088572 w 1340152"/>
                      <a:gd name="connsiteY5" fmla="*/ 280610 h 1180496"/>
                      <a:gd name="connsiteX6" fmla="*/ 638629 w 1340152"/>
                      <a:gd name="connsiteY6" fmla="*/ 396724 h 1180496"/>
                      <a:gd name="connsiteX7" fmla="*/ 391886 w 1340152"/>
                      <a:gd name="connsiteY7" fmla="*/ 745067 h 1180496"/>
                      <a:gd name="connsiteX8" fmla="*/ 319315 w 1340152"/>
                      <a:gd name="connsiteY8" fmla="*/ 919239 h 1180496"/>
                      <a:gd name="connsiteX9" fmla="*/ 58058 w 1340152"/>
                      <a:gd name="connsiteY9" fmla="*/ 1107924 h 11804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340152" h="1180496">
                        <a:moveTo>
                          <a:pt x="0" y="1180496"/>
                        </a:moveTo>
                        <a:cubicBezTo>
                          <a:pt x="90714" y="1080105"/>
                          <a:pt x="181429" y="979714"/>
                          <a:pt x="290286" y="962781"/>
                        </a:cubicBezTo>
                        <a:cubicBezTo>
                          <a:pt x="399143" y="945848"/>
                          <a:pt x="500743" y="1100667"/>
                          <a:pt x="653143" y="1078896"/>
                        </a:cubicBezTo>
                        <a:cubicBezTo>
                          <a:pt x="805543" y="1057125"/>
                          <a:pt x="1093410" y="996648"/>
                          <a:pt x="1204686" y="832153"/>
                        </a:cubicBezTo>
                        <a:cubicBezTo>
                          <a:pt x="1315962" y="667658"/>
                          <a:pt x="1340152" y="183848"/>
                          <a:pt x="1320800" y="91924"/>
                        </a:cubicBezTo>
                        <a:cubicBezTo>
                          <a:pt x="1301448" y="0"/>
                          <a:pt x="1202267" y="229810"/>
                          <a:pt x="1088572" y="280610"/>
                        </a:cubicBezTo>
                        <a:cubicBezTo>
                          <a:pt x="974877" y="331410"/>
                          <a:pt x="754743" y="319315"/>
                          <a:pt x="638629" y="396724"/>
                        </a:cubicBezTo>
                        <a:cubicBezTo>
                          <a:pt x="522515" y="474133"/>
                          <a:pt x="445105" y="657981"/>
                          <a:pt x="391886" y="745067"/>
                        </a:cubicBezTo>
                        <a:cubicBezTo>
                          <a:pt x="338667" y="832153"/>
                          <a:pt x="374953" y="858763"/>
                          <a:pt x="319315" y="919239"/>
                        </a:cubicBezTo>
                        <a:cubicBezTo>
                          <a:pt x="263677" y="979715"/>
                          <a:pt x="160867" y="1043819"/>
                          <a:pt x="58058" y="1107924"/>
                        </a:cubicBezTo>
                      </a:path>
                    </a:pathLst>
                  </a:custGeom>
                  <a:solidFill>
                    <a:srgbClr val="97E44A"/>
                  </a:solidFill>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84" name="Freeform 83"/>
                  <p:cNvSpPr/>
                  <p:nvPr/>
                </p:nvSpPr>
                <p:spPr>
                  <a:xfrm>
                    <a:off x="2525486" y="1669143"/>
                    <a:ext cx="996647" cy="812800"/>
                  </a:xfrm>
                  <a:custGeom>
                    <a:avLst/>
                    <a:gdLst>
                      <a:gd name="connsiteX0" fmla="*/ 0 w 996647"/>
                      <a:gd name="connsiteY0" fmla="*/ 812800 h 812800"/>
                      <a:gd name="connsiteX1" fmla="*/ 261257 w 996647"/>
                      <a:gd name="connsiteY1" fmla="*/ 696686 h 812800"/>
                      <a:gd name="connsiteX2" fmla="*/ 624114 w 996647"/>
                      <a:gd name="connsiteY2" fmla="*/ 449943 h 812800"/>
                      <a:gd name="connsiteX3" fmla="*/ 943428 w 996647"/>
                      <a:gd name="connsiteY3" fmla="*/ 116114 h 812800"/>
                      <a:gd name="connsiteX4" fmla="*/ 943428 w 996647"/>
                      <a:gd name="connsiteY4" fmla="*/ 0 h 8128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996647" h="812800">
                        <a:moveTo>
                          <a:pt x="0" y="812800"/>
                        </a:moveTo>
                        <a:cubicBezTo>
                          <a:pt x="78619" y="784981"/>
                          <a:pt x="157238" y="757162"/>
                          <a:pt x="261257" y="696686"/>
                        </a:cubicBezTo>
                        <a:cubicBezTo>
                          <a:pt x="365276" y="636210"/>
                          <a:pt x="510419" y="546705"/>
                          <a:pt x="624114" y="449943"/>
                        </a:cubicBezTo>
                        <a:cubicBezTo>
                          <a:pt x="737809" y="353181"/>
                          <a:pt x="890209" y="191104"/>
                          <a:pt x="943428" y="116114"/>
                        </a:cubicBezTo>
                        <a:cubicBezTo>
                          <a:pt x="996647" y="41124"/>
                          <a:pt x="970037" y="20562"/>
                          <a:pt x="943428"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85" name="Freeform 84"/>
                  <p:cNvSpPr/>
                  <p:nvPr/>
                </p:nvSpPr>
                <p:spPr>
                  <a:xfrm>
                    <a:off x="2931886" y="2336800"/>
                    <a:ext cx="319314" cy="154819"/>
                  </a:xfrm>
                  <a:custGeom>
                    <a:avLst/>
                    <a:gdLst>
                      <a:gd name="connsiteX0" fmla="*/ 0 w 319314"/>
                      <a:gd name="connsiteY0" fmla="*/ 0 h 154819"/>
                      <a:gd name="connsiteX1" fmla="*/ 87085 w 319314"/>
                      <a:gd name="connsiteY1" fmla="*/ 87086 h 154819"/>
                      <a:gd name="connsiteX2" fmla="*/ 232228 w 319314"/>
                      <a:gd name="connsiteY2" fmla="*/ 145143 h 154819"/>
                      <a:gd name="connsiteX3" fmla="*/ 319314 w 319314"/>
                      <a:gd name="connsiteY3" fmla="*/ 145143 h 154819"/>
                    </a:gdLst>
                    <a:ahLst/>
                    <a:cxnLst>
                      <a:cxn ang="0">
                        <a:pos x="connsiteX0" y="connsiteY0"/>
                      </a:cxn>
                      <a:cxn ang="0">
                        <a:pos x="connsiteX1" y="connsiteY1"/>
                      </a:cxn>
                      <a:cxn ang="0">
                        <a:pos x="connsiteX2" y="connsiteY2"/>
                      </a:cxn>
                      <a:cxn ang="0">
                        <a:pos x="connsiteX3" y="connsiteY3"/>
                      </a:cxn>
                    </a:cxnLst>
                    <a:rect l="l" t="t" r="r" b="b"/>
                    <a:pathLst>
                      <a:path w="319314" h="154819">
                        <a:moveTo>
                          <a:pt x="0" y="0"/>
                        </a:moveTo>
                        <a:cubicBezTo>
                          <a:pt x="24190" y="31448"/>
                          <a:pt x="48380" y="62896"/>
                          <a:pt x="87085" y="87086"/>
                        </a:cubicBezTo>
                        <a:cubicBezTo>
                          <a:pt x="125790" y="111276"/>
                          <a:pt x="193523" y="135467"/>
                          <a:pt x="232228" y="145143"/>
                        </a:cubicBezTo>
                        <a:cubicBezTo>
                          <a:pt x="270933" y="154819"/>
                          <a:pt x="295123" y="149981"/>
                          <a:pt x="319314" y="145143"/>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86" name="Freeform 85"/>
                  <p:cNvSpPr/>
                  <p:nvPr/>
                </p:nvSpPr>
                <p:spPr>
                  <a:xfrm>
                    <a:off x="3077029" y="2220686"/>
                    <a:ext cx="290285" cy="120952"/>
                  </a:xfrm>
                  <a:custGeom>
                    <a:avLst/>
                    <a:gdLst>
                      <a:gd name="connsiteX0" fmla="*/ 0 w 290285"/>
                      <a:gd name="connsiteY0" fmla="*/ 0 h 120952"/>
                      <a:gd name="connsiteX1" fmla="*/ 188685 w 290285"/>
                      <a:gd name="connsiteY1" fmla="*/ 101600 h 120952"/>
                      <a:gd name="connsiteX2" fmla="*/ 290285 w 290285"/>
                      <a:gd name="connsiteY2" fmla="*/ 116114 h 120952"/>
                    </a:gdLst>
                    <a:ahLst/>
                    <a:cxnLst>
                      <a:cxn ang="0">
                        <a:pos x="connsiteX0" y="connsiteY0"/>
                      </a:cxn>
                      <a:cxn ang="0">
                        <a:pos x="connsiteX1" y="connsiteY1"/>
                      </a:cxn>
                      <a:cxn ang="0">
                        <a:pos x="connsiteX2" y="connsiteY2"/>
                      </a:cxn>
                    </a:cxnLst>
                    <a:rect l="l" t="t" r="r" b="b"/>
                    <a:pathLst>
                      <a:path w="290285" h="120952">
                        <a:moveTo>
                          <a:pt x="0" y="0"/>
                        </a:moveTo>
                        <a:cubicBezTo>
                          <a:pt x="70152" y="41124"/>
                          <a:pt x="140304" y="82248"/>
                          <a:pt x="188685" y="101600"/>
                        </a:cubicBezTo>
                        <a:cubicBezTo>
                          <a:pt x="237066" y="120952"/>
                          <a:pt x="263675" y="118533"/>
                          <a:pt x="290285" y="116114"/>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87" name="Freeform 86"/>
                  <p:cNvSpPr/>
                  <p:nvPr/>
                </p:nvSpPr>
                <p:spPr>
                  <a:xfrm>
                    <a:off x="2743200" y="2119086"/>
                    <a:ext cx="14514" cy="275771"/>
                  </a:xfrm>
                  <a:custGeom>
                    <a:avLst/>
                    <a:gdLst>
                      <a:gd name="connsiteX0" fmla="*/ 14514 w 14514"/>
                      <a:gd name="connsiteY0" fmla="*/ 275771 h 275771"/>
                      <a:gd name="connsiteX1" fmla="*/ 0 w 14514"/>
                      <a:gd name="connsiteY1" fmla="*/ 174171 h 275771"/>
                      <a:gd name="connsiteX2" fmla="*/ 14514 w 14514"/>
                      <a:gd name="connsiteY2" fmla="*/ 0 h 275771"/>
                    </a:gdLst>
                    <a:ahLst/>
                    <a:cxnLst>
                      <a:cxn ang="0">
                        <a:pos x="connsiteX0" y="connsiteY0"/>
                      </a:cxn>
                      <a:cxn ang="0">
                        <a:pos x="connsiteX1" y="connsiteY1"/>
                      </a:cxn>
                      <a:cxn ang="0">
                        <a:pos x="connsiteX2" y="connsiteY2"/>
                      </a:cxn>
                    </a:cxnLst>
                    <a:rect l="l" t="t" r="r" b="b"/>
                    <a:pathLst>
                      <a:path w="14514" h="275771">
                        <a:moveTo>
                          <a:pt x="14514" y="275771"/>
                        </a:moveTo>
                        <a:cubicBezTo>
                          <a:pt x="7257" y="247952"/>
                          <a:pt x="0" y="220133"/>
                          <a:pt x="0" y="174171"/>
                        </a:cubicBezTo>
                        <a:cubicBezTo>
                          <a:pt x="0" y="128209"/>
                          <a:pt x="7257" y="64104"/>
                          <a:pt x="14514"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88" name="Freeform 87"/>
                  <p:cNvSpPr/>
                  <p:nvPr/>
                </p:nvSpPr>
                <p:spPr>
                  <a:xfrm>
                    <a:off x="2931886" y="1988457"/>
                    <a:ext cx="43543" cy="217714"/>
                  </a:xfrm>
                  <a:custGeom>
                    <a:avLst/>
                    <a:gdLst>
                      <a:gd name="connsiteX0" fmla="*/ 43543 w 43543"/>
                      <a:gd name="connsiteY0" fmla="*/ 217714 h 217714"/>
                      <a:gd name="connsiteX1" fmla="*/ 0 w 43543"/>
                      <a:gd name="connsiteY1" fmla="*/ 130629 h 217714"/>
                      <a:gd name="connsiteX2" fmla="*/ 43543 w 43543"/>
                      <a:gd name="connsiteY2" fmla="*/ 0 h 217714"/>
                    </a:gdLst>
                    <a:ahLst/>
                    <a:cxnLst>
                      <a:cxn ang="0">
                        <a:pos x="connsiteX0" y="connsiteY0"/>
                      </a:cxn>
                      <a:cxn ang="0">
                        <a:pos x="connsiteX1" y="connsiteY1"/>
                      </a:cxn>
                      <a:cxn ang="0">
                        <a:pos x="connsiteX2" y="connsiteY2"/>
                      </a:cxn>
                    </a:cxnLst>
                    <a:rect l="l" t="t" r="r" b="b"/>
                    <a:pathLst>
                      <a:path w="43543" h="217714">
                        <a:moveTo>
                          <a:pt x="43543" y="217714"/>
                        </a:moveTo>
                        <a:cubicBezTo>
                          <a:pt x="21771" y="192314"/>
                          <a:pt x="0" y="166915"/>
                          <a:pt x="0" y="130629"/>
                        </a:cubicBezTo>
                        <a:cubicBezTo>
                          <a:pt x="0" y="94343"/>
                          <a:pt x="21771" y="47171"/>
                          <a:pt x="435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89" name="Freeform 88"/>
                  <p:cNvSpPr/>
                  <p:nvPr/>
                </p:nvSpPr>
                <p:spPr>
                  <a:xfrm>
                    <a:off x="2714171" y="2467429"/>
                    <a:ext cx="217715" cy="101600"/>
                  </a:xfrm>
                  <a:custGeom>
                    <a:avLst/>
                    <a:gdLst>
                      <a:gd name="connsiteX0" fmla="*/ 0 w 217715"/>
                      <a:gd name="connsiteY0" fmla="*/ 0 h 101600"/>
                      <a:gd name="connsiteX1" fmla="*/ 116115 w 217715"/>
                      <a:gd name="connsiteY1" fmla="*/ 72571 h 101600"/>
                      <a:gd name="connsiteX2" fmla="*/ 217715 w 217715"/>
                      <a:gd name="connsiteY2" fmla="*/ 101600 h 101600"/>
                    </a:gdLst>
                    <a:ahLst/>
                    <a:cxnLst>
                      <a:cxn ang="0">
                        <a:pos x="connsiteX0" y="connsiteY0"/>
                      </a:cxn>
                      <a:cxn ang="0">
                        <a:pos x="connsiteX1" y="connsiteY1"/>
                      </a:cxn>
                      <a:cxn ang="0">
                        <a:pos x="connsiteX2" y="connsiteY2"/>
                      </a:cxn>
                    </a:cxnLst>
                    <a:rect l="l" t="t" r="r" b="b"/>
                    <a:pathLst>
                      <a:path w="217715" h="101600">
                        <a:moveTo>
                          <a:pt x="0" y="0"/>
                        </a:moveTo>
                        <a:cubicBezTo>
                          <a:pt x="39914" y="27819"/>
                          <a:pt x="79829" y="55638"/>
                          <a:pt x="116115" y="72571"/>
                        </a:cubicBezTo>
                        <a:cubicBezTo>
                          <a:pt x="152401" y="89504"/>
                          <a:pt x="185058" y="95552"/>
                          <a:pt x="217715" y="10160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90" name="Freeform 89"/>
                  <p:cNvSpPr/>
                  <p:nvPr/>
                </p:nvSpPr>
                <p:spPr>
                  <a:xfrm>
                    <a:off x="3207657" y="2104571"/>
                    <a:ext cx="246743" cy="33867"/>
                  </a:xfrm>
                  <a:custGeom>
                    <a:avLst/>
                    <a:gdLst>
                      <a:gd name="connsiteX0" fmla="*/ 0 w 246743"/>
                      <a:gd name="connsiteY0" fmla="*/ 29029 h 33867"/>
                      <a:gd name="connsiteX1" fmla="*/ 159657 w 246743"/>
                      <a:gd name="connsiteY1" fmla="*/ 29029 h 33867"/>
                      <a:gd name="connsiteX2" fmla="*/ 246743 w 246743"/>
                      <a:gd name="connsiteY2" fmla="*/ 0 h 33867"/>
                    </a:gdLst>
                    <a:ahLst/>
                    <a:cxnLst>
                      <a:cxn ang="0">
                        <a:pos x="connsiteX0" y="connsiteY0"/>
                      </a:cxn>
                      <a:cxn ang="0">
                        <a:pos x="connsiteX1" y="connsiteY1"/>
                      </a:cxn>
                      <a:cxn ang="0">
                        <a:pos x="connsiteX2" y="connsiteY2"/>
                      </a:cxn>
                    </a:cxnLst>
                    <a:rect l="l" t="t" r="r" b="b"/>
                    <a:pathLst>
                      <a:path w="246743" h="33867">
                        <a:moveTo>
                          <a:pt x="0" y="29029"/>
                        </a:moveTo>
                        <a:cubicBezTo>
                          <a:pt x="59266" y="31448"/>
                          <a:pt x="118533" y="33867"/>
                          <a:pt x="159657" y="29029"/>
                        </a:cubicBezTo>
                        <a:cubicBezTo>
                          <a:pt x="200781" y="24191"/>
                          <a:pt x="223762" y="12095"/>
                          <a:pt x="2467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grpSp>
              <p:nvGrpSpPr>
                <p:cNvPr id="127" name="Group 90"/>
                <p:cNvGrpSpPr/>
                <p:nvPr/>
              </p:nvGrpSpPr>
              <p:grpSpPr>
                <a:xfrm>
                  <a:off x="2124074" y="3645024"/>
                  <a:ext cx="1367805" cy="964472"/>
                  <a:chOff x="2206171" y="1548190"/>
                  <a:chExt cx="1340152" cy="1180496"/>
                </a:xfrm>
              </p:grpSpPr>
              <p:sp>
                <p:nvSpPr>
                  <p:cNvPr id="175" name="Freeform 174"/>
                  <p:cNvSpPr/>
                  <p:nvPr/>
                </p:nvSpPr>
                <p:spPr>
                  <a:xfrm>
                    <a:off x="2206171" y="1548190"/>
                    <a:ext cx="1340152" cy="1180496"/>
                  </a:xfrm>
                  <a:custGeom>
                    <a:avLst/>
                    <a:gdLst>
                      <a:gd name="connsiteX0" fmla="*/ 0 w 1340152"/>
                      <a:gd name="connsiteY0" fmla="*/ 1180496 h 1180496"/>
                      <a:gd name="connsiteX1" fmla="*/ 290286 w 1340152"/>
                      <a:gd name="connsiteY1" fmla="*/ 962781 h 1180496"/>
                      <a:gd name="connsiteX2" fmla="*/ 653143 w 1340152"/>
                      <a:gd name="connsiteY2" fmla="*/ 1078896 h 1180496"/>
                      <a:gd name="connsiteX3" fmla="*/ 1204686 w 1340152"/>
                      <a:gd name="connsiteY3" fmla="*/ 832153 h 1180496"/>
                      <a:gd name="connsiteX4" fmla="*/ 1320800 w 1340152"/>
                      <a:gd name="connsiteY4" fmla="*/ 91924 h 1180496"/>
                      <a:gd name="connsiteX5" fmla="*/ 1088572 w 1340152"/>
                      <a:gd name="connsiteY5" fmla="*/ 280610 h 1180496"/>
                      <a:gd name="connsiteX6" fmla="*/ 638629 w 1340152"/>
                      <a:gd name="connsiteY6" fmla="*/ 396724 h 1180496"/>
                      <a:gd name="connsiteX7" fmla="*/ 391886 w 1340152"/>
                      <a:gd name="connsiteY7" fmla="*/ 745067 h 1180496"/>
                      <a:gd name="connsiteX8" fmla="*/ 319315 w 1340152"/>
                      <a:gd name="connsiteY8" fmla="*/ 919239 h 1180496"/>
                      <a:gd name="connsiteX9" fmla="*/ 58058 w 1340152"/>
                      <a:gd name="connsiteY9" fmla="*/ 1107924 h 11804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340152" h="1180496">
                        <a:moveTo>
                          <a:pt x="0" y="1180496"/>
                        </a:moveTo>
                        <a:cubicBezTo>
                          <a:pt x="90714" y="1080105"/>
                          <a:pt x="181429" y="979714"/>
                          <a:pt x="290286" y="962781"/>
                        </a:cubicBezTo>
                        <a:cubicBezTo>
                          <a:pt x="399143" y="945848"/>
                          <a:pt x="500743" y="1100667"/>
                          <a:pt x="653143" y="1078896"/>
                        </a:cubicBezTo>
                        <a:cubicBezTo>
                          <a:pt x="805543" y="1057125"/>
                          <a:pt x="1093410" y="996648"/>
                          <a:pt x="1204686" y="832153"/>
                        </a:cubicBezTo>
                        <a:cubicBezTo>
                          <a:pt x="1315962" y="667658"/>
                          <a:pt x="1340152" y="183848"/>
                          <a:pt x="1320800" y="91924"/>
                        </a:cubicBezTo>
                        <a:cubicBezTo>
                          <a:pt x="1301448" y="0"/>
                          <a:pt x="1202267" y="229810"/>
                          <a:pt x="1088572" y="280610"/>
                        </a:cubicBezTo>
                        <a:cubicBezTo>
                          <a:pt x="974877" y="331410"/>
                          <a:pt x="754743" y="319315"/>
                          <a:pt x="638629" y="396724"/>
                        </a:cubicBezTo>
                        <a:cubicBezTo>
                          <a:pt x="522515" y="474133"/>
                          <a:pt x="445105" y="657981"/>
                          <a:pt x="391886" y="745067"/>
                        </a:cubicBezTo>
                        <a:cubicBezTo>
                          <a:pt x="338667" y="832153"/>
                          <a:pt x="374953" y="858763"/>
                          <a:pt x="319315" y="919239"/>
                        </a:cubicBezTo>
                        <a:cubicBezTo>
                          <a:pt x="263677" y="979715"/>
                          <a:pt x="160867" y="1043819"/>
                          <a:pt x="58058" y="1107924"/>
                        </a:cubicBezTo>
                      </a:path>
                    </a:pathLst>
                  </a:custGeom>
                  <a:solidFill>
                    <a:srgbClr val="97E44A"/>
                  </a:solidFill>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76" name="Freeform 175"/>
                  <p:cNvSpPr/>
                  <p:nvPr/>
                </p:nvSpPr>
                <p:spPr>
                  <a:xfrm>
                    <a:off x="2525486" y="1669143"/>
                    <a:ext cx="996647" cy="812800"/>
                  </a:xfrm>
                  <a:custGeom>
                    <a:avLst/>
                    <a:gdLst>
                      <a:gd name="connsiteX0" fmla="*/ 0 w 996647"/>
                      <a:gd name="connsiteY0" fmla="*/ 812800 h 812800"/>
                      <a:gd name="connsiteX1" fmla="*/ 261257 w 996647"/>
                      <a:gd name="connsiteY1" fmla="*/ 696686 h 812800"/>
                      <a:gd name="connsiteX2" fmla="*/ 624114 w 996647"/>
                      <a:gd name="connsiteY2" fmla="*/ 449943 h 812800"/>
                      <a:gd name="connsiteX3" fmla="*/ 943428 w 996647"/>
                      <a:gd name="connsiteY3" fmla="*/ 116114 h 812800"/>
                      <a:gd name="connsiteX4" fmla="*/ 943428 w 996647"/>
                      <a:gd name="connsiteY4" fmla="*/ 0 h 8128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996647" h="812800">
                        <a:moveTo>
                          <a:pt x="0" y="812800"/>
                        </a:moveTo>
                        <a:cubicBezTo>
                          <a:pt x="78619" y="784981"/>
                          <a:pt x="157238" y="757162"/>
                          <a:pt x="261257" y="696686"/>
                        </a:cubicBezTo>
                        <a:cubicBezTo>
                          <a:pt x="365276" y="636210"/>
                          <a:pt x="510419" y="546705"/>
                          <a:pt x="624114" y="449943"/>
                        </a:cubicBezTo>
                        <a:cubicBezTo>
                          <a:pt x="737809" y="353181"/>
                          <a:pt x="890209" y="191104"/>
                          <a:pt x="943428" y="116114"/>
                        </a:cubicBezTo>
                        <a:cubicBezTo>
                          <a:pt x="996647" y="41124"/>
                          <a:pt x="970037" y="20562"/>
                          <a:pt x="943428"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77" name="Freeform 176"/>
                  <p:cNvSpPr/>
                  <p:nvPr/>
                </p:nvSpPr>
                <p:spPr>
                  <a:xfrm>
                    <a:off x="2931886" y="2336800"/>
                    <a:ext cx="319314" cy="154819"/>
                  </a:xfrm>
                  <a:custGeom>
                    <a:avLst/>
                    <a:gdLst>
                      <a:gd name="connsiteX0" fmla="*/ 0 w 319314"/>
                      <a:gd name="connsiteY0" fmla="*/ 0 h 154819"/>
                      <a:gd name="connsiteX1" fmla="*/ 87085 w 319314"/>
                      <a:gd name="connsiteY1" fmla="*/ 87086 h 154819"/>
                      <a:gd name="connsiteX2" fmla="*/ 232228 w 319314"/>
                      <a:gd name="connsiteY2" fmla="*/ 145143 h 154819"/>
                      <a:gd name="connsiteX3" fmla="*/ 319314 w 319314"/>
                      <a:gd name="connsiteY3" fmla="*/ 145143 h 154819"/>
                    </a:gdLst>
                    <a:ahLst/>
                    <a:cxnLst>
                      <a:cxn ang="0">
                        <a:pos x="connsiteX0" y="connsiteY0"/>
                      </a:cxn>
                      <a:cxn ang="0">
                        <a:pos x="connsiteX1" y="connsiteY1"/>
                      </a:cxn>
                      <a:cxn ang="0">
                        <a:pos x="connsiteX2" y="connsiteY2"/>
                      </a:cxn>
                      <a:cxn ang="0">
                        <a:pos x="connsiteX3" y="connsiteY3"/>
                      </a:cxn>
                    </a:cxnLst>
                    <a:rect l="l" t="t" r="r" b="b"/>
                    <a:pathLst>
                      <a:path w="319314" h="154819">
                        <a:moveTo>
                          <a:pt x="0" y="0"/>
                        </a:moveTo>
                        <a:cubicBezTo>
                          <a:pt x="24190" y="31448"/>
                          <a:pt x="48380" y="62896"/>
                          <a:pt x="87085" y="87086"/>
                        </a:cubicBezTo>
                        <a:cubicBezTo>
                          <a:pt x="125790" y="111276"/>
                          <a:pt x="193523" y="135467"/>
                          <a:pt x="232228" y="145143"/>
                        </a:cubicBezTo>
                        <a:cubicBezTo>
                          <a:pt x="270933" y="154819"/>
                          <a:pt x="295123" y="149981"/>
                          <a:pt x="319314" y="145143"/>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78" name="Freeform 177"/>
                  <p:cNvSpPr/>
                  <p:nvPr/>
                </p:nvSpPr>
                <p:spPr>
                  <a:xfrm>
                    <a:off x="3077029" y="2220686"/>
                    <a:ext cx="290285" cy="120952"/>
                  </a:xfrm>
                  <a:custGeom>
                    <a:avLst/>
                    <a:gdLst>
                      <a:gd name="connsiteX0" fmla="*/ 0 w 290285"/>
                      <a:gd name="connsiteY0" fmla="*/ 0 h 120952"/>
                      <a:gd name="connsiteX1" fmla="*/ 188685 w 290285"/>
                      <a:gd name="connsiteY1" fmla="*/ 101600 h 120952"/>
                      <a:gd name="connsiteX2" fmla="*/ 290285 w 290285"/>
                      <a:gd name="connsiteY2" fmla="*/ 116114 h 120952"/>
                    </a:gdLst>
                    <a:ahLst/>
                    <a:cxnLst>
                      <a:cxn ang="0">
                        <a:pos x="connsiteX0" y="connsiteY0"/>
                      </a:cxn>
                      <a:cxn ang="0">
                        <a:pos x="connsiteX1" y="connsiteY1"/>
                      </a:cxn>
                      <a:cxn ang="0">
                        <a:pos x="connsiteX2" y="connsiteY2"/>
                      </a:cxn>
                    </a:cxnLst>
                    <a:rect l="l" t="t" r="r" b="b"/>
                    <a:pathLst>
                      <a:path w="290285" h="120952">
                        <a:moveTo>
                          <a:pt x="0" y="0"/>
                        </a:moveTo>
                        <a:cubicBezTo>
                          <a:pt x="70152" y="41124"/>
                          <a:pt x="140304" y="82248"/>
                          <a:pt x="188685" y="101600"/>
                        </a:cubicBezTo>
                        <a:cubicBezTo>
                          <a:pt x="237066" y="120952"/>
                          <a:pt x="263675" y="118533"/>
                          <a:pt x="290285" y="116114"/>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79" name="Freeform 178"/>
                  <p:cNvSpPr/>
                  <p:nvPr/>
                </p:nvSpPr>
                <p:spPr>
                  <a:xfrm>
                    <a:off x="2743200" y="2119086"/>
                    <a:ext cx="14514" cy="275771"/>
                  </a:xfrm>
                  <a:custGeom>
                    <a:avLst/>
                    <a:gdLst>
                      <a:gd name="connsiteX0" fmla="*/ 14514 w 14514"/>
                      <a:gd name="connsiteY0" fmla="*/ 275771 h 275771"/>
                      <a:gd name="connsiteX1" fmla="*/ 0 w 14514"/>
                      <a:gd name="connsiteY1" fmla="*/ 174171 h 275771"/>
                      <a:gd name="connsiteX2" fmla="*/ 14514 w 14514"/>
                      <a:gd name="connsiteY2" fmla="*/ 0 h 275771"/>
                    </a:gdLst>
                    <a:ahLst/>
                    <a:cxnLst>
                      <a:cxn ang="0">
                        <a:pos x="connsiteX0" y="connsiteY0"/>
                      </a:cxn>
                      <a:cxn ang="0">
                        <a:pos x="connsiteX1" y="connsiteY1"/>
                      </a:cxn>
                      <a:cxn ang="0">
                        <a:pos x="connsiteX2" y="connsiteY2"/>
                      </a:cxn>
                    </a:cxnLst>
                    <a:rect l="l" t="t" r="r" b="b"/>
                    <a:pathLst>
                      <a:path w="14514" h="275771">
                        <a:moveTo>
                          <a:pt x="14514" y="275771"/>
                        </a:moveTo>
                        <a:cubicBezTo>
                          <a:pt x="7257" y="247952"/>
                          <a:pt x="0" y="220133"/>
                          <a:pt x="0" y="174171"/>
                        </a:cubicBezTo>
                        <a:cubicBezTo>
                          <a:pt x="0" y="128209"/>
                          <a:pt x="7257" y="64104"/>
                          <a:pt x="14514"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80" name="Freeform 179"/>
                  <p:cNvSpPr/>
                  <p:nvPr/>
                </p:nvSpPr>
                <p:spPr>
                  <a:xfrm>
                    <a:off x="2931886" y="1988457"/>
                    <a:ext cx="43543" cy="217714"/>
                  </a:xfrm>
                  <a:custGeom>
                    <a:avLst/>
                    <a:gdLst>
                      <a:gd name="connsiteX0" fmla="*/ 43543 w 43543"/>
                      <a:gd name="connsiteY0" fmla="*/ 217714 h 217714"/>
                      <a:gd name="connsiteX1" fmla="*/ 0 w 43543"/>
                      <a:gd name="connsiteY1" fmla="*/ 130629 h 217714"/>
                      <a:gd name="connsiteX2" fmla="*/ 43543 w 43543"/>
                      <a:gd name="connsiteY2" fmla="*/ 0 h 217714"/>
                    </a:gdLst>
                    <a:ahLst/>
                    <a:cxnLst>
                      <a:cxn ang="0">
                        <a:pos x="connsiteX0" y="connsiteY0"/>
                      </a:cxn>
                      <a:cxn ang="0">
                        <a:pos x="connsiteX1" y="connsiteY1"/>
                      </a:cxn>
                      <a:cxn ang="0">
                        <a:pos x="connsiteX2" y="connsiteY2"/>
                      </a:cxn>
                    </a:cxnLst>
                    <a:rect l="l" t="t" r="r" b="b"/>
                    <a:pathLst>
                      <a:path w="43543" h="217714">
                        <a:moveTo>
                          <a:pt x="43543" y="217714"/>
                        </a:moveTo>
                        <a:cubicBezTo>
                          <a:pt x="21771" y="192314"/>
                          <a:pt x="0" y="166915"/>
                          <a:pt x="0" y="130629"/>
                        </a:cubicBezTo>
                        <a:cubicBezTo>
                          <a:pt x="0" y="94343"/>
                          <a:pt x="21771" y="47171"/>
                          <a:pt x="435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81" name="Freeform 180"/>
                  <p:cNvSpPr/>
                  <p:nvPr/>
                </p:nvSpPr>
                <p:spPr>
                  <a:xfrm>
                    <a:off x="2714171" y="2467429"/>
                    <a:ext cx="217715" cy="101600"/>
                  </a:xfrm>
                  <a:custGeom>
                    <a:avLst/>
                    <a:gdLst>
                      <a:gd name="connsiteX0" fmla="*/ 0 w 217715"/>
                      <a:gd name="connsiteY0" fmla="*/ 0 h 101600"/>
                      <a:gd name="connsiteX1" fmla="*/ 116115 w 217715"/>
                      <a:gd name="connsiteY1" fmla="*/ 72571 h 101600"/>
                      <a:gd name="connsiteX2" fmla="*/ 217715 w 217715"/>
                      <a:gd name="connsiteY2" fmla="*/ 101600 h 101600"/>
                    </a:gdLst>
                    <a:ahLst/>
                    <a:cxnLst>
                      <a:cxn ang="0">
                        <a:pos x="connsiteX0" y="connsiteY0"/>
                      </a:cxn>
                      <a:cxn ang="0">
                        <a:pos x="connsiteX1" y="connsiteY1"/>
                      </a:cxn>
                      <a:cxn ang="0">
                        <a:pos x="connsiteX2" y="connsiteY2"/>
                      </a:cxn>
                    </a:cxnLst>
                    <a:rect l="l" t="t" r="r" b="b"/>
                    <a:pathLst>
                      <a:path w="217715" h="101600">
                        <a:moveTo>
                          <a:pt x="0" y="0"/>
                        </a:moveTo>
                        <a:cubicBezTo>
                          <a:pt x="39914" y="27819"/>
                          <a:pt x="79829" y="55638"/>
                          <a:pt x="116115" y="72571"/>
                        </a:cubicBezTo>
                        <a:cubicBezTo>
                          <a:pt x="152401" y="89504"/>
                          <a:pt x="185058" y="95552"/>
                          <a:pt x="217715" y="10160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82" name="Freeform 181"/>
                  <p:cNvSpPr/>
                  <p:nvPr/>
                </p:nvSpPr>
                <p:spPr>
                  <a:xfrm>
                    <a:off x="3207657" y="2104571"/>
                    <a:ext cx="246743" cy="33867"/>
                  </a:xfrm>
                  <a:custGeom>
                    <a:avLst/>
                    <a:gdLst>
                      <a:gd name="connsiteX0" fmla="*/ 0 w 246743"/>
                      <a:gd name="connsiteY0" fmla="*/ 29029 h 33867"/>
                      <a:gd name="connsiteX1" fmla="*/ 159657 w 246743"/>
                      <a:gd name="connsiteY1" fmla="*/ 29029 h 33867"/>
                      <a:gd name="connsiteX2" fmla="*/ 246743 w 246743"/>
                      <a:gd name="connsiteY2" fmla="*/ 0 h 33867"/>
                    </a:gdLst>
                    <a:ahLst/>
                    <a:cxnLst>
                      <a:cxn ang="0">
                        <a:pos x="connsiteX0" y="connsiteY0"/>
                      </a:cxn>
                      <a:cxn ang="0">
                        <a:pos x="connsiteX1" y="connsiteY1"/>
                      </a:cxn>
                      <a:cxn ang="0">
                        <a:pos x="connsiteX2" y="connsiteY2"/>
                      </a:cxn>
                    </a:cxnLst>
                    <a:rect l="l" t="t" r="r" b="b"/>
                    <a:pathLst>
                      <a:path w="246743" h="33867">
                        <a:moveTo>
                          <a:pt x="0" y="29029"/>
                        </a:moveTo>
                        <a:cubicBezTo>
                          <a:pt x="59266" y="31448"/>
                          <a:pt x="118533" y="33867"/>
                          <a:pt x="159657" y="29029"/>
                        </a:cubicBezTo>
                        <a:cubicBezTo>
                          <a:pt x="200781" y="24191"/>
                          <a:pt x="223762" y="12095"/>
                          <a:pt x="2467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grpSp>
              <p:nvGrpSpPr>
                <p:cNvPr id="128" name="Group 72"/>
                <p:cNvGrpSpPr/>
                <p:nvPr/>
              </p:nvGrpSpPr>
              <p:grpSpPr>
                <a:xfrm flipH="1">
                  <a:off x="683915" y="3933056"/>
                  <a:ext cx="1440160" cy="1180496"/>
                  <a:chOff x="2206171" y="1548190"/>
                  <a:chExt cx="1340152" cy="1180496"/>
                </a:xfrm>
              </p:grpSpPr>
              <p:sp>
                <p:nvSpPr>
                  <p:cNvPr id="167" name="Freeform 73"/>
                  <p:cNvSpPr/>
                  <p:nvPr/>
                </p:nvSpPr>
                <p:spPr>
                  <a:xfrm>
                    <a:off x="2206171" y="1548190"/>
                    <a:ext cx="1340152" cy="1180496"/>
                  </a:xfrm>
                  <a:custGeom>
                    <a:avLst/>
                    <a:gdLst>
                      <a:gd name="connsiteX0" fmla="*/ 0 w 1340152"/>
                      <a:gd name="connsiteY0" fmla="*/ 1180496 h 1180496"/>
                      <a:gd name="connsiteX1" fmla="*/ 290286 w 1340152"/>
                      <a:gd name="connsiteY1" fmla="*/ 962781 h 1180496"/>
                      <a:gd name="connsiteX2" fmla="*/ 653143 w 1340152"/>
                      <a:gd name="connsiteY2" fmla="*/ 1078896 h 1180496"/>
                      <a:gd name="connsiteX3" fmla="*/ 1204686 w 1340152"/>
                      <a:gd name="connsiteY3" fmla="*/ 832153 h 1180496"/>
                      <a:gd name="connsiteX4" fmla="*/ 1320800 w 1340152"/>
                      <a:gd name="connsiteY4" fmla="*/ 91924 h 1180496"/>
                      <a:gd name="connsiteX5" fmla="*/ 1088572 w 1340152"/>
                      <a:gd name="connsiteY5" fmla="*/ 280610 h 1180496"/>
                      <a:gd name="connsiteX6" fmla="*/ 638629 w 1340152"/>
                      <a:gd name="connsiteY6" fmla="*/ 396724 h 1180496"/>
                      <a:gd name="connsiteX7" fmla="*/ 391886 w 1340152"/>
                      <a:gd name="connsiteY7" fmla="*/ 745067 h 1180496"/>
                      <a:gd name="connsiteX8" fmla="*/ 319315 w 1340152"/>
                      <a:gd name="connsiteY8" fmla="*/ 919239 h 1180496"/>
                      <a:gd name="connsiteX9" fmla="*/ 58058 w 1340152"/>
                      <a:gd name="connsiteY9" fmla="*/ 1107924 h 11804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340152" h="1180496">
                        <a:moveTo>
                          <a:pt x="0" y="1180496"/>
                        </a:moveTo>
                        <a:cubicBezTo>
                          <a:pt x="90714" y="1080105"/>
                          <a:pt x="181429" y="979714"/>
                          <a:pt x="290286" y="962781"/>
                        </a:cubicBezTo>
                        <a:cubicBezTo>
                          <a:pt x="399143" y="945848"/>
                          <a:pt x="500743" y="1100667"/>
                          <a:pt x="653143" y="1078896"/>
                        </a:cubicBezTo>
                        <a:cubicBezTo>
                          <a:pt x="805543" y="1057125"/>
                          <a:pt x="1093410" y="996648"/>
                          <a:pt x="1204686" y="832153"/>
                        </a:cubicBezTo>
                        <a:cubicBezTo>
                          <a:pt x="1315962" y="667658"/>
                          <a:pt x="1340152" y="183848"/>
                          <a:pt x="1320800" y="91924"/>
                        </a:cubicBezTo>
                        <a:cubicBezTo>
                          <a:pt x="1301448" y="0"/>
                          <a:pt x="1202267" y="229810"/>
                          <a:pt x="1088572" y="280610"/>
                        </a:cubicBezTo>
                        <a:cubicBezTo>
                          <a:pt x="974877" y="331410"/>
                          <a:pt x="754743" y="319315"/>
                          <a:pt x="638629" y="396724"/>
                        </a:cubicBezTo>
                        <a:cubicBezTo>
                          <a:pt x="522515" y="474133"/>
                          <a:pt x="445105" y="657981"/>
                          <a:pt x="391886" y="745067"/>
                        </a:cubicBezTo>
                        <a:cubicBezTo>
                          <a:pt x="338667" y="832153"/>
                          <a:pt x="374953" y="858763"/>
                          <a:pt x="319315" y="919239"/>
                        </a:cubicBezTo>
                        <a:cubicBezTo>
                          <a:pt x="263677" y="979715"/>
                          <a:pt x="160867" y="1043819"/>
                          <a:pt x="58058" y="1107924"/>
                        </a:cubicBezTo>
                      </a:path>
                    </a:pathLst>
                  </a:custGeom>
                  <a:solidFill>
                    <a:srgbClr val="97E44A"/>
                  </a:solidFill>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68" name="Freeform 74"/>
                  <p:cNvSpPr/>
                  <p:nvPr/>
                </p:nvSpPr>
                <p:spPr>
                  <a:xfrm>
                    <a:off x="2525486" y="1669143"/>
                    <a:ext cx="996647" cy="812800"/>
                  </a:xfrm>
                  <a:custGeom>
                    <a:avLst/>
                    <a:gdLst>
                      <a:gd name="connsiteX0" fmla="*/ 0 w 996647"/>
                      <a:gd name="connsiteY0" fmla="*/ 812800 h 812800"/>
                      <a:gd name="connsiteX1" fmla="*/ 261257 w 996647"/>
                      <a:gd name="connsiteY1" fmla="*/ 696686 h 812800"/>
                      <a:gd name="connsiteX2" fmla="*/ 624114 w 996647"/>
                      <a:gd name="connsiteY2" fmla="*/ 449943 h 812800"/>
                      <a:gd name="connsiteX3" fmla="*/ 943428 w 996647"/>
                      <a:gd name="connsiteY3" fmla="*/ 116114 h 812800"/>
                      <a:gd name="connsiteX4" fmla="*/ 943428 w 996647"/>
                      <a:gd name="connsiteY4" fmla="*/ 0 h 8128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996647" h="812800">
                        <a:moveTo>
                          <a:pt x="0" y="812800"/>
                        </a:moveTo>
                        <a:cubicBezTo>
                          <a:pt x="78619" y="784981"/>
                          <a:pt x="157238" y="757162"/>
                          <a:pt x="261257" y="696686"/>
                        </a:cubicBezTo>
                        <a:cubicBezTo>
                          <a:pt x="365276" y="636210"/>
                          <a:pt x="510419" y="546705"/>
                          <a:pt x="624114" y="449943"/>
                        </a:cubicBezTo>
                        <a:cubicBezTo>
                          <a:pt x="737809" y="353181"/>
                          <a:pt x="890209" y="191104"/>
                          <a:pt x="943428" y="116114"/>
                        </a:cubicBezTo>
                        <a:cubicBezTo>
                          <a:pt x="996647" y="41124"/>
                          <a:pt x="970037" y="20562"/>
                          <a:pt x="943428"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69" name="Freeform 75"/>
                  <p:cNvSpPr/>
                  <p:nvPr/>
                </p:nvSpPr>
                <p:spPr>
                  <a:xfrm>
                    <a:off x="2931886" y="2336800"/>
                    <a:ext cx="319314" cy="154819"/>
                  </a:xfrm>
                  <a:custGeom>
                    <a:avLst/>
                    <a:gdLst>
                      <a:gd name="connsiteX0" fmla="*/ 0 w 319314"/>
                      <a:gd name="connsiteY0" fmla="*/ 0 h 154819"/>
                      <a:gd name="connsiteX1" fmla="*/ 87085 w 319314"/>
                      <a:gd name="connsiteY1" fmla="*/ 87086 h 154819"/>
                      <a:gd name="connsiteX2" fmla="*/ 232228 w 319314"/>
                      <a:gd name="connsiteY2" fmla="*/ 145143 h 154819"/>
                      <a:gd name="connsiteX3" fmla="*/ 319314 w 319314"/>
                      <a:gd name="connsiteY3" fmla="*/ 145143 h 154819"/>
                    </a:gdLst>
                    <a:ahLst/>
                    <a:cxnLst>
                      <a:cxn ang="0">
                        <a:pos x="connsiteX0" y="connsiteY0"/>
                      </a:cxn>
                      <a:cxn ang="0">
                        <a:pos x="connsiteX1" y="connsiteY1"/>
                      </a:cxn>
                      <a:cxn ang="0">
                        <a:pos x="connsiteX2" y="connsiteY2"/>
                      </a:cxn>
                      <a:cxn ang="0">
                        <a:pos x="connsiteX3" y="connsiteY3"/>
                      </a:cxn>
                    </a:cxnLst>
                    <a:rect l="l" t="t" r="r" b="b"/>
                    <a:pathLst>
                      <a:path w="319314" h="154819">
                        <a:moveTo>
                          <a:pt x="0" y="0"/>
                        </a:moveTo>
                        <a:cubicBezTo>
                          <a:pt x="24190" y="31448"/>
                          <a:pt x="48380" y="62896"/>
                          <a:pt x="87085" y="87086"/>
                        </a:cubicBezTo>
                        <a:cubicBezTo>
                          <a:pt x="125790" y="111276"/>
                          <a:pt x="193523" y="135467"/>
                          <a:pt x="232228" y="145143"/>
                        </a:cubicBezTo>
                        <a:cubicBezTo>
                          <a:pt x="270933" y="154819"/>
                          <a:pt x="295123" y="149981"/>
                          <a:pt x="319314" y="145143"/>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70" name="Freeform 76"/>
                  <p:cNvSpPr/>
                  <p:nvPr/>
                </p:nvSpPr>
                <p:spPr>
                  <a:xfrm>
                    <a:off x="3077029" y="2220686"/>
                    <a:ext cx="290285" cy="120952"/>
                  </a:xfrm>
                  <a:custGeom>
                    <a:avLst/>
                    <a:gdLst>
                      <a:gd name="connsiteX0" fmla="*/ 0 w 290285"/>
                      <a:gd name="connsiteY0" fmla="*/ 0 h 120952"/>
                      <a:gd name="connsiteX1" fmla="*/ 188685 w 290285"/>
                      <a:gd name="connsiteY1" fmla="*/ 101600 h 120952"/>
                      <a:gd name="connsiteX2" fmla="*/ 290285 w 290285"/>
                      <a:gd name="connsiteY2" fmla="*/ 116114 h 120952"/>
                    </a:gdLst>
                    <a:ahLst/>
                    <a:cxnLst>
                      <a:cxn ang="0">
                        <a:pos x="connsiteX0" y="connsiteY0"/>
                      </a:cxn>
                      <a:cxn ang="0">
                        <a:pos x="connsiteX1" y="connsiteY1"/>
                      </a:cxn>
                      <a:cxn ang="0">
                        <a:pos x="connsiteX2" y="connsiteY2"/>
                      </a:cxn>
                    </a:cxnLst>
                    <a:rect l="l" t="t" r="r" b="b"/>
                    <a:pathLst>
                      <a:path w="290285" h="120952">
                        <a:moveTo>
                          <a:pt x="0" y="0"/>
                        </a:moveTo>
                        <a:cubicBezTo>
                          <a:pt x="70152" y="41124"/>
                          <a:pt x="140304" y="82248"/>
                          <a:pt x="188685" y="101600"/>
                        </a:cubicBezTo>
                        <a:cubicBezTo>
                          <a:pt x="237066" y="120952"/>
                          <a:pt x="263675" y="118533"/>
                          <a:pt x="290285" y="116114"/>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71" name="Freeform 77"/>
                  <p:cNvSpPr/>
                  <p:nvPr/>
                </p:nvSpPr>
                <p:spPr>
                  <a:xfrm>
                    <a:off x="2743200" y="2119086"/>
                    <a:ext cx="14514" cy="275771"/>
                  </a:xfrm>
                  <a:custGeom>
                    <a:avLst/>
                    <a:gdLst>
                      <a:gd name="connsiteX0" fmla="*/ 14514 w 14514"/>
                      <a:gd name="connsiteY0" fmla="*/ 275771 h 275771"/>
                      <a:gd name="connsiteX1" fmla="*/ 0 w 14514"/>
                      <a:gd name="connsiteY1" fmla="*/ 174171 h 275771"/>
                      <a:gd name="connsiteX2" fmla="*/ 14514 w 14514"/>
                      <a:gd name="connsiteY2" fmla="*/ 0 h 275771"/>
                    </a:gdLst>
                    <a:ahLst/>
                    <a:cxnLst>
                      <a:cxn ang="0">
                        <a:pos x="connsiteX0" y="connsiteY0"/>
                      </a:cxn>
                      <a:cxn ang="0">
                        <a:pos x="connsiteX1" y="connsiteY1"/>
                      </a:cxn>
                      <a:cxn ang="0">
                        <a:pos x="connsiteX2" y="connsiteY2"/>
                      </a:cxn>
                    </a:cxnLst>
                    <a:rect l="l" t="t" r="r" b="b"/>
                    <a:pathLst>
                      <a:path w="14514" h="275771">
                        <a:moveTo>
                          <a:pt x="14514" y="275771"/>
                        </a:moveTo>
                        <a:cubicBezTo>
                          <a:pt x="7257" y="247952"/>
                          <a:pt x="0" y="220133"/>
                          <a:pt x="0" y="174171"/>
                        </a:cubicBezTo>
                        <a:cubicBezTo>
                          <a:pt x="0" y="128209"/>
                          <a:pt x="7257" y="64104"/>
                          <a:pt x="14514"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72" name="Freeform 78"/>
                  <p:cNvSpPr/>
                  <p:nvPr/>
                </p:nvSpPr>
                <p:spPr>
                  <a:xfrm>
                    <a:off x="2931886" y="1988457"/>
                    <a:ext cx="43543" cy="217714"/>
                  </a:xfrm>
                  <a:custGeom>
                    <a:avLst/>
                    <a:gdLst>
                      <a:gd name="connsiteX0" fmla="*/ 43543 w 43543"/>
                      <a:gd name="connsiteY0" fmla="*/ 217714 h 217714"/>
                      <a:gd name="connsiteX1" fmla="*/ 0 w 43543"/>
                      <a:gd name="connsiteY1" fmla="*/ 130629 h 217714"/>
                      <a:gd name="connsiteX2" fmla="*/ 43543 w 43543"/>
                      <a:gd name="connsiteY2" fmla="*/ 0 h 217714"/>
                    </a:gdLst>
                    <a:ahLst/>
                    <a:cxnLst>
                      <a:cxn ang="0">
                        <a:pos x="connsiteX0" y="connsiteY0"/>
                      </a:cxn>
                      <a:cxn ang="0">
                        <a:pos x="connsiteX1" y="connsiteY1"/>
                      </a:cxn>
                      <a:cxn ang="0">
                        <a:pos x="connsiteX2" y="connsiteY2"/>
                      </a:cxn>
                    </a:cxnLst>
                    <a:rect l="l" t="t" r="r" b="b"/>
                    <a:pathLst>
                      <a:path w="43543" h="217714">
                        <a:moveTo>
                          <a:pt x="43543" y="217714"/>
                        </a:moveTo>
                        <a:cubicBezTo>
                          <a:pt x="21771" y="192314"/>
                          <a:pt x="0" y="166915"/>
                          <a:pt x="0" y="130629"/>
                        </a:cubicBezTo>
                        <a:cubicBezTo>
                          <a:pt x="0" y="94343"/>
                          <a:pt x="21771" y="47171"/>
                          <a:pt x="435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73" name="Freeform 79"/>
                  <p:cNvSpPr/>
                  <p:nvPr/>
                </p:nvSpPr>
                <p:spPr>
                  <a:xfrm>
                    <a:off x="2714171" y="2467429"/>
                    <a:ext cx="217715" cy="101600"/>
                  </a:xfrm>
                  <a:custGeom>
                    <a:avLst/>
                    <a:gdLst>
                      <a:gd name="connsiteX0" fmla="*/ 0 w 217715"/>
                      <a:gd name="connsiteY0" fmla="*/ 0 h 101600"/>
                      <a:gd name="connsiteX1" fmla="*/ 116115 w 217715"/>
                      <a:gd name="connsiteY1" fmla="*/ 72571 h 101600"/>
                      <a:gd name="connsiteX2" fmla="*/ 217715 w 217715"/>
                      <a:gd name="connsiteY2" fmla="*/ 101600 h 101600"/>
                    </a:gdLst>
                    <a:ahLst/>
                    <a:cxnLst>
                      <a:cxn ang="0">
                        <a:pos x="connsiteX0" y="connsiteY0"/>
                      </a:cxn>
                      <a:cxn ang="0">
                        <a:pos x="connsiteX1" y="connsiteY1"/>
                      </a:cxn>
                      <a:cxn ang="0">
                        <a:pos x="connsiteX2" y="connsiteY2"/>
                      </a:cxn>
                    </a:cxnLst>
                    <a:rect l="l" t="t" r="r" b="b"/>
                    <a:pathLst>
                      <a:path w="217715" h="101600">
                        <a:moveTo>
                          <a:pt x="0" y="0"/>
                        </a:moveTo>
                        <a:cubicBezTo>
                          <a:pt x="39914" y="27819"/>
                          <a:pt x="79829" y="55638"/>
                          <a:pt x="116115" y="72571"/>
                        </a:cubicBezTo>
                        <a:cubicBezTo>
                          <a:pt x="152401" y="89504"/>
                          <a:pt x="185058" y="95552"/>
                          <a:pt x="217715" y="10160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74" name="Freeform 80"/>
                  <p:cNvSpPr/>
                  <p:nvPr/>
                </p:nvSpPr>
                <p:spPr>
                  <a:xfrm>
                    <a:off x="3207657" y="2104571"/>
                    <a:ext cx="246743" cy="33867"/>
                  </a:xfrm>
                  <a:custGeom>
                    <a:avLst/>
                    <a:gdLst>
                      <a:gd name="connsiteX0" fmla="*/ 0 w 246743"/>
                      <a:gd name="connsiteY0" fmla="*/ 29029 h 33867"/>
                      <a:gd name="connsiteX1" fmla="*/ 159657 w 246743"/>
                      <a:gd name="connsiteY1" fmla="*/ 29029 h 33867"/>
                      <a:gd name="connsiteX2" fmla="*/ 246743 w 246743"/>
                      <a:gd name="connsiteY2" fmla="*/ 0 h 33867"/>
                    </a:gdLst>
                    <a:ahLst/>
                    <a:cxnLst>
                      <a:cxn ang="0">
                        <a:pos x="connsiteX0" y="connsiteY0"/>
                      </a:cxn>
                      <a:cxn ang="0">
                        <a:pos x="connsiteX1" y="connsiteY1"/>
                      </a:cxn>
                      <a:cxn ang="0">
                        <a:pos x="connsiteX2" y="connsiteY2"/>
                      </a:cxn>
                    </a:cxnLst>
                    <a:rect l="l" t="t" r="r" b="b"/>
                    <a:pathLst>
                      <a:path w="246743" h="33867">
                        <a:moveTo>
                          <a:pt x="0" y="29029"/>
                        </a:moveTo>
                        <a:cubicBezTo>
                          <a:pt x="59266" y="31448"/>
                          <a:pt x="118533" y="33867"/>
                          <a:pt x="159657" y="29029"/>
                        </a:cubicBezTo>
                        <a:cubicBezTo>
                          <a:pt x="200781" y="24191"/>
                          <a:pt x="223762" y="12095"/>
                          <a:pt x="2467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grpSp>
              <p:nvGrpSpPr>
                <p:cNvPr id="129" name="Group 77"/>
                <p:cNvGrpSpPr>
                  <a:grpSpLocks/>
                </p:cNvGrpSpPr>
                <p:nvPr/>
              </p:nvGrpSpPr>
              <p:grpSpPr bwMode="auto">
                <a:xfrm>
                  <a:off x="1744662" y="476672"/>
                  <a:ext cx="758825" cy="5097462"/>
                  <a:chOff x="620688" y="3080792"/>
                  <a:chExt cx="896300" cy="5813162"/>
                </a:xfrm>
              </p:grpSpPr>
              <p:sp>
                <p:nvSpPr>
                  <p:cNvPr id="139" name="Isosceles Triangle 6"/>
                  <p:cNvSpPr/>
                  <p:nvPr/>
                </p:nvSpPr>
                <p:spPr>
                  <a:xfrm>
                    <a:off x="1074463" y="3205708"/>
                    <a:ext cx="144384" cy="5688246"/>
                  </a:xfrm>
                  <a:prstGeom prst="triangle">
                    <a:avLst/>
                  </a:prstGeom>
                  <a:solidFill>
                    <a:srgbClr val="CCFF66"/>
                  </a:solidFill>
                  <a:ln w="1270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400"/>
                  </a:p>
                </p:txBody>
              </p:sp>
              <p:grpSp>
                <p:nvGrpSpPr>
                  <p:cNvPr id="140" name="Group 139"/>
                  <p:cNvGrpSpPr/>
                  <p:nvPr/>
                </p:nvGrpSpPr>
                <p:grpSpPr>
                  <a:xfrm rot="2429880">
                    <a:off x="1154131" y="5771563"/>
                    <a:ext cx="362857" cy="599924"/>
                    <a:chOff x="3899505" y="4414762"/>
                    <a:chExt cx="362857" cy="599924"/>
                  </a:xfrm>
                  <a:solidFill>
                    <a:srgbClr val="CCFF66"/>
                  </a:solidFill>
                </p:grpSpPr>
                <p:sp>
                  <p:nvSpPr>
                    <p:cNvPr id="165" name="Freeform 164"/>
                    <p:cNvSpPr/>
                    <p:nvPr/>
                  </p:nvSpPr>
                  <p:spPr>
                    <a:xfrm>
                      <a:off x="3899505" y="4414762"/>
                      <a:ext cx="362857" cy="599924"/>
                    </a:xfrm>
                    <a:custGeom>
                      <a:avLst/>
                      <a:gdLst>
                        <a:gd name="connsiteX0" fmla="*/ 48381 w 362857"/>
                        <a:gd name="connsiteY0" fmla="*/ 505581 h 599924"/>
                        <a:gd name="connsiteX1" fmla="*/ 19352 w 362857"/>
                        <a:gd name="connsiteY1" fmla="*/ 258838 h 599924"/>
                        <a:gd name="connsiteX2" fmla="*/ 164495 w 362857"/>
                        <a:gd name="connsiteY2" fmla="*/ 84667 h 599924"/>
                        <a:gd name="connsiteX3" fmla="*/ 237066 w 362857"/>
                        <a:gd name="connsiteY3" fmla="*/ 12095 h 599924"/>
                        <a:gd name="connsiteX4" fmla="*/ 324152 w 362857"/>
                        <a:gd name="connsiteY4" fmla="*/ 157238 h 599924"/>
                        <a:gd name="connsiteX5" fmla="*/ 353181 w 362857"/>
                        <a:gd name="connsiteY5" fmla="*/ 331409 h 599924"/>
                        <a:gd name="connsiteX6" fmla="*/ 266095 w 362857"/>
                        <a:gd name="connsiteY6" fmla="*/ 563638 h 599924"/>
                        <a:gd name="connsiteX7" fmla="*/ 193524 w 362857"/>
                        <a:gd name="connsiteY7" fmla="*/ 549124 h 599924"/>
                        <a:gd name="connsiteX8" fmla="*/ 48381 w 362857"/>
                        <a:gd name="connsiteY8" fmla="*/ 505581 h 5999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62857" h="599924">
                          <a:moveTo>
                            <a:pt x="48381" y="505581"/>
                          </a:moveTo>
                          <a:cubicBezTo>
                            <a:pt x="24190" y="417285"/>
                            <a:pt x="0" y="328990"/>
                            <a:pt x="19352" y="258838"/>
                          </a:cubicBezTo>
                          <a:cubicBezTo>
                            <a:pt x="38704" y="188686"/>
                            <a:pt x="128209" y="125791"/>
                            <a:pt x="164495" y="84667"/>
                          </a:cubicBezTo>
                          <a:cubicBezTo>
                            <a:pt x="200781" y="43543"/>
                            <a:pt x="210457" y="0"/>
                            <a:pt x="237066" y="12095"/>
                          </a:cubicBezTo>
                          <a:cubicBezTo>
                            <a:pt x="263675" y="24190"/>
                            <a:pt x="304800" y="104019"/>
                            <a:pt x="324152" y="157238"/>
                          </a:cubicBezTo>
                          <a:cubicBezTo>
                            <a:pt x="343504" y="210457"/>
                            <a:pt x="362857" y="263676"/>
                            <a:pt x="353181" y="331409"/>
                          </a:cubicBezTo>
                          <a:cubicBezTo>
                            <a:pt x="343505" y="399142"/>
                            <a:pt x="292704" y="527352"/>
                            <a:pt x="266095" y="563638"/>
                          </a:cubicBezTo>
                          <a:cubicBezTo>
                            <a:pt x="239486" y="599924"/>
                            <a:pt x="193524" y="549124"/>
                            <a:pt x="193524" y="549124"/>
                          </a:cubicBezTo>
                          <a:lnTo>
                            <a:pt x="48381" y="505581"/>
                          </a:lnTo>
                          <a:close/>
                        </a:path>
                      </a:pathLst>
                    </a:custGeom>
                    <a:grp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400"/>
                    </a:p>
                  </p:txBody>
                </p:sp>
                <p:sp>
                  <p:nvSpPr>
                    <p:cNvPr id="166" name="Freeform 165"/>
                    <p:cNvSpPr/>
                    <p:nvPr/>
                  </p:nvSpPr>
                  <p:spPr>
                    <a:xfrm>
                      <a:off x="3959981" y="4630057"/>
                      <a:ext cx="292705" cy="304800"/>
                    </a:xfrm>
                    <a:custGeom>
                      <a:avLst/>
                      <a:gdLst>
                        <a:gd name="connsiteX0" fmla="*/ 16933 w 292705"/>
                        <a:gd name="connsiteY0" fmla="*/ 304800 h 304800"/>
                        <a:gd name="connsiteX1" fmla="*/ 45962 w 292705"/>
                        <a:gd name="connsiteY1" fmla="*/ 130629 h 304800"/>
                        <a:gd name="connsiteX2" fmla="*/ 292705 w 292705"/>
                        <a:gd name="connsiteY2" fmla="*/ 0 h 304800"/>
                      </a:gdLst>
                      <a:ahLst/>
                      <a:cxnLst>
                        <a:cxn ang="0">
                          <a:pos x="connsiteX0" y="connsiteY0"/>
                        </a:cxn>
                        <a:cxn ang="0">
                          <a:pos x="connsiteX1" y="connsiteY1"/>
                        </a:cxn>
                        <a:cxn ang="0">
                          <a:pos x="connsiteX2" y="connsiteY2"/>
                        </a:cxn>
                      </a:cxnLst>
                      <a:rect l="l" t="t" r="r" b="b"/>
                      <a:pathLst>
                        <a:path w="292705" h="304800">
                          <a:moveTo>
                            <a:pt x="16933" y="304800"/>
                          </a:moveTo>
                          <a:cubicBezTo>
                            <a:pt x="8466" y="243114"/>
                            <a:pt x="0" y="181429"/>
                            <a:pt x="45962" y="130629"/>
                          </a:cubicBezTo>
                          <a:cubicBezTo>
                            <a:pt x="91924" y="79829"/>
                            <a:pt x="192314" y="39914"/>
                            <a:pt x="292705" y="0"/>
                          </a:cubicBezTo>
                        </a:path>
                      </a:pathLst>
                    </a:custGeom>
                    <a:grpFill/>
                    <a:ln w="12700">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en-US" sz="1400"/>
                    </a:p>
                  </p:txBody>
                </p:sp>
              </p:grpSp>
              <p:grpSp>
                <p:nvGrpSpPr>
                  <p:cNvPr id="141" name="Group 140"/>
                  <p:cNvGrpSpPr/>
                  <p:nvPr/>
                </p:nvGrpSpPr>
                <p:grpSpPr>
                  <a:xfrm rot="18280728">
                    <a:off x="739221" y="6537597"/>
                    <a:ext cx="362857" cy="599924"/>
                    <a:chOff x="3899505" y="4414762"/>
                    <a:chExt cx="362857" cy="599924"/>
                  </a:xfrm>
                  <a:solidFill>
                    <a:srgbClr val="CCFF66"/>
                  </a:solidFill>
                </p:grpSpPr>
                <p:sp>
                  <p:nvSpPr>
                    <p:cNvPr id="163" name="Freeform 30"/>
                    <p:cNvSpPr/>
                    <p:nvPr/>
                  </p:nvSpPr>
                  <p:spPr>
                    <a:xfrm>
                      <a:off x="3899505" y="4414762"/>
                      <a:ext cx="362857" cy="599924"/>
                    </a:xfrm>
                    <a:custGeom>
                      <a:avLst/>
                      <a:gdLst>
                        <a:gd name="connsiteX0" fmla="*/ 48381 w 362857"/>
                        <a:gd name="connsiteY0" fmla="*/ 505581 h 599924"/>
                        <a:gd name="connsiteX1" fmla="*/ 19352 w 362857"/>
                        <a:gd name="connsiteY1" fmla="*/ 258838 h 599924"/>
                        <a:gd name="connsiteX2" fmla="*/ 164495 w 362857"/>
                        <a:gd name="connsiteY2" fmla="*/ 84667 h 599924"/>
                        <a:gd name="connsiteX3" fmla="*/ 237066 w 362857"/>
                        <a:gd name="connsiteY3" fmla="*/ 12095 h 599924"/>
                        <a:gd name="connsiteX4" fmla="*/ 324152 w 362857"/>
                        <a:gd name="connsiteY4" fmla="*/ 157238 h 599924"/>
                        <a:gd name="connsiteX5" fmla="*/ 353181 w 362857"/>
                        <a:gd name="connsiteY5" fmla="*/ 331409 h 599924"/>
                        <a:gd name="connsiteX6" fmla="*/ 266095 w 362857"/>
                        <a:gd name="connsiteY6" fmla="*/ 563638 h 599924"/>
                        <a:gd name="connsiteX7" fmla="*/ 193524 w 362857"/>
                        <a:gd name="connsiteY7" fmla="*/ 549124 h 599924"/>
                        <a:gd name="connsiteX8" fmla="*/ 48381 w 362857"/>
                        <a:gd name="connsiteY8" fmla="*/ 505581 h 5999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62857" h="599924">
                          <a:moveTo>
                            <a:pt x="48381" y="505581"/>
                          </a:moveTo>
                          <a:cubicBezTo>
                            <a:pt x="24190" y="417285"/>
                            <a:pt x="0" y="328990"/>
                            <a:pt x="19352" y="258838"/>
                          </a:cubicBezTo>
                          <a:cubicBezTo>
                            <a:pt x="38704" y="188686"/>
                            <a:pt x="128209" y="125791"/>
                            <a:pt x="164495" y="84667"/>
                          </a:cubicBezTo>
                          <a:cubicBezTo>
                            <a:pt x="200781" y="43543"/>
                            <a:pt x="210457" y="0"/>
                            <a:pt x="237066" y="12095"/>
                          </a:cubicBezTo>
                          <a:cubicBezTo>
                            <a:pt x="263675" y="24190"/>
                            <a:pt x="304800" y="104019"/>
                            <a:pt x="324152" y="157238"/>
                          </a:cubicBezTo>
                          <a:cubicBezTo>
                            <a:pt x="343504" y="210457"/>
                            <a:pt x="362857" y="263676"/>
                            <a:pt x="353181" y="331409"/>
                          </a:cubicBezTo>
                          <a:cubicBezTo>
                            <a:pt x="343505" y="399142"/>
                            <a:pt x="292704" y="527352"/>
                            <a:pt x="266095" y="563638"/>
                          </a:cubicBezTo>
                          <a:cubicBezTo>
                            <a:pt x="239486" y="599924"/>
                            <a:pt x="193524" y="549124"/>
                            <a:pt x="193524" y="549124"/>
                          </a:cubicBezTo>
                          <a:lnTo>
                            <a:pt x="48381" y="505581"/>
                          </a:lnTo>
                          <a:close/>
                        </a:path>
                      </a:pathLst>
                    </a:custGeom>
                    <a:grp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400"/>
                    </a:p>
                  </p:txBody>
                </p:sp>
                <p:sp>
                  <p:nvSpPr>
                    <p:cNvPr id="164" name="Freeform 163"/>
                    <p:cNvSpPr/>
                    <p:nvPr/>
                  </p:nvSpPr>
                  <p:spPr>
                    <a:xfrm>
                      <a:off x="3959981" y="4630057"/>
                      <a:ext cx="292705" cy="304800"/>
                    </a:xfrm>
                    <a:custGeom>
                      <a:avLst/>
                      <a:gdLst>
                        <a:gd name="connsiteX0" fmla="*/ 16933 w 292705"/>
                        <a:gd name="connsiteY0" fmla="*/ 304800 h 304800"/>
                        <a:gd name="connsiteX1" fmla="*/ 45962 w 292705"/>
                        <a:gd name="connsiteY1" fmla="*/ 130629 h 304800"/>
                        <a:gd name="connsiteX2" fmla="*/ 292705 w 292705"/>
                        <a:gd name="connsiteY2" fmla="*/ 0 h 304800"/>
                      </a:gdLst>
                      <a:ahLst/>
                      <a:cxnLst>
                        <a:cxn ang="0">
                          <a:pos x="connsiteX0" y="connsiteY0"/>
                        </a:cxn>
                        <a:cxn ang="0">
                          <a:pos x="connsiteX1" y="connsiteY1"/>
                        </a:cxn>
                        <a:cxn ang="0">
                          <a:pos x="connsiteX2" y="connsiteY2"/>
                        </a:cxn>
                      </a:cxnLst>
                      <a:rect l="l" t="t" r="r" b="b"/>
                      <a:pathLst>
                        <a:path w="292705" h="304800">
                          <a:moveTo>
                            <a:pt x="16933" y="304800"/>
                          </a:moveTo>
                          <a:cubicBezTo>
                            <a:pt x="8466" y="243114"/>
                            <a:pt x="0" y="181429"/>
                            <a:pt x="45962" y="130629"/>
                          </a:cubicBezTo>
                          <a:cubicBezTo>
                            <a:pt x="91924" y="79829"/>
                            <a:pt x="192314" y="39914"/>
                            <a:pt x="292705" y="0"/>
                          </a:cubicBezTo>
                        </a:path>
                      </a:pathLst>
                    </a:custGeom>
                    <a:grpFill/>
                    <a:ln w="12700">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en-US" sz="1400"/>
                    </a:p>
                  </p:txBody>
                </p:sp>
              </p:grpSp>
              <p:grpSp>
                <p:nvGrpSpPr>
                  <p:cNvPr id="142" name="Group 25"/>
                  <p:cNvGrpSpPr/>
                  <p:nvPr/>
                </p:nvGrpSpPr>
                <p:grpSpPr>
                  <a:xfrm rot="18462427">
                    <a:off x="866419" y="5228094"/>
                    <a:ext cx="269765" cy="515813"/>
                    <a:chOff x="3899505" y="4414762"/>
                    <a:chExt cx="362857" cy="599924"/>
                  </a:xfrm>
                  <a:solidFill>
                    <a:srgbClr val="CCFF66"/>
                  </a:solidFill>
                </p:grpSpPr>
                <p:sp>
                  <p:nvSpPr>
                    <p:cNvPr id="161" name="Freeform 28"/>
                    <p:cNvSpPr/>
                    <p:nvPr/>
                  </p:nvSpPr>
                  <p:spPr>
                    <a:xfrm>
                      <a:off x="3899505" y="4414762"/>
                      <a:ext cx="362857" cy="599924"/>
                    </a:xfrm>
                    <a:custGeom>
                      <a:avLst/>
                      <a:gdLst>
                        <a:gd name="connsiteX0" fmla="*/ 48381 w 362857"/>
                        <a:gd name="connsiteY0" fmla="*/ 505581 h 599924"/>
                        <a:gd name="connsiteX1" fmla="*/ 19352 w 362857"/>
                        <a:gd name="connsiteY1" fmla="*/ 258838 h 599924"/>
                        <a:gd name="connsiteX2" fmla="*/ 164495 w 362857"/>
                        <a:gd name="connsiteY2" fmla="*/ 84667 h 599924"/>
                        <a:gd name="connsiteX3" fmla="*/ 237066 w 362857"/>
                        <a:gd name="connsiteY3" fmla="*/ 12095 h 599924"/>
                        <a:gd name="connsiteX4" fmla="*/ 324152 w 362857"/>
                        <a:gd name="connsiteY4" fmla="*/ 157238 h 599924"/>
                        <a:gd name="connsiteX5" fmla="*/ 353181 w 362857"/>
                        <a:gd name="connsiteY5" fmla="*/ 331409 h 599924"/>
                        <a:gd name="connsiteX6" fmla="*/ 266095 w 362857"/>
                        <a:gd name="connsiteY6" fmla="*/ 563638 h 599924"/>
                        <a:gd name="connsiteX7" fmla="*/ 193524 w 362857"/>
                        <a:gd name="connsiteY7" fmla="*/ 549124 h 599924"/>
                        <a:gd name="connsiteX8" fmla="*/ 48381 w 362857"/>
                        <a:gd name="connsiteY8" fmla="*/ 505581 h 5999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62857" h="599924">
                          <a:moveTo>
                            <a:pt x="48381" y="505581"/>
                          </a:moveTo>
                          <a:cubicBezTo>
                            <a:pt x="24190" y="417285"/>
                            <a:pt x="0" y="328990"/>
                            <a:pt x="19352" y="258838"/>
                          </a:cubicBezTo>
                          <a:cubicBezTo>
                            <a:pt x="38704" y="188686"/>
                            <a:pt x="128209" y="125791"/>
                            <a:pt x="164495" y="84667"/>
                          </a:cubicBezTo>
                          <a:cubicBezTo>
                            <a:pt x="200781" y="43543"/>
                            <a:pt x="210457" y="0"/>
                            <a:pt x="237066" y="12095"/>
                          </a:cubicBezTo>
                          <a:cubicBezTo>
                            <a:pt x="263675" y="24190"/>
                            <a:pt x="304800" y="104019"/>
                            <a:pt x="324152" y="157238"/>
                          </a:cubicBezTo>
                          <a:cubicBezTo>
                            <a:pt x="343504" y="210457"/>
                            <a:pt x="362857" y="263676"/>
                            <a:pt x="353181" y="331409"/>
                          </a:cubicBezTo>
                          <a:cubicBezTo>
                            <a:pt x="343505" y="399142"/>
                            <a:pt x="292704" y="527352"/>
                            <a:pt x="266095" y="563638"/>
                          </a:cubicBezTo>
                          <a:cubicBezTo>
                            <a:pt x="239486" y="599924"/>
                            <a:pt x="193524" y="549124"/>
                            <a:pt x="193524" y="549124"/>
                          </a:cubicBezTo>
                          <a:lnTo>
                            <a:pt x="48381" y="505581"/>
                          </a:lnTo>
                          <a:close/>
                        </a:path>
                      </a:pathLst>
                    </a:custGeom>
                    <a:grp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400"/>
                    </a:p>
                  </p:txBody>
                </p:sp>
                <p:sp>
                  <p:nvSpPr>
                    <p:cNvPr id="162" name="Freeform 29"/>
                    <p:cNvSpPr/>
                    <p:nvPr/>
                  </p:nvSpPr>
                  <p:spPr>
                    <a:xfrm>
                      <a:off x="3959981" y="4630057"/>
                      <a:ext cx="292705" cy="304800"/>
                    </a:xfrm>
                    <a:custGeom>
                      <a:avLst/>
                      <a:gdLst>
                        <a:gd name="connsiteX0" fmla="*/ 16933 w 292705"/>
                        <a:gd name="connsiteY0" fmla="*/ 304800 h 304800"/>
                        <a:gd name="connsiteX1" fmla="*/ 45962 w 292705"/>
                        <a:gd name="connsiteY1" fmla="*/ 130629 h 304800"/>
                        <a:gd name="connsiteX2" fmla="*/ 292705 w 292705"/>
                        <a:gd name="connsiteY2" fmla="*/ 0 h 304800"/>
                      </a:gdLst>
                      <a:ahLst/>
                      <a:cxnLst>
                        <a:cxn ang="0">
                          <a:pos x="connsiteX0" y="connsiteY0"/>
                        </a:cxn>
                        <a:cxn ang="0">
                          <a:pos x="connsiteX1" y="connsiteY1"/>
                        </a:cxn>
                        <a:cxn ang="0">
                          <a:pos x="connsiteX2" y="connsiteY2"/>
                        </a:cxn>
                      </a:cxnLst>
                      <a:rect l="l" t="t" r="r" b="b"/>
                      <a:pathLst>
                        <a:path w="292705" h="304800">
                          <a:moveTo>
                            <a:pt x="16933" y="304800"/>
                          </a:moveTo>
                          <a:cubicBezTo>
                            <a:pt x="8466" y="243114"/>
                            <a:pt x="0" y="181429"/>
                            <a:pt x="45962" y="130629"/>
                          </a:cubicBezTo>
                          <a:cubicBezTo>
                            <a:pt x="91924" y="79829"/>
                            <a:pt x="192314" y="39914"/>
                            <a:pt x="292705" y="0"/>
                          </a:cubicBezTo>
                        </a:path>
                      </a:pathLst>
                    </a:custGeom>
                    <a:grpFill/>
                    <a:ln w="12700">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en-US" sz="1400"/>
                    </a:p>
                  </p:txBody>
                </p:sp>
              </p:grpSp>
              <p:grpSp>
                <p:nvGrpSpPr>
                  <p:cNvPr id="143" name="Group 28"/>
                  <p:cNvGrpSpPr>
                    <a:grpSpLocks noChangeAspect="1"/>
                  </p:cNvGrpSpPr>
                  <p:nvPr/>
                </p:nvGrpSpPr>
                <p:grpSpPr>
                  <a:xfrm rot="2764909">
                    <a:off x="1174002" y="4624506"/>
                    <a:ext cx="215054" cy="376679"/>
                    <a:chOff x="3899505" y="4414762"/>
                    <a:chExt cx="362857" cy="599924"/>
                  </a:xfrm>
                  <a:solidFill>
                    <a:srgbClr val="CCFF66"/>
                  </a:solidFill>
                </p:grpSpPr>
                <p:sp>
                  <p:nvSpPr>
                    <p:cNvPr id="159" name="Freeform 26"/>
                    <p:cNvSpPr/>
                    <p:nvPr/>
                  </p:nvSpPr>
                  <p:spPr>
                    <a:xfrm>
                      <a:off x="3899505" y="4414762"/>
                      <a:ext cx="362857" cy="599924"/>
                    </a:xfrm>
                    <a:custGeom>
                      <a:avLst/>
                      <a:gdLst>
                        <a:gd name="connsiteX0" fmla="*/ 48381 w 362857"/>
                        <a:gd name="connsiteY0" fmla="*/ 505581 h 599924"/>
                        <a:gd name="connsiteX1" fmla="*/ 19352 w 362857"/>
                        <a:gd name="connsiteY1" fmla="*/ 258838 h 599924"/>
                        <a:gd name="connsiteX2" fmla="*/ 164495 w 362857"/>
                        <a:gd name="connsiteY2" fmla="*/ 84667 h 599924"/>
                        <a:gd name="connsiteX3" fmla="*/ 237066 w 362857"/>
                        <a:gd name="connsiteY3" fmla="*/ 12095 h 599924"/>
                        <a:gd name="connsiteX4" fmla="*/ 324152 w 362857"/>
                        <a:gd name="connsiteY4" fmla="*/ 157238 h 599924"/>
                        <a:gd name="connsiteX5" fmla="*/ 353181 w 362857"/>
                        <a:gd name="connsiteY5" fmla="*/ 331409 h 599924"/>
                        <a:gd name="connsiteX6" fmla="*/ 266095 w 362857"/>
                        <a:gd name="connsiteY6" fmla="*/ 563638 h 599924"/>
                        <a:gd name="connsiteX7" fmla="*/ 193524 w 362857"/>
                        <a:gd name="connsiteY7" fmla="*/ 549124 h 599924"/>
                        <a:gd name="connsiteX8" fmla="*/ 48381 w 362857"/>
                        <a:gd name="connsiteY8" fmla="*/ 505581 h 5999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62857" h="599924">
                          <a:moveTo>
                            <a:pt x="48381" y="505581"/>
                          </a:moveTo>
                          <a:cubicBezTo>
                            <a:pt x="24190" y="417285"/>
                            <a:pt x="0" y="328990"/>
                            <a:pt x="19352" y="258838"/>
                          </a:cubicBezTo>
                          <a:cubicBezTo>
                            <a:pt x="38704" y="188686"/>
                            <a:pt x="128209" y="125791"/>
                            <a:pt x="164495" y="84667"/>
                          </a:cubicBezTo>
                          <a:cubicBezTo>
                            <a:pt x="200781" y="43543"/>
                            <a:pt x="210457" y="0"/>
                            <a:pt x="237066" y="12095"/>
                          </a:cubicBezTo>
                          <a:cubicBezTo>
                            <a:pt x="263675" y="24190"/>
                            <a:pt x="304800" y="104019"/>
                            <a:pt x="324152" y="157238"/>
                          </a:cubicBezTo>
                          <a:cubicBezTo>
                            <a:pt x="343504" y="210457"/>
                            <a:pt x="362857" y="263676"/>
                            <a:pt x="353181" y="331409"/>
                          </a:cubicBezTo>
                          <a:cubicBezTo>
                            <a:pt x="343505" y="399142"/>
                            <a:pt x="292704" y="527352"/>
                            <a:pt x="266095" y="563638"/>
                          </a:cubicBezTo>
                          <a:cubicBezTo>
                            <a:pt x="239486" y="599924"/>
                            <a:pt x="193524" y="549124"/>
                            <a:pt x="193524" y="549124"/>
                          </a:cubicBezTo>
                          <a:lnTo>
                            <a:pt x="48381" y="505581"/>
                          </a:lnTo>
                          <a:close/>
                        </a:path>
                      </a:pathLst>
                    </a:custGeom>
                    <a:grp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400"/>
                    </a:p>
                  </p:txBody>
                </p:sp>
                <p:sp>
                  <p:nvSpPr>
                    <p:cNvPr id="160" name="Freeform 27"/>
                    <p:cNvSpPr/>
                    <p:nvPr/>
                  </p:nvSpPr>
                  <p:spPr>
                    <a:xfrm>
                      <a:off x="3959981" y="4630057"/>
                      <a:ext cx="292705" cy="304800"/>
                    </a:xfrm>
                    <a:custGeom>
                      <a:avLst/>
                      <a:gdLst>
                        <a:gd name="connsiteX0" fmla="*/ 16933 w 292705"/>
                        <a:gd name="connsiteY0" fmla="*/ 304800 h 304800"/>
                        <a:gd name="connsiteX1" fmla="*/ 45962 w 292705"/>
                        <a:gd name="connsiteY1" fmla="*/ 130629 h 304800"/>
                        <a:gd name="connsiteX2" fmla="*/ 292705 w 292705"/>
                        <a:gd name="connsiteY2" fmla="*/ 0 h 304800"/>
                      </a:gdLst>
                      <a:ahLst/>
                      <a:cxnLst>
                        <a:cxn ang="0">
                          <a:pos x="connsiteX0" y="connsiteY0"/>
                        </a:cxn>
                        <a:cxn ang="0">
                          <a:pos x="connsiteX1" y="connsiteY1"/>
                        </a:cxn>
                        <a:cxn ang="0">
                          <a:pos x="connsiteX2" y="connsiteY2"/>
                        </a:cxn>
                      </a:cxnLst>
                      <a:rect l="l" t="t" r="r" b="b"/>
                      <a:pathLst>
                        <a:path w="292705" h="304800">
                          <a:moveTo>
                            <a:pt x="16933" y="304800"/>
                          </a:moveTo>
                          <a:cubicBezTo>
                            <a:pt x="8466" y="243114"/>
                            <a:pt x="0" y="181429"/>
                            <a:pt x="45962" y="130629"/>
                          </a:cubicBezTo>
                          <a:cubicBezTo>
                            <a:pt x="91924" y="79829"/>
                            <a:pt x="192314" y="39914"/>
                            <a:pt x="292705" y="0"/>
                          </a:cubicBezTo>
                        </a:path>
                      </a:pathLst>
                    </a:custGeom>
                    <a:grpFill/>
                    <a:ln w="12700">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en-US" sz="1400"/>
                    </a:p>
                  </p:txBody>
                </p:sp>
              </p:grpSp>
              <p:grpSp>
                <p:nvGrpSpPr>
                  <p:cNvPr id="144" name="Group 31"/>
                  <p:cNvGrpSpPr/>
                  <p:nvPr/>
                </p:nvGrpSpPr>
                <p:grpSpPr>
                  <a:xfrm rot="2429880">
                    <a:off x="1154131" y="7139715"/>
                    <a:ext cx="362857" cy="599924"/>
                    <a:chOff x="3899505" y="4414762"/>
                    <a:chExt cx="362857" cy="599924"/>
                  </a:xfrm>
                  <a:solidFill>
                    <a:srgbClr val="CCFF66"/>
                  </a:solidFill>
                </p:grpSpPr>
                <p:sp>
                  <p:nvSpPr>
                    <p:cNvPr id="157" name="Freeform 24"/>
                    <p:cNvSpPr/>
                    <p:nvPr/>
                  </p:nvSpPr>
                  <p:spPr>
                    <a:xfrm>
                      <a:off x="3899505" y="4414762"/>
                      <a:ext cx="362857" cy="599924"/>
                    </a:xfrm>
                    <a:custGeom>
                      <a:avLst/>
                      <a:gdLst>
                        <a:gd name="connsiteX0" fmla="*/ 48381 w 362857"/>
                        <a:gd name="connsiteY0" fmla="*/ 505581 h 599924"/>
                        <a:gd name="connsiteX1" fmla="*/ 19352 w 362857"/>
                        <a:gd name="connsiteY1" fmla="*/ 258838 h 599924"/>
                        <a:gd name="connsiteX2" fmla="*/ 164495 w 362857"/>
                        <a:gd name="connsiteY2" fmla="*/ 84667 h 599924"/>
                        <a:gd name="connsiteX3" fmla="*/ 237066 w 362857"/>
                        <a:gd name="connsiteY3" fmla="*/ 12095 h 599924"/>
                        <a:gd name="connsiteX4" fmla="*/ 324152 w 362857"/>
                        <a:gd name="connsiteY4" fmla="*/ 157238 h 599924"/>
                        <a:gd name="connsiteX5" fmla="*/ 353181 w 362857"/>
                        <a:gd name="connsiteY5" fmla="*/ 331409 h 599924"/>
                        <a:gd name="connsiteX6" fmla="*/ 266095 w 362857"/>
                        <a:gd name="connsiteY6" fmla="*/ 563638 h 599924"/>
                        <a:gd name="connsiteX7" fmla="*/ 193524 w 362857"/>
                        <a:gd name="connsiteY7" fmla="*/ 549124 h 599924"/>
                        <a:gd name="connsiteX8" fmla="*/ 48381 w 362857"/>
                        <a:gd name="connsiteY8" fmla="*/ 505581 h 5999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62857" h="599924">
                          <a:moveTo>
                            <a:pt x="48381" y="505581"/>
                          </a:moveTo>
                          <a:cubicBezTo>
                            <a:pt x="24190" y="417285"/>
                            <a:pt x="0" y="328990"/>
                            <a:pt x="19352" y="258838"/>
                          </a:cubicBezTo>
                          <a:cubicBezTo>
                            <a:pt x="38704" y="188686"/>
                            <a:pt x="128209" y="125791"/>
                            <a:pt x="164495" y="84667"/>
                          </a:cubicBezTo>
                          <a:cubicBezTo>
                            <a:pt x="200781" y="43543"/>
                            <a:pt x="210457" y="0"/>
                            <a:pt x="237066" y="12095"/>
                          </a:cubicBezTo>
                          <a:cubicBezTo>
                            <a:pt x="263675" y="24190"/>
                            <a:pt x="304800" y="104019"/>
                            <a:pt x="324152" y="157238"/>
                          </a:cubicBezTo>
                          <a:cubicBezTo>
                            <a:pt x="343504" y="210457"/>
                            <a:pt x="362857" y="263676"/>
                            <a:pt x="353181" y="331409"/>
                          </a:cubicBezTo>
                          <a:cubicBezTo>
                            <a:pt x="343505" y="399142"/>
                            <a:pt x="292704" y="527352"/>
                            <a:pt x="266095" y="563638"/>
                          </a:cubicBezTo>
                          <a:cubicBezTo>
                            <a:pt x="239486" y="599924"/>
                            <a:pt x="193524" y="549124"/>
                            <a:pt x="193524" y="549124"/>
                          </a:cubicBezTo>
                          <a:lnTo>
                            <a:pt x="48381" y="505581"/>
                          </a:lnTo>
                          <a:close/>
                        </a:path>
                      </a:pathLst>
                    </a:custGeom>
                    <a:grp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400"/>
                    </a:p>
                  </p:txBody>
                </p:sp>
                <p:sp>
                  <p:nvSpPr>
                    <p:cNvPr id="158" name="Freeform 25"/>
                    <p:cNvSpPr/>
                    <p:nvPr/>
                  </p:nvSpPr>
                  <p:spPr>
                    <a:xfrm>
                      <a:off x="3959981" y="4630057"/>
                      <a:ext cx="292705" cy="304800"/>
                    </a:xfrm>
                    <a:custGeom>
                      <a:avLst/>
                      <a:gdLst>
                        <a:gd name="connsiteX0" fmla="*/ 16933 w 292705"/>
                        <a:gd name="connsiteY0" fmla="*/ 304800 h 304800"/>
                        <a:gd name="connsiteX1" fmla="*/ 45962 w 292705"/>
                        <a:gd name="connsiteY1" fmla="*/ 130629 h 304800"/>
                        <a:gd name="connsiteX2" fmla="*/ 292705 w 292705"/>
                        <a:gd name="connsiteY2" fmla="*/ 0 h 304800"/>
                      </a:gdLst>
                      <a:ahLst/>
                      <a:cxnLst>
                        <a:cxn ang="0">
                          <a:pos x="connsiteX0" y="connsiteY0"/>
                        </a:cxn>
                        <a:cxn ang="0">
                          <a:pos x="connsiteX1" y="connsiteY1"/>
                        </a:cxn>
                        <a:cxn ang="0">
                          <a:pos x="connsiteX2" y="connsiteY2"/>
                        </a:cxn>
                      </a:cxnLst>
                      <a:rect l="l" t="t" r="r" b="b"/>
                      <a:pathLst>
                        <a:path w="292705" h="304800">
                          <a:moveTo>
                            <a:pt x="16933" y="304800"/>
                          </a:moveTo>
                          <a:cubicBezTo>
                            <a:pt x="8466" y="243114"/>
                            <a:pt x="0" y="181429"/>
                            <a:pt x="45962" y="130629"/>
                          </a:cubicBezTo>
                          <a:cubicBezTo>
                            <a:pt x="91924" y="79829"/>
                            <a:pt x="192314" y="39914"/>
                            <a:pt x="292705" y="0"/>
                          </a:cubicBezTo>
                        </a:path>
                      </a:pathLst>
                    </a:custGeom>
                    <a:grpFill/>
                    <a:ln w="12700">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en-US" sz="1400"/>
                    </a:p>
                  </p:txBody>
                </p:sp>
              </p:grpSp>
              <p:grpSp>
                <p:nvGrpSpPr>
                  <p:cNvPr id="145" name="Group 35"/>
                  <p:cNvGrpSpPr/>
                  <p:nvPr/>
                </p:nvGrpSpPr>
                <p:grpSpPr>
                  <a:xfrm rot="17897058">
                    <a:off x="786474" y="7857054"/>
                    <a:ext cx="362857" cy="549858"/>
                    <a:chOff x="3899505" y="4414762"/>
                    <a:chExt cx="362857" cy="599924"/>
                  </a:xfrm>
                  <a:solidFill>
                    <a:srgbClr val="CCFF66"/>
                  </a:solidFill>
                </p:grpSpPr>
                <p:sp>
                  <p:nvSpPr>
                    <p:cNvPr id="155" name="Freeform 22"/>
                    <p:cNvSpPr/>
                    <p:nvPr/>
                  </p:nvSpPr>
                  <p:spPr>
                    <a:xfrm>
                      <a:off x="3899505" y="4414762"/>
                      <a:ext cx="362857" cy="599924"/>
                    </a:xfrm>
                    <a:custGeom>
                      <a:avLst/>
                      <a:gdLst>
                        <a:gd name="connsiteX0" fmla="*/ 48381 w 362857"/>
                        <a:gd name="connsiteY0" fmla="*/ 505581 h 599924"/>
                        <a:gd name="connsiteX1" fmla="*/ 19352 w 362857"/>
                        <a:gd name="connsiteY1" fmla="*/ 258838 h 599924"/>
                        <a:gd name="connsiteX2" fmla="*/ 164495 w 362857"/>
                        <a:gd name="connsiteY2" fmla="*/ 84667 h 599924"/>
                        <a:gd name="connsiteX3" fmla="*/ 237066 w 362857"/>
                        <a:gd name="connsiteY3" fmla="*/ 12095 h 599924"/>
                        <a:gd name="connsiteX4" fmla="*/ 324152 w 362857"/>
                        <a:gd name="connsiteY4" fmla="*/ 157238 h 599924"/>
                        <a:gd name="connsiteX5" fmla="*/ 353181 w 362857"/>
                        <a:gd name="connsiteY5" fmla="*/ 331409 h 599924"/>
                        <a:gd name="connsiteX6" fmla="*/ 266095 w 362857"/>
                        <a:gd name="connsiteY6" fmla="*/ 563638 h 599924"/>
                        <a:gd name="connsiteX7" fmla="*/ 193524 w 362857"/>
                        <a:gd name="connsiteY7" fmla="*/ 549124 h 599924"/>
                        <a:gd name="connsiteX8" fmla="*/ 48381 w 362857"/>
                        <a:gd name="connsiteY8" fmla="*/ 505581 h 5999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62857" h="599924">
                          <a:moveTo>
                            <a:pt x="48381" y="505581"/>
                          </a:moveTo>
                          <a:cubicBezTo>
                            <a:pt x="24190" y="417285"/>
                            <a:pt x="0" y="328990"/>
                            <a:pt x="19352" y="258838"/>
                          </a:cubicBezTo>
                          <a:cubicBezTo>
                            <a:pt x="38704" y="188686"/>
                            <a:pt x="128209" y="125791"/>
                            <a:pt x="164495" y="84667"/>
                          </a:cubicBezTo>
                          <a:cubicBezTo>
                            <a:pt x="200781" y="43543"/>
                            <a:pt x="210457" y="0"/>
                            <a:pt x="237066" y="12095"/>
                          </a:cubicBezTo>
                          <a:cubicBezTo>
                            <a:pt x="263675" y="24190"/>
                            <a:pt x="304800" y="104019"/>
                            <a:pt x="324152" y="157238"/>
                          </a:cubicBezTo>
                          <a:cubicBezTo>
                            <a:pt x="343504" y="210457"/>
                            <a:pt x="362857" y="263676"/>
                            <a:pt x="353181" y="331409"/>
                          </a:cubicBezTo>
                          <a:cubicBezTo>
                            <a:pt x="343505" y="399142"/>
                            <a:pt x="292704" y="527352"/>
                            <a:pt x="266095" y="563638"/>
                          </a:cubicBezTo>
                          <a:cubicBezTo>
                            <a:pt x="239486" y="599924"/>
                            <a:pt x="193524" y="549124"/>
                            <a:pt x="193524" y="549124"/>
                          </a:cubicBezTo>
                          <a:lnTo>
                            <a:pt x="48381" y="505581"/>
                          </a:lnTo>
                          <a:close/>
                        </a:path>
                      </a:pathLst>
                    </a:custGeom>
                    <a:grp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400"/>
                    </a:p>
                  </p:txBody>
                </p:sp>
                <p:sp>
                  <p:nvSpPr>
                    <p:cNvPr id="156" name="Freeform 23"/>
                    <p:cNvSpPr/>
                    <p:nvPr/>
                  </p:nvSpPr>
                  <p:spPr>
                    <a:xfrm>
                      <a:off x="3959981" y="4630057"/>
                      <a:ext cx="292705" cy="304800"/>
                    </a:xfrm>
                    <a:custGeom>
                      <a:avLst/>
                      <a:gdLst>
                        <a:gd name="connsiteX0" fmla="*/ 16933 w 292705"/>
                        <a:gd name="connsiteY0" fmla="*/ 304800 h 304800"/>
                        <a:gd name="connsiteX1" fmla="*/ 45962 w 292705"/>
                        <a:gd name="connsiteY1" fmla="*/ 130629 h 304800"/>
                        <a:gd name="connsiteX2" fmla="*/ 292705 w 292705"/>
                        <a:gd name="connsiteY2" fmla="*/ 0 h 304800"/>
                      </a:gdLst>
                      <a:ahLst/>
                      <a:cxnLst>
                        <a:cxn ang="0">
                          <a:pos x="connsiteX0" y="connsiteY0"/>
                        </a:cxn>
                        <a:cxn ang="0">
                          <a:pos x="connsiteX1" y="connsiteY1"/>
                        </a:cxn>
                        <a:cxn ang="0">
                          <a:pos x="connsiteX2" y="connsiteY2"/>
                        </a:cxn>
                      </a:cxnLst>
                      <a:rect l="l" t="t" r="r" b="b"/>
                      <a:pathLst>
                        <a:path w="292705" h="304800">
                          <a:moveTo>
                            <a:pt x="16933" y="304800"/>
                          </a:moveTo>
                          <a:cubicBezTo>
                            <a:pt x="8466" y="243114"/>
                            <a:pt x="0" y="181429"/>
                            <a:pt x="45962" y="130629"/>
                          </a:cubicBezTo>
                          <a:cubicBezTo>
                            <a:pt x="91924" y="79829"/>
                            <a:pt x="192314" y="39914"/>
                            <a:pt x="292705" y="0"/>
                          </a:cubicBezTo>
                        </a:path>
                      </a:pathLst>
                    </a:custGeom>
                    <a:grpFill/>
                    <a:ln w="12700">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en-US" sz="1400"/>
                    </a:p>
                  </p:txBody>
                </p:sp>
              </p:grpSp>
              <p:grpSp>
                <p:nvGrpSpPr>
                  <p:cNvPr id="146" name="Group 38"/>
                  <p:cNvGrpSpPr>
                    <a:grpSpLocks noChangeAspect="1"/>
                  </p:cNvGrpSpPr>
                  <p:nvPr/>
                </p:nvGrpSpPr>
                <p:grpSpPr>
                  <a:xfrm rot="18240000">
                    <a:off x="922002" y="3976506"/>
                    <a:ext cx="215054" cy="376679"/>
                    <a:chOff x="3899505" y="4414762"/>
                    <a:chExt cx="362857" cy="599924"/>
                  </a:xfrm>
                  <a:solidFill>
                    <a:srgbClr val="CCFF66"/>
                  </a:solidFill>
                </p:grpSpPr>
                <p:sp>
                  <p:nvSpPr>
                    <p:cNvPr id="153" name="Freeform 152"/>
                    <p:cNvSpPr/>
                    <p:nvPr/>
                  </p:nvSpPr>
                  <p:spPr>
                    <a:xfrm>
                      <a:off x="3899505" y="4414762"/>
                      <a:ext cx="362857" cy="599924"/>
                    </a:xfrm>
                    <a:custGeom>
                      <a:avLst/>
                      <a:gdLst>
                        <a:gd name="connsiteX0" fmla="*/ 48381 w 362857"/>
                        <a:gd name="connsiteY0" fmla="*/ 505581 h 599924"/>
                        <a:gd name="connsiteX1" fmla="*/ 19352 w 362857"/>
                        <a:gd name="connsiteY1" fmla="*/ 258838 h 599924"/>
                        <a:gd name="connsiteX2" fmla="*/ 164495 w 362857"/>
                        <a:gd name="connsiteY2" fmla="*/ 84667 h 599924"/>
                        <a:gd name="connsiteX3" fmla="*/ 237066 w 362857"/>
                        <a:gd name="connsiteY3" fmla="*/ 12095 h 599924"/>
                        <a:gd name="connsiteX4" fmla="*/ 324152 w 362857"/>
                        <a:gd name="connsiteY4" fmla="*/ 157238 h 599924"/>
                        <a:gd name="connsiteX5" fmla="*/ 353181 w 362857"/>
                        <a:gd name="connsiteY5" fmla="*/ 331409 h 599924"/>
                        <a:gd name="connsiteX6" fmla="*/ 266095 w 362857"/>
                        <a:gd name="connsiteY6" fmla="*/ 563638 h 599924"/>
                        <a:gd name="connsiteX7" fmla="*/ 193524 w 362857"/>
                        <a:gd name="connsiteY7" fmla="*/ 549124 h 599924"/>
                        <a:gd name="connsiteX8" fmla="*/ 48381 w 362857"/>
                        <a:gd name="connsiteY8" fmla="*/ 505581 h 5999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62857" h="599924">
                          <a:moveTo>
                            <a:pt x="48381" y="505581"/>
                          </a:moveTo>
                          <a:cubicBezTo>
                            <a:pt x="24190" y="417285"/>
                            <a:pt x="0" y="328990"/>
                            <a:pt x="19352" y="258838"/>
                          </a:cubicBezTo>
                          <a:cubicBezTo>
                            <a:pt x="38704" y="188686"/>
                            <a:pt x="128209" y="125791"/>
                            <a:pt x="164495" y="84667"/>
                          </a:cubicBezTo>
                          <a:cubicBezTo>
                            <a:pt x="200781" y="43543"/>
                            <a:pt x="210457" y="0"/>
                            <a:pt x="237066" y="12095"/>
                          </a:cubicBezTo>
                          <a:cubicBezTo>
                            <a:pt x="263675" y="24190"/>
                            <a:pt x="304800" y="104019"/>
                            <a:pt x="324152" y="157238"/>
                          </a:cubicBezTo>
                          <a:cubicBezTo>
                            <a:pt x="343504" y="210457"/>
                            <a:pt x="362857" y="263676"/>
                            <a:pt x="353181" y="331409"/>
                          </a:cubicBezTo>
                          <a:cubicBezTo>
                            <a:pt x="343505" y="399142"/>
                            <a:pt x="292704" y="527352"/>
                            <a:pt x="266095" y="563638"/>
                          </a:cubicBezTo>
                          <a:cubicBezTo>
                            <a:pt x="239486" y="599924"/>
                            <a:pt x="193524" y="549124"/>
                            <a:pt x="193524" y="549124"/>
                          </a:cubicBezTo>
                          <a:lnTo>
                            <a:pt x="48381" y="505581"/>
                          </a:lnTo>
                          <a:close/>
                        </a:path>
                      </a:pathLst>
                    </a:custGeom>
                    <a:grp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400"/>
                    </a:p>
                  </p:txBody>
                </p:sp>
                <p:sp>
                  <p:nvSpPr>
                    <p:cNvPr id="154" name="Freeform 21"/>
                    <p:cNvSpPr/>
                    <p:nvPr/>
                  </p:nvSpPr>
                  <p:spPr>
                    <a:xfrm>
                      <a:off x="3959981" y="4630057"/>
                      <a:ext cx="292705" cy="304800"/>
                    </a:xfrm>
                    <a:custGeom>
                      <a:avLst/>
                      <a:gdLst>
                        <a:gd name="connsiteX0" fmla="*/ 16933 w 292705"/>
                        <a:gd name="connsiteY0" fmla="*/ 304800 h 304800"/>
                        <a:gd name="connsiteX1" fmla="*/ 45962 w 292705"/>
                        <a:gd name="connsiteY1" fmla="*/ 130629 h 304800"/>
                        <a:gd name="connsiteX2" fmla="*/ 292705 w 292705"/>
                        <a:gd name="connsiteY2" fmla="*/ 0 h 304800"/>
                      </a:gdLst>
                      <a:ahLst/>
                      <a:cxnLst>
                        <a:cxn ang="0">
                          <a:pos x="connsiteX0" y="connsiteY0"/>
                        </a:cxn>
                        <a:cxn ang="0">
                          <a:pos x="connsiteX1" y="connsiteY1"/>
                        </a:cxn>
                        <a:cxn ang="0">
                          <a:pos x="connsiteX2" y="connsiteY2"/>
                        </a:cxn>
                      </a:cxnLst>
                      <a:rect l="l" t="t" r="r" b="b"/>
                      <a:pathLst>
                        <a:path w="292705" h="304800">
                          <a:moveTo>
                            <a:pt x="16933" y="304800"/>
                          </a:moveTo>
                          <a:cubicBezTo>
                            <a:pt x="8466" y="243114"/>
                            <a:pt x="0" y="181429"/>
                            <a:pt x="45962" y="130629"/>
                          </a:cubicBezTo>
                          <a:cubicBezTo>
                            <a:pt x="91924" y="79829"/>
                            <a:pt x="192314" y="39914"/>
                            <a:pt x="292705" y="0"/>
                          </a:cubicBezTo>
                        </a:path>
                      </a:pathLst>
                    </a:custGeom>
                    <a:grpFill/>
                    <a:ln w="12700">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en-US" sz="1400"/>
                    </a:p>
                  </p:txBody>
                </p:sp>
              </p:grpSp>
              <p:grpSp>
                <p:nvGrpSpPr>
                  <p:cNvPr id="147" name="Group 41"/>
                  <p:cNvGrpSpPr>
                    <a:grpSpLocks noChangeAspect="1"/>
                  </p:cNvGrpSpPr>
                  <p:nvPr/>
                </p:nvGrpSpPr>
                <p:grpSpPr>
                  <a:xfrm rot="1680000">
                    <a:off x="1133796" y="3499559"/>
                    <a:ext cx="147363" cy="258114"/>
                    <a:chOff x="3899505" y="4414762"/>
                    <a:chExt cx="362857" cy="599924"/>
                  </a:xfrm>
                  <a:solidFill>
                    <a:srgbClr val="CCFF66"/>
                  </a:solidFill>
                </p:grpSpPr>
                <p:sp>
                  <p:nvSpPr>
                    <p:cNvPr id="151" name="Freeform 150"/>
                    <p:cNvSpPr/>
                    <p:nvPr/>
                  </p:nvSpPr>
                  <p:spPr>
                    <a:xfrm>
                      <a:off x="3899505" y="4414762"/>
                      <a:ext cx="362857" cy="599924"/>
                    </a:xfrm>
                    <a:custGeom>
                      <a:avLst/>
                      <a:gdLst>
                        <a:gd name="connsiteX0" fmla="*/ 48381 w 362857"/>
                        <a:gd name="connsiteY0" fmla="*/ 505581 h 599924"/>
                        <a:gd name="connsiteX1" fmla="*/ 19352 w 362857"/>
                        <a:gd name="connsiteY1" fmla="*/ 258838 h 599924"/>
                        <a:gd name="connsiteX2" fmla="*/ 164495 w 362857"/>
                        <a:gd name="connsiteY2" fmla="*/ 84667 h 599924"/>
                        <a:gd name="connsiteX3" fmla="*/ 237066 w 362857"/>
                        <a:gd name="connsiteY3" fmla="*/ 12095 h 599924"/>
                        <a:gd name="connsiteX4" fmla="*/ 324152 w 362857"/>
                        <a:gd name="connsiteY4" fmla="*/ 157238 h 599924"/>
                        <a:gd name="connsiteX5" fmla="*/ 353181 w 362857"/>
                        <a:gd name="connsiteY5" fmla="*/ 331409 h 599924"/>
                        <a:gd name="connsiteX6" fmla="*/ 266095 w 362857"/>
                        <a:gd name="connsiteY6" fmla="*/ 563638 h 599924"/>
                        <a:gd name="connsiteX7" fmla="*/ 193524 w 362857"/>
                        <a:gd name="connsiteY7" fmla="*/ 549124 h 599924"/>
                        <a:gd name="connsiteX8" fmla="*/ 48381 w 362857"/>
                        <a:gd name="connsiteY8" fmla="*/ 505581 h 5999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62857" h="599924">
                          <a:moveTo>
                            <a:pt x="48381" y="505581"/>
                          </a:moveTo>
                          <a:cubicBezTo>
                            <a:pt x="24190" y="417285"/>
                            <a:pt x="0" y="328990"/>
                            <a:pt x="19352" y="258838"/>
                          </a:cubicBezTo>
                          <a:cubicBezTo>
                            <a:pt x="38704" y="188686"/>
                            <a:pt x="128209" y="125791"/>
                            <a:pt x="164495" y="84667"/>
                          </a:cubicBezTo>
                          <a:cubicBezTo>
                            <a:pt x="200781" y="43543"/>
                            <a:pt x="210457" y="0"/>
                            <a:pt x="237066" y="12095"/>
                          </a:cubicBezTo>
                          <a:cubicBezTo>
                            <a:pt x="263675" y="24190"/>
                            <a:pt x="304800" y="104019"/>
                            <a:pt x="324152" y="157238"/>
                          </a:cubicBezTo>
                          <a:cubicBezTo>
                            <a:pt x="343504" y="210457"/>
                            <a:pt x="362857" y="263676"/>
                            <a:pt x="353181" y="331409"/>
                          </a:cubicBezTo>
                          <a:cubicBezTo>
                            <a:pt x="343505" y="399142"/>
                            <a:pt x="292704" y="527352"/>
                            <a:pt x="266095" y="563638"/>
                          </a:cubicBezTo>
                          <a:cubicBezTo>
                            <a:pt x="239486" y="599924"/>
                            <a:pt x="193524" y="549124"/>
                            <a:pt x="193524" y="549124"/>
                          </a:cubicBezTo>
                          <a:lnTo>
                            <a:pt x="48381" y="505581"/>
                          </a:lnTo>
                          <a:close/>
                        </a:path>
                      </a:pathLst>
                    </a:custGeom>
                    <a:grp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400"/>
                    </a:p>
                  </p:txBody>
                </p:sp>
                <p:sp>
                  <p:nvSpPr>
                    <p:cNvPr id="152" name="Freeform 151"/>
                    <p:cNvSpPr/>
                    <p:nvPr/>
                  </p:nvSpPr>
                  <p:spPr>
                    <a:xfrm>
                      <a:off x="3959981" y="4630057"/>
                      <a:ext cx="292705" cy="304800"/>
                    </a:xfrm>
                    <a:custGeom>
                      <a:avLst/>
                      <a:gdLst>
                        <a:gd name="connsiteX0" fmla="*/ 16933 w 292705"/>
                        <a:gd name="connsiteY0" fmla="*/ 304800 h 304800"/>
                        <a:gd name="connsiteX1" fmla="*/ 45962 w 292705"/>
                        <a:gd name="connsiteY1" fmla="*/ 130629 h 304800"/>
                        <a:gd name="connsiteX2" fmla="*/ 292705 w 292705"/>
                        <a:gd name="connsiteY2" fmla="*/ 0 h 304800"/>
                      </a:gdLst>
                      <a:ahLst/>
                      <a:cxnLst>
                        <a:cxn ang="0">
                          <a:pos x="connsiteX0" y="connsiteY0"/>
                        </a:cxn>
                        <a:cxn ang="0">
                          <a:pos x="connsiteX1" y="connsiteY1"/>
                        </a:cxn>
                        <a:cxn ang="0">
                          <a:pos x="connsiteX2" y="connsiteY2"/>
                        </a:cxn>
                      </a:cxnLst>
                      <a:rect l="l" t="t" r="r" b="b"/>
                      <a:pathLst>
                        <a:path w="292705" h="304800">
                          <a:moveTo>
                            <a:pt x="16933" y="304800"/>
                          </a:moveTo>
                          <a:cubicBezTo>
                            <a:pt x="8466" y="243114"/>
                            <a:pt x="0" y="181429"/>
                            <a:pt x="45962" y="130629"/>
                          </a:cubicBezTo>
                          <a:cubicBezTo>
                            <a:pt x="91924" y="79829"/>
                            <a:pt x="192314" y="39914"/>
                            <a:pt x="292705" y="0"/>
                          </a:cubicBezTo>
                        </a:path>
                      </a:pathLst>
                    </a:custGeom>
                    <a:grpFill/>
                    <a:ln w="12700">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en-US" sz="1400"/>
                    </a:p>
                  </p:txBody>
                </p:sp>
              </p:grpSp>
              <p:grpSp>
                <p:nvGrpSpPr>
                  <p:cNvPr id="148" name="Group 44"/>
                  <p:cNvGrpSpPr>
                    <a:grpSpLocks noChangeAspect="1"/>
                  </p:cNvGrpSpPr>
                  <p:nvPr/>
                </p:nvGrpSpPr>
                <p:grpSpPr>
                  <a:xfrm rot="21420000">
                    <a:off x="1066002" y="3080792"/>
                    <a:ext cx="147363" cy="258114"/>
                    <a:chOff x="3899505" y="4414762"/>
                    <a:chExt cx="362857" cy="599924"/>
                  </a:xfrm>
                  <a:solidFill>
                    <a:srgbClr val="CCFF66"/>
                  </a:solidFill>
                </p:grpSpPr>
                <p:sp>
                  <p:nvSpPr>
                    <p:cNvPr id="149" name="Freeform 148"/>
                    <p:cNvSpPr/>
                    <p:nvPr/>
                  </p:nvSpPr>
                  <p:spPr>
                    <a:xfrm>
                      <a:off x="3899505" y="4414762"/>
                      <a:ext cx="362857" cy="599924"/>
                    </a:xfrm>
                    <a:custGeom>
                      <a:avLst/>
                      <a:gdLst>
                        <a:gd name="connsiteX0" fmla="*/ 48381 w 362857"/>
                        <a:gd name="connsiteY0" fmla="*/ 505581 h 599924"/>
                        <a:gd name="connsiteX1" fmla="*/ 19352 w 362857"/>
                        <a:gd name="connsiteY1" fmla="*/ 258838 h 599924"/>
                        <a:gd name="connsiteX2" fmla="*/ 164495 w 362857"/>
                        <a:gd name="connsiteY2" fmla="*/ 84667 h 599924"/>
                        <a:gd name="connsiteX3" fmla="*/ 237066 w 362857"/>
                        <a:gd name="connsiteY3" fmla="*/ 12095 h 599924"/>
                        <a:gd name="connsiteX4" fmla="*/ 324152 w 362857"/>
                        <a:gd name="connsiteY4" fmla="*/ 157238 h 599924"/>
                        <a:gd name="connsiteX5" fmla="*/ 353181 w 362857"/>
                        <a:gd name="connsiteY5" fmla="*/ 331409 h 599924"/>
                        <a:gd name="connsiteX6" fmla="*/ 266095 w 362857"/>
                        <a:gd name="connsiteY6" fmla="*/ 563638 h 599924"/>
                        <a:gd name="connsiteX7" fmla="*/ 193524 w 362857"/>
                        <a:gd name="connsiteY7" fmla="*/ 549124 h 599924"/>
                        <a:gd name="connsiteX8" fmla="*/ 48381 w 362857"/>
                        <a:gd name="connsiteY8" fmla="*/ 505581 h 5999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62857" h="599924">
                          <a:moveTo>
                            <a:pt x="48381" y="505581"/>
                          </a:moveTo>
                          <a:cubicBezTo>
                            <a:pt x="24190" y="417285"/>
                            <a:pt x="0" y="328990"/>
                            <a:pt x="19352" y="258838"/>
                          </a:cubicBezTo>
                          <a:cubicBezTo>
                            <a:pt x="38704" y="188686"/>
                            <a:pt x="128209" y="125791"/>
                            <a:pt x="164495" y="84667"/>
                          </a:cubicBezTo>
                          <a:cubicBezTo>
                            <a:pt x="200781" y="43543"/>
                            <a:pt x="210457" y="0"/>
                            <a:pt x="237066" y="12095"/>
                          </a:cubicBezTo>
                          <a:cubicBezTo>
                            <a:pt x="263675" y="24190"/>
                            <a:pt x="304800" y="104019"/>
                            <a:pt x="324152" y="157238"/>
                          </a:cubicBezTo>
                          <a:cubicBezTo>
                            <a:pt x="343504" y="210457"/>
                            <a:pt x="362857" y="263676"/>
                            <a:pt x="353181" y="331409"/>
                          </a:cubicBezTo>
                          <a:cubicBezTo>
                            <a:pt x="343505" y="399142"/>
                            <a:pt x="292704" y="527352"/>
                            <a:pt x="266095" y="563638"/>
                          </a:cubicBezTo>
                          <a:cubicBezTo>
                            <a:pt x="239486" y="599924"/>
                            <a:pt x="193524" y="549124"/>
                            <a:pt x="193524" y="549124"/>
                          </a:cubicBezTo>
                          <a:lnTo>
                            <a:pt x="48381" y="505581"/>
                          </a:lnTo>
                          <a:close/>
                        </a:path>
                      </a:pathLst>
                    </a:custGeom>
                    <a:grp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400"/>
                    </a:p>
                  </p:txBody>
                </p:sp>
                <p:sp>
                  <p:nvSpPr>
                    <p:cNvPr id="150" name="Freeform 149"/>
                    <p:cNvSpPr/>
                    <p:nvPr/>
                  </p:nvSpPr>
                  <p:spPr>
                    <a:xfrm>
                      <a:off x="3959981" y="4630057"/>
                      <a:ext cx="292705" cy="304800"/>
                    </a:xfrm>
                    <a:custGeom>
                      <a:avLst/>
                      <a:gdLst>
                        <a:gd name="connsiteX0" fmla="*/ 16933 w 292705"/>
                        <a:gd name="connsiteY0" fmla="*/ 304800 h 304800"/>
                        <a:gd name="connsiteX1" fmla="*/ 45962 w 292705"/>
                        <a:gd name="connsiteY1" fmla="*/ 130629 h 304800"/>
                        <a:gd name="connsiteX2" fmla="*/ 292705 w 292705"/>
                        <a:gd name="connsiteY2" fmla="*/ 0 h 304800"/>
                      </a:gdLst>
                      <a:ahLst/>
                      <a:cxnLst>
                        <a:cxn ang="0">
                          <a:pos x="connsiteX0" y="connsiteY0"/>
                        </a:cxn>
                        <a:cxn ang="0">
                          <a:pos x="connsiteX1" y="connsiteY1"/>
                        </a:cxn>
                        <a:cxn ang="0">
                          <a:pos x="connsiteX2" y="connsiteY2"/>
                        </a:cxn>
                      </a:cxnLst>
                      <a:rect l="l" t="t" r="r" b="b"/>
                      <a:pathLst>
                        <a:path w="292705" h="304800">
                          <a:moveTo>
                            <a:pt x="16933" y="304800"/>
                          </a:moveTo>
                          <a:cubicBezTo>
                            <a:pt x="8466" y="243114"/>
                            <a:pt x="0" y="181429"/>
                            <a:pt x="45962" y="130629"/>
                          </a:cubicBezTo>
                          <a:cubicBezTo>
                            <a:pt x="91924" y="79829"/>
                            <a:pt x="192314" y="39914"/>
                            <a:pt x="292705" y="0"/>
                          </a:cubicBezTo>
                        </a:path>
                      </a:pathLst>
                    </a:custGeom>
                    <a:grpFill/>
                    <a:ln w="12700">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en-US" sz="1400"/>
                    </a:p>
                  </p:txBody>
                </p:sp>
              </p:grpSp>
            </p:grpSp>
            <p:grpSp>
              <p:nvGrpSpPr>
                <p:cNvPr id="130" name="Group 63"/>
                <p:cNvGrpSpPr/>
                <p:nvPr/>
              </p:nvGrpSpPr>
              <p:grpSpPr>
                <a:xfrm>
                  <a:off x="2124075" y="2420888"/>
                  <a:ext cx="1007765" cy="1008112"/>
                  <a:chOff x="2206171" y="1548190"/>
                  <a:chExt cx="1340152" cy="1180496"/>
                </a:xfrm>
              </p:grpSpPr>
              <p:sp>
                <p:nvSpPr>
                  <p:cNvPr id="131" name="Freeform 130"/>
                  <p:cNvSpPr/>
                  <p:nvPr/>
                </p:nvSpPr>
                <p:spPr>
                  <a:xfrm>
                    <a:off x="2206171" y="1548190"/>
                    <a:ext cx="1340152" cy="1180496"/>
                  </a:xfrm>
                  <a:custGeom>
                    <a:avLst/>
                    <a:gdLst>
                      <a:gd name="connsiteX0" fmla="*/ 0 w 1340152"/>
                      <a:gd name="connsiteY0" fmla="*/ 1180496 h 1180496"/>
                      <a:gd name="connsiteX1" fmla="*/ 290286 w 1340152"/>
                      <a:gd name="connsiteY1" fmla="*/ 962781 h 1180496"/>
                      <a:gd name="connsiteX2" fmla="*/ 653143 w 1340152"/>
                      <a:gd name="connsiteY2" fmla="*/ 1078896 h 1180496"/>
                      <a:gd name="connsiteX3" fmla="*/ 1204686 w 1340152"/>
                      <a:gd name="connsiteY3" fmla="*/ 832153 h 1180496"/>
                      <a:gd name="connsiteX4" fmla="*/ 1320800 w 1340152"/>
                      <a:gd name="connsiteY4" fmla="*/ 91924 h 1180496"/>
                      <a:gd name="connsiteX5" fmla="*/ 1088572 w 1340152"/>
                      <a:gd name="connsiteY5" fmla="*/ 280610 h 1180496"/>
                      <a:gd name="connsiteX6" fmla="*/ 638629 w 1340152"/>
                      <a:gd name="connsiteY6" fmla="*/ 396724 h 1180496"/>
                      <a:gd name="connsiteX7" fmla="*/ 391886 w 1340152"/>
                      <a:gd name="connsiteY7" fmla="*/ 745067 h 1180496"/>
                      <a:gd name="connsiteX8" fmla="*/ 319315 w 1340152"/>
                      <a:gd name="connsiteY8" fmla="*/ 919239 h 1180496"/>
                      <a:gd name="connsiteX9" fmla="*/ 58058 w 1340152"/>
                      <a:gd name="connsiteY9" fmla="*/ 1107924 h 11804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340152" h="1180496">
                        <a:moveTo>
                          <a:pt x="0" y="1180496"/>
                        </a:moveTo>
                        <a:cubicBezTo>
                          <a:pt x="90714" y="1080105"/>
                          <a:pt x="181429" y="979714"/>
                          <a:pt x="290286" y="962781"/>
                        </a:cubicBezTo>
                        <a:cubicBezTo>
                          <a:pt x="399143" y="945848"/>
                          <a:pt x="500743" y="1100667"/>
                          <a:pt x="653143" y="1078896"/>
                        </a:cubicBezTo>
                        <a:cubicBezTo>
                          <a:pt x="805543" y="1057125"/>
                          <a:pt x="1093410" y="996648"/>
                          <a:pt x="1204686" y="832153"/>
                        </a:cubicBezTo>
                        <a:cubicBezTo>
                          <a:pt x="1315962" y="667658"/>
                          <a:pt x="1340152" y="183848"/>
                          <a:pt x="1320800" y="91924"/>
                        </a:cubicBezTo>
                        <a:cubicBezTo>
                          <a:pt x="1301448" y="0"/>
                          <a:pt x="1202267" y="229810"/>
                          <a:pt x="1088572" y="280610"/>
                        </a:cubicBezTo>
                        <a:cubicBezTo>
                          <a:pt x="974877" y="331410"/>
                          <a:pt x="754743" y="319315"/>
                          <a:pt x="638629" y="396724"/>
                        </a:cubicBezTo>
                        <a:cubicBezTo>
                          <a:pt x="522515" y="474133"/>
                          <a:pt x="445105" y="657981"/>
                          <a:pt x="391886" y="745067"/>
                        </a:cubicBezTo>
                        <a:cubicBezTo>
                          <a:pt x="338667" y="832153"/>
                          <a:pt x="374953" y="858763"/>
                          <a:pt x="319315" y="919239"/>
                        </a:cubicBezTo>
                        <a:cubicBezTo>
                          <a:pt x="263677" y="979715"/>
                          <a:pt x="160867" y="1043819"/>
                          <a:pt x="58058" y="1107924"/>
                        </a:cubicBezTo>
                      </a:path>
                    </a:pathLst>
                  </a:custGeom>
                  <a:solidFill>
                    <a:srgbClr val="97E44A"/>
                  </a:solidFill>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32" name="Freeform 131"/>
                  <p:cNvSpPr/>
                  <p:nvPr/>
                </p:nvSpPr>
                <p:spPr>
                  <a:xfrm>
                    <a:off x="2525486" y="1669143"/>
                    <a:ext cx="996647" cy="812800"/>
                  </a:xfrm>
                  <a:custGeom>
                    <a:avLst/>
                    <a:gdLst>
                      <a:gd name="connsiteX0" fmla="*/ 0 w 996647"/>
                      <a:gd name="connsiteY0" fmla="*/ 812800 h 812800"/>
                      <a:gd name="connsiteX1" fmla="*/ 261257 w 996647"/>
                      <a:gd name="connsiteY1" fmla="*/ 696686 h 812800"/>
                      <a:gd name="connsiteX2" fmla="*/ 624114 w 996647"/>
                      <a:gd name="connsiteY2" fmla="*/ 449943 h 812800"/>
                      <a:gd name="connsiteX3" fmla="*/ 943428 w 996647"/>
                      <a:gd name="connsiteY3" fmla="*/ 116114 h 812800"/>
                      <a:gd name="connsiteX4" fmla="*/ 943428 w 996647"/>
                      <a:gd name="connsiteY4" fmla="*/ 0 h 8128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996647" h="812800">
                        <a:moveTo>
                          <a:pt x="0" y="812800"/>
                        </a:moveTo>
                        <a:cubicBezTo>
                          <a:pt x="78619" y="784981"/>
                          <a:pt x="157238" y="757162"/>
                          <a:pt x="261257" y="696686"/>
                        </a:cubicBezTo>
                        <a:cubicBezTo>
                          <a:pt x="365276" y="636210"/>
                          <a:pt x="510419" y="546705"/>
                          <a:pt x="624114" y="449943"/>
                        </a:cubicBezTo>
                        <a:cubicBezTo>
                          <a:pt x="737809" y="353181"/>
                          <a:pt x="890209" y="191104"/>
                          <a:pt x="943428" y="116114"/>
                        </a:cubicBezTo>
                        <a:cubicBezTo>
                          <a:pt x="996647" y="41124"/>
                          <a:pt x="970037" y="20562"/>
                          <a:pt x="943428"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33" name="Freeform 132"/>
                  <p:cNvSpPr/>
                  <p:nvPr/>
                </p:nvSpPr>
                <p:spPr>
                  <a:xfrm>
                    <a:off x="2931886" y="2336800"/>
                    <a:ext cx="319314" cy="154819"/>
                  </a:xfrm>
                  <a:custGeom>
                    <a:avLst/>
                    <a:gdLst>
                      <a:gd name="connsiteX0" fmla="*/ 0 w 319314"/>
                      <a:gd name="connsiteY0" fmla="*/ 0 h 154819"/>
                      <a:gd name="connsiteX1" fmla="*/ 87085 w 319314"/>
                      <a:gd name="connsiteY1" fmla="*/ 87086 h 154819"/>
                      <a:gd name="connsiteX2" fmla="*/ 232228 w 319314"/>
                      <a:gd name="connsiteY2" fmla="*/ 145143 h 154819"/>
                      <a:gd name="connsiteX3" fmla="*/ 319314 w 319314"/>
                      <a:gd name="connsiteY3" fmla="*/ 145143 h 154819"/>
                    </a:gdLst>
                    <a:ahLst/>
                    <a:cxnLst>
                      <a:cxn ang="0">
                        <a:pos x="connsiteX0" y="connsiteY0"/>
                      </a:cxn>
                      <a:cxn ang="0">
                        <a:pos x="connsiteX1" y="connsiteY1"/>
                      </a:cxn>
                      <a:cxn ang="0">
                        <a:pos x="connsiteX2" y="connsiteY2"/>
                      </a:cxn>
                      <a:cxn ang="0">
                        <a:pos x="connsiteX3" y="connsiteY3"/>
                      </a:cxn>
                    </a:cxnLst>
                    <a:rect l="l" t="t" r="r" b="b"/>
                    <a:pathLst>
                      <a:path w="319314" h="154819">
                        <a:moveTo>
                          <a:pt x="0" y="0"/>
                        </a:moveTo>
                        <a:cubicBezTo>
                          <a:pt x="24190" y="31448"/>
                          <a:pt x="48380" y="62896"/>
                          <a:pt x="87085" y="87086"/>
                        </a:cubicBezTo>
                        <a:cubicBezTo>
                          <a:pt x="125790" y="111276"/>
                          <a:pt x="193523" y="135467"/>
                          <a:pt x="232228" y="145143"/>
                        </a:cubicBezTo>
                        <a:cubicBezTo>
                          <a:pt x="270933" y="154819"/>
                          <a:pt x="295123" y="149981"/>
                          <a:pt x="319314" y="145143"/>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34" name="Freeform 133"/>
                  <p:cNvSpPr/>
                  <p:nvPr/>
                </p:nvSpPr>
                <p:spPr>
                  <a:xfrm>
                    <a:off x="3077029" y="2220686"/>
                    <a:ext cx="290285" cy="120952"/>
                  </a:xfrm>
                  <a:custGeom>
                    <a:avLst/>
                    <a:gdLst>
                      <a:gd name="connsiteX0" fmla="*/ 0 w 290285"/>
                      <a:gd name="connsiteY0" fmla="*/ 0 h 120952"/>
                      <a:gd name="connsiteX1" fmla="*/ 188685 w 290285"/>
                      <a:gd name="connsiteY1" fmla="*/ 101600 h 120952"/>
                      <a:gd name="connsiteX2" fmla="*/ 290285 w 290285"/>
                      <a:gd name="connsiteY2" fmla="*/ 116114 h 120952"/>
                    </a:gdLst>
                    <a:ahLst/>
                    <a:cxnLst>
                      <a:cxn ang="0">
                        <a:pos x="connsiteX0" y="connsiteY0"/>
                      </a:cxn>
                      <a:cxn ang="0">
                        <a:pos x="connsiteX1" y="connsiteY1"/>
                      </a:cxn>
                      <a:cxn ang="0">
                        <a:pos x="connsiteX2" y="connsiteY2"/>
                      </a:cxn>
                    </a:cxnLst>
                    <a:rect l="l" t="t" r="r" b="b"/>
                    <a:pathLst>
                      <a:path w="290285" h="120952">
                        <a:moveTo>
                          <a:pt x="0" y="0"/>
                        </a:moveTo>
                        <a:cubicBezTo>
                          <a:pt x="70152" y="41124"/>
                          <a:pt x="140304" y="82248"/>
                          <a:pt x="188685" y="101600"/>
                        </a:cubicBezTo>
                        <a:cubicBezTo>
                          <a:pt x="237066" y="120952"/>
                          <a:pt x="263675" y="118533"/>
                          <a:pt x="290285" y="116114"/>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35" name="Freeform 134"/>
                  <p:cNvSpPr/>
                  <p:nvPr/>
                </p:nvSpPr>
                <p:spPr>
                  <a:xfrm>
                    <a:off x="2743200" y="2119086"/>
                    <a:ext cx="14514" cy="275771"/>
                  </a:xfrm>
                  <a:custGeom>
                    <a:avLst/>
                    <a:gdLst>
                      <a:gd name="connsiteX0" fmla="*/ 14514 w 14514"/>
                      <a:gd name="connsiteY0" fmla="*/ 275771 h 275771"/>
                      <a:gd name="connsiteX1" fmla="*/ 0 w 14514"/>
                      <a:gd name="connsiteY1" fmla="*/ 174171 h 275771"/>
                      <a:gd name="connsiteX2" fmla="*/ 14514 w 14514"/>
                      <a:gd name="connsiteY2" fmla="*/ 0 h 275771"/>
                    </a:gdLst>
                    <a:ahLst/>
                    <a:cxnLst>
                      <a:cxn ang="0">
                        <a:pos x="connsiteX0" y="connsiteY0"/>
                      </a:cxn>
                      <a:cxn ang="0">
                        <a:pos x="connsiteX1" y="connsiteY1"/>
                      </a:cxn>
                      <a:cxn ang="0">
                        <a:pos x="connsiteX2" y="connsiteY2"/>
                      </a:cxn>
                    </a:cxnLst>
                    <a:rect l="l" t="t" r="r" b="b"/>
                    <a:pathLst>
                      <a:path w="14514" h="275771">
                        <a:moveTo>
                          <a:pt x="14514" y="275771"/>
                        </a:moveTo>
                        <a:cubicBezTo>
                          <a:pt x="7257" y="247952"/>
                          <a:pt x="0" y="220133"/>
                          <a:pt x="0" y="174171"/>
                        </a:cubicBezTo>
                        <a:cubicBezTo>
                          <a:pt x="0" y="128209"/>
                          <a:pt x="7257" y="64104"/>
                          <a:pt x="14514"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36" name="Freeform 135"/>
                  <p:cNvSpPr/>
                  <p:nvPr/>
                </p:nvSpPr>
                <p:spPr>
                  <a:xfrm>
                    <a:off x="2931886" y="1988457"/>
                    <a:ext cx="43543" cy="217714"/>
                  </a:xfrm>
                  <a:custGeom>
                    <a:avLst/>
                    <a:gdLst>
                      <a:gd name="connsiteX0" fmla="*/ 43543 w 43543"/>
                      <a:gd name="connsiteY0" fmla="*/ 217714 h 217714"/>
                      <a:gd name="connsiteX1" fmla="*/ 0 w 43543"/>
                      <a:gd name="connsiteY1" fmla="*/ 130629 h 217714"/>
                      <a:gd name="connsiteX2" fmla="*/ 43543 w 43543"/>
                      <a:gd name="connsiteY2" fmla="*/ 0 h 217714"/>
                    </a:gdLst>
                    <a:ahLst/>
                    <a:cxnLst>
                      <a:cxn ang="0">
                        <a:pos x="connsiteX0" y="connsiteY0"/>
                      </a:cxn>
                      <a:cxn ang="0">
                        <a:pos x="connsiteX1" y="connsiteY1"/>
                      </a:cxn>
                      <a:cxn ang="0">
                        <a:pos x="connsiteX2" y="connsiteY2"/>
                      </a:cxn>
                    </a:cxnLst>
                    <a:rect l="l" t="t" r="r" b="b"/>
                    <a:pathLst>
                      <a:path w="43543" h="217714">
                        <a:moveTo>
                          <a:pt x="43543" y="217714"/>
                        </a:moveTo>
                        <a:cubicBezTo>
                          <a:pt x="21771" y="192314"/>
                          <a:pt x="0" y="166915"/>
                          <a:pt x="0" y="130629"/>
                        </a:cubicBezTo>
                        <a:cubicBezTo>
                          <a:pt x="0" y="94343"/>
                          <a:pt x="21771" y="47171"/>
                          <a:pt x="435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37" name="Freeform 136"/>
                  <p:cNvSpPr/>
                  <p:nvPr/>
                </p:nvSpPr>
                <p:spPr>
                  <a:xfrm>
                    <a:off x="2714171" y="2467429"/>
                    <a:ext cx="217715" cy="101600"/>
                  </a:xfrm>
                  <a:custGeom>
                    <a:avLst/>
                    <a:gdLst>
                      <a:gd name="connsiteX0" fmla="*/ 0 w 217715"/>
                      <a:gd name="connsiteY0" fmla="*/ 0 h 101600"/>
                      <a:gd name="connsiteX1" fmla="*/ 116115 w 217715"/>
                      <a:gd name="connsiteY1" fmla="*/ 72571 h 101600"/>
                      <a:gd name="connsiteX2" fmla="*/ 217715 w 217715"/>
                      <a:gd name="connsiteY2" fmla="*/ 101600 h 101600"/>
                    </a:gdLst>
                    <a:ahLst/>
                    <a:cxnLst>
                      <a:cxn ang="0">
                        <a:pos x="connsiteX0" y="connsiteY0"/>
                      </a:cxn>
                      <a:cxn ang="0">
                        <a:pos x="connsiteX1" y="connsiteY1"/>
                      </a:cxn>
                      <a:cxn ang="0">
                        <a:pos x="connsiteX2" y="connsiteY2"/>
                      </a:cxn>
                    </a:cxnLst>
                    <a:rect l="l" t="t" r="r" b="b"/>
                    <a:pathLst>
                      <a:path w="217715" h="101600">
                        <a:moveTo>
                          <a:pt x="0" y="0"/>
                        </a:moveTo>
                        <a:cubicBezTo>
                          <a:pt x="39914" y="27819"/>
                          <a:pt x="79829" y="55638"/>
                          <a:pt x="116115" y="72571"/>
                        </a:cubicBezTo>
                        <a:cubicBezTo>
                          <a:pt x="152401" y="89504"/>
                          <a:pt x="185058" y="95552"/>
                          <a:pt x="217715" y="10160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38" name="Freeform 137"/>
                  <p:cNvSpPr/>
                  <p:nvPr/>
                </p:nvSpPr>
                <p:spPr>
                  <a:xfrm>
                    <a:off x="3207657" y="2104571"/>
                    <a:ext cx="246743" cy="33867"/>
                  </a:xfrm>
                  <a:custGeom>
                    <a:avLst/>
                    <a:gdLst>
                      <a:gd name="connsiteX0" fmla="*/ 0 w 246743"/>
                      <a:gd name="connsiteY0" fmla="*/ 29029 h 33867"/>
                      <a:gd name="connsiteX1" fmla="*/ 159657 w 246743"/>
                      <a:gd name="connsiteY1" fmla="*/ 29029 h 33867"/>
                      <a:gd name="connsiteX2" fmla="*/ 246743 w 246743"/>
                      <a:gd name="connsiteY2" fmla="*/ 0 h 33867"/>
                    </a:gdLst>
                    <a:ahLst/>
                    <a:cxnLst>
                      <a:cxn ang="0">
                        <a:pos x="connsiteX0" y="connsiteY0"/>
                      </a:cxn>
                      <a:cxn ang="0">
                        <a:pos x="connsiteX1" y="connsiteY1"/>
                      </a:cxn>
                      <a:cxn ang="0">
                        <a:pos x="connsiteX2" y="connsiteY2"/>
                      </a:cxn>
                    </a:cxnLst>
                    <a:rect l="l" t="t" r="r" b="b"/>
                    <a:pathLst>
                      <a:path w="246743" h="33867">
                        <a:moveTo>
                          <a:pt x="0" y="29029"/>
                        </a:moveTo>
                        <a:cubicBezTo>
                          <a:pt x="59266" y="31448"/>
                          <a:pt x="118533" y="33867"/>
                          <a:pt x="159657" y="29029"/>
                        </a:cubicBezTo>
                        <a:cubicBezTo>
                          <a:pt x="200781" y="24191"/>
                          <a:pt x="223762" y="12095"/>
                          <a:pt x="246743" y="0"/>
                        </a:cubicBezTo>
                      </a:path>
                    </a:pathLst>
                  </a:custGeom>
                  <a:ln w="19050">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grpSp>
          <p:sp>
            <p:nvSpPr>
              <p:cNvPr id="284" name="Rectangle 283"/>
              <p:cNvSpPr/>
              <p:nvPr/>
            </p:nvSpPr>
            <p:spPr>
              <a:xfrm>
                <a:off x="2119240" y="4165420"/>
                <a:ext cx="173097" cy="17827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87" name="Straight Arrow Connector 286"/>
              <p:cNvCxnSpPr/>
              <p:nvPr/>
            </p:nvCxnSpPr>
            <p:spPr>
              <a:xfrm flipV="1">
                <a:off x="2263487" y="4139952"/>
                <a:ext cx="317344" cy="296015"/>
              </a:xfrm>
              <a:prstGeom prst="straightConnector1">
                <a:avLst/>
              </a:prstGeom>
              <a:ln w="12700">
                <a:solidFill>
                  <a:srgbClr val="FF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88" name="Straight Arrow Connector 287"/>
              <p:cNvCxnSpPr/>
              <p:nvPr/>
            </p:nvCxnSpPr>
            <p:spPr>
              <a:xfrm flipV="1">
                <a:off x="2263486" y="4572000"/>
                <a:ext cx="85394" cy="221307"/>
              </a:xfrm>
              <a:prstGeom prst="straightConnector1">
                <a:avLst/>
              </a:prstGeom>
              <a:ln w="12700">
                <a:solidFill>
                  <a:srgbClr val="FF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89" name="Straight Arrow Connector 288"/>
              <p:cNvCxnSpPr/>
              <p:nvPr/>
            </p:nvCxnSpPr>
            <p:spPr>
              <a:xfrm flipH="1" flipV="1">
                <a:off x="2090391" y="4267291"/>
                <a:ext cx="57699" cy="296015"/>
              </a:xfrm>
              <a:prstGeom prst="straightConnector1">
                <a:avLst/>
              </a:prstGeom>
              <a:ln w="12700">
                <a:solidFill>
                  <a:srgbClr val="FF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303" name="TextBox 302"/>
              <p:cNvSpPr txBox="1"/>
              <p:nvPr/>
            </p:nvSpPr>
            <p:spPr>
              <a:xfrm>
                <a:off x="2520000" y="3960000"/>
                <a:ext cx="269626" cy="276999"/>
              </a:xfrm>
              <a:prstGeom prst="rect">
                <a:avLst/>
              </a:prstGeom>
              <a:noFill/>
            </p:spPr>
            <p:txBody>
              <a:bodyPr wrap="none" rtlCol="0">
                <a:spAutoFit/>
              </a:bodyPr>
              <a:lstStyle/>
              <a:p>
                <a:r>
                  <a:rPr lang="en-US" sz="1200" dirty="0" smtClean="0">
                    <a:latin typeface="Arial" pitchFamily="34" charset="0"/>
                    <a:cs typeface="Arial" pitchFamily="34" charset="0"/>
                  </a:rPr>
                  <a:t>1</a:t>
                </a:r>
                <a:endParaRPr lang="en-US" sz="1200" dirty="0">
                  <a:latin typeface="Arial" pitchFamily="34" charset="0"/>
                  <a:cs typeface="Arial" pitchFamily="34" charset="0"/>
                </a:endParaRPr>
              </a:p>
            </p:txBody>
          </p:sp>
          <p:sp>
            <p:nvSpPr>
              <p:cNvPr id="304" name="TextBox 303"/>
              <p:cNvSpPr txBox="1"/>
              <p:nvPr/>
            </p:nvSpPr>
            <p:spPr>
              <a:xfrm>
                <a:off x="1944000" y="4068000"/>
                <a:ext cx="269626" cy="276999"/>
              </a:xfrm>
              <a:prstGeom prst="rect">
                <a:avLst/>
              </a:prstGeom>
              <a:noFill/>
            </p:spPr>
            <p:txBody>
              <a:bodyPr wrap="none" rtlCol="0">
                <a:spAutoFit/>
              </a:bodyPr>
              <a:lstStyle/>
              <a:p>
                <a:r>
                  <a:rPr lang="en-US" sz="1200" dirty="0" smtClean="0">
                    <a:latin typeface="Arial" pitchFamily="34" charset="0"/>
                    <a:cs typeface="Arial" pitchFamily="34" charset="0"/>
                  </a:rPr>
                  <a:t>2</a:t>
                </a:r>
                <a:endParaRPr lang="en-US" sz="1200" dirty="0">
                  <a:latin typeface="Arial" pitchFamily="34" charset="0"/>
                  <a:cs typeface="Arial" pitchFamily="34" charset="0"/>
                </a:endParaRPr>
              </a:p>
            </p:txBody>
          </p:sp>
          <p:sp>
            <p:nvSpPr>
              <p:cNvPr id="305" name="TextBox 304"/>
              <p:cNvSpPr txBox="1"/>
              <p:nvPr/>
            </p:nvSpPr>
            <p:spPr>
              <a:xfrm>
                <a:off x="2340000" y="4392000"/>
                <a:ext cx="269626" cy="276999"/>
              </a:xfrm>
              <a:prstGeom prst="rect">
                <a:avLst/>
              </a:prstGeom>
              <a:noFill/>
            </p:spPr>
            <p:txBody>
              <a:bodyPr wrap="none" rtlCol="0">
                <a:spAutoFit/>
              </a:bodyPr>
              <a:lstStyle/>
              <a:p>
                <a:r>
                  <a:rPr lang="en-US" sz="1200" dirty="0" smtClean="0">
                    <a:latin typeface="Arial" pitchFamily="34" charset="0"/>
                    <a:cs typeface="Arial" pitchFamily="34" charset="0"/>
                  </a:rPr>
                  <a:t>3</a:t>
                </a:r>
                <a:endParaRPr lang="en-US" sz="1200" dirty="0">
                  <a:latin typeface="Arial" pitchFamily="34" charset="0"/>
                  <a:cs typeface="Arial" pitchFamily="34" charset="0"/>
                </a:endParaRPr>
              </a:p>
            </p:txBody>
          </p:sp>
        </p:grpSp>
        <p:grpSp>
          <p:nvGrpSpPr>
            <p:cNvPr id="321" name="Group 320"/>
            <p:cNvGrpSpPr>
              <a:grpSpLocks noChangeAspect="1"/>
            </p:cNvGrpSpPr>
            <p:nvPr/>
          </p:nvGrpSpPr>
          <p:grpSpPr>
            <a:xfrm>
              <a:off x="1389173" y="3279008"/>
              <a:ext cx="3156737" cy="2733679"/>
              <a:chOff x="463913" y="518704"/>
              <a:chExt cx="3503704" cy="3034151"/>
            </a:xfrm>
          </p:grpSpPr>
          <p:graphicFrame>
            <p:nvGraphicFramePr>
              <p:cNvPr id="4" name="Chart 3"/>
              <p:cNvGraphicFramePr>
                <a:graphicFrameLocks noChangeAspect="1"/>
              </p:cNvGraphicFramePr>
              <p:nvPr>
                <p:extLst>
                  <p:ext uri="{D42A27DB-BD31-4B8C-83A1-F6EECF244321}">
                    <p14:modId xmlns:p14="http://schemas.microsoft.com/office/powerpoint/2010/main" val="4238366411"/>
                  </p:ext>
                </p:extLst>
              </p:nvPr>
            </p:nvGraphicFramePr>
            <p:xfrm>
              <a:off x="908720" y="1043608"/>
              <a:ext cx="3058897" cy="2283298"/>
            </p:xfrm>
            <a:graphic>
              <a:graphicData uri="http://schemas.openxmlformats.org/drawingml/2006/chart">
                <c:chart xmlns:c="http://schemas.openxmlformats.org/drawingml/2006/chart" xmlns:r="http://schemas.openxmlformats.org/officeDocument/2006/relationships" r:id="rId2"/>
              </a:graphicData>
            </a:graphic>
          </p:graphicFrame>
          <p:sp>
            <p:nvSpPr>
              <p:cNvPr id="6" name="TextBox 5"/>
              <p:cNvSpPr txBox="1"/>
              <p:nvPr/>
            </p:nvSpPr>
            <p:spPr>
              <a:xfrm>
                <a:off x="463913" y="518704"/>
                <a:ext cx="295274" cy="276999"/>
              </a:xfrm>
              <a:prstGeom prst="rect">
                <a:avLst/>
              </a:prstGeom>
              <a:noFill/>
            </p:spPr>
            <p:txBody>
              <a:bodyPr wrap="none" rtlCol="0">
                <a:spAutoFit/>
              </a:bodyPr>
              <a:lstStyle/>
              <a:p>
                <a:r>
                  <a:rPr lang="nb-NO" sz="1200" b="1" dirty="0" smtClean="0">
                    <a:latin typeface="Arial" pitchFamily="34" charset="0"/>
                    <a:cs typeface="Arial" pitchFamily="34" charset="0"/>
                  </a:rPr>
                  <a:t>B</a:t>
                </a:r>
                <a:endParaRPr lang="nb-NO" sz="1200" b="1" dirty="0">
                  <a:latin typeface="Arial" pitchFamily="34" charset="0"/>
                  <a:cs typeface="Arial" pitchFamily="34" charset="0"/>
                </a:endParaRPr>
              </a:p>
            </p:txBody>
          </p:sp>
          <p:sp>
            <p:nvSpPr>
              <p:cNvPr id="317" name="TextBox 316"/>
              <p:cNvSpPr txBox="1"/>
              <p:nvPr/>
            </p:nvSpPr>
            <p:spPr>
              <a:xfrm>
                <a:off x="1230379" y="2877459"/>
                <a:ext cx="2183711" cy="409927"/>
              </a:xfrm>
              <a:prstGeom prst="rect">
                <a:avLst/>
              </a:prstGeom>
              <a:solidFill>
                <a:schemeClr val="bg1"/>
              </a:solidFill>
            </p:spPr>
            <p:txBody>
              <a:bodyPr wrap="square" rtlCol="0">
                <a:spAutoFit/>
              </a:bodyPr>
              <a:lstStyle/>
              <a:p>
                <a:r>
                  <a:rPr lang="en-US" dirty="0" smtClean="0"/>
                  <a:t>    </a:t>
                </a:r>
                <a:r>
                  <a:rPr lang="en-US" sz="1200" dirty="0" smtClean="0">
                    <a:latin typeface="Arial" pitchFamily="34" charset="0"/>
                    <a:cs typeface="Arial" pitchFamily="34" charset="0"/>
                  </a:rPr>
                  <a:t>10            20           30 </a:t>
                </a:r>
                <a:endParaRPr lang="en-US" sz="1200" dirty="0">
                  <a:latin typeface="Arial" pitchFamily="34" charset="0"/>
                  <a:cs typeface="Arial" pitchFamily="34" charset="0"/>
                </a:endParaRPr>
              </a:p>
            </p:txBody>
          </p:sp>
          <p:sp>
            <p:nvSpPr>
              <p:cNvPr id="318" name="TextBox 317"/>
              <p:cNvSpPr txBox="1"/>
              <p:nvPr/>
            </p:nvSpPr>
            <p:spPr>
              <a:xfrm>
                <a:off x="1556792" y="3275856"/>
                <a:ext cx="1821332" cy="276999"/>
              </a:xfrm>
              <a:prstGeom prst="rect">
                <a:avLst/>
              </a:prstGeom>
              <a:noFill/>
            </p:spPr>
            <p:txBody>
              <a:bodyPr wrap="none" rtlCol="0">
                <a:spAutoFit/>
              </a:bodyPr>
              <a:lstStyle/>
              <a:p>
                <a:r>
                  <a:rPr lang="en-US" sz="1200" dirty="0" smtClean="0">
                    <a:latin typeface="Arial" pitchFamily="34" charset="0"/>
                    <a:cs typeface="Arial" pitchFamily="34" charset="0"/>
                  </a:rPr>
                  <a:t>Node number cut above</a:t>
                </a:r>
                <a:endParaRPr lang="en-US" sz="1200" dirty="0">
                  <a:latin typeface="Arial" pitchFamily="34" charset="0"/>
                  <a:cs typeface="Arial" pitchFamily="34" charset="0"/>
                </a:endParaRPr>
              </a:p>
            </p:txBody>
          </p:sp>
          <p:sp>
            <p:nvSpPr>
              <p:cNvPr id="319" name="TextBox 318"/>
              <p:cNvSpPr txBox="1"/>
              <p:nvPr/>
            </p:nvSpPr>
            <p:spPr>
              <a:xfrm rot="-5400000">
                <a:off x="-393756" y="2058052"/>
                <a:ext cx="2305888" cy="276999"/>
              </a:xfrm>
              <a:prstGeom prst="rect">
                <a:avLst/>
              </a:prstGeom>
              <a:noFill/>
            </p:spPr>
            <p:txBody>
              <a:bodyPr wrap="none" rtlCol="0">
                <a:spAutoFit/>
              </a:bodyPr>
              <a:lstStyle/>
              <a:p>
                <a:r>
                  <a:rPr lang="en-US" sz="1200" dirty="0" smtClean="0">
                    <a:latin typeface="Arial" pitchFamily="34" charset="0"/>
                    <a:cs typeface="Arial" pitchFamily="34" charset="0"/>
                  </a:rPr>
                  <a:t>Average length of branches cm</a:t>
                </a:r>
                <a:endParaRPr lang="en-US" sz="1200" dirty="0">
                  <a:latin typeface="Arial" pitchFamily="34" charset="0"/>
                  <a:cs typeface="Arial" pitchFamily="34" charset="0"/>
                </a:endParaRPr>
              </a:p>
            </p:txBody>
          </p:sp>
        </p:grpSp>
      </p:grpSp>
      <p:sp>
        <p:nvSpPr>
          <p:cNvPr id="297" name="TextBox 296"/>
          <p:cNvSpPr txBox="1"/>
          <p:nvPr/>
        </p:nvSpPr>
        <p:spPr>
          <a:xfrm>
            <a:off x="1196752" y="6371631"/>
            <a:ext cx="4680000" cy="1785104"/>
          </a:xfrm>
          <a:prstGeom prst="rect">
            <a:avLst/>
          </a:prstGeom>
          <a:noFill/>
        </p:spPr>
        <p:txBody>
          <a:bodyPr wrap="square" rtlCol="0">
            <a:spAutoFit/>
          </a:bodyPr>
          <a:lstStyle/>
          <a:p>
            <a:pPr algn="just"/>
            <a:r>
              <a:rPr lang="en-US" sz="1100" b="1" dirty="0" smtClean="0">
                <a:latin typeface="Times New Roman" panose="02020603050405020304" pitchFamily="18" charset="0"/>
                <a:cs typeface="Times New Roman" panose="02020603050405020304" pitchFamily="18" charset="0"/>
              </a:rPr>
              <a:t>Supplementary Fig. S1. </a:t>
            </a:r>
            <a:r>
              <a:rPr lang="en-US" sz="1100" dirty="0" smtClean="0">
                <a:latin typeface="Times New Roman" panose="02020603050405020304" pitchFamily="18" charset="0"/>
                <a:cs typeface="Times New Roman" panose="02020603050405020304" pitchFamily="18" charset="0"/>
              </a:rPr>
              <a:t>Effects of decapitation on AXB branching. </a:t>
            </a:r>
          </a:p>
          <a:p>
            <a:pPr algn="just"/>
            <a:r>
              <a:rPr lang="en-US" sz="1100" dirty="0" smtClean="0">
                <a:latin typeface="Times New Roman" panose="02020603050405020304" pitchFamily="18" charset="0"/>
                <a:cs typeface="Times New Roman" panose="02020603050405020304" pitchFamily="18" charset="0"/>
              </a:rPr>
              <a:t> </a:t>
            </a:r>
          </a:p>
          <a:p>
            <a:pPr algn="just"/>
            <a:r>
              <a:rPr lang="en-US" sz="1100" dirty="0" smtClean="0">
                <a:latin typeface="Times New Roman" panose="02020603050405020304" pitchFamily="18" charset="0"/>
                <a:cs typeface="Times New Roman" panose="02020603050405020304" pitchFamily="18" charset="0"/>
              </a:rPr>
              <a:t>(</a:t>
            </a:r>
            <a:r>
              <a:rPr lang="en-US" sz="1100" b="1" dirty="0" smtClean="0">
                <a:latin typeface="Times New Roman" panose="02020603050405020304" pitchFamily="18" charset="0"/>
                <a:cs typeface="Times New Roman" panose="02020603050405020304" pitchFamily="18" charset="0"/>
              </a:rPr>
              <a:t>A</a:t>
            </a:r>
            <a:r>
              <a:rPr lang="en-US" sz="1100" dirty="0" smtClean="0">
                <a:latin typeface="Times New Roman" panose="02020603050405020304" pitchFamily="18" charset="0"/>
                <a:cs typeface="Times New Roman" panose="02020603050405020304" pitchFamily="18" charset="0"/>
              </a:rPr>
              <a:t>) The effect of cutting on branch activation, and the establishment of branch hierarchy. Arrows and number indicate AXB activation and branch hierarchy </a:t>
            </a:r>
            <a:r>
              <a:rPr lang="en-US" sz="1100" dirty="0" smtClean="0">
                <a:latin typeface="Times New Roman" panose="02020603050405020304" pitchFamily="18" charset="0"/>
                <a:cs typeface="Times New Roman" panose="02020603050405020304" pitchFamily="18" charset="0"/>
              </a:rPr>
              <a:t>(red arrows indicate branches 1-3; 1 = longest). </a:t>
            </a:r>
            <a:r>
              <a:rPr lang="en-US" sz="1100" dirty="0" smtClean="0">
                <a:latin typeface="Times New Roman" panose="02020603050405020304" pitchFamily="18" charset="0"/>
                <a:cs typeface="Times New Roman" panose="02020603050405020304" pitchFamily="18" charset="0"/>
              </a:rPr>
              <a:t>(</a:t>
            </a:r>
            <a:r>
              <a:rPr lang="en-US" sz="1100" b="1" dirty="0" smtClean="0">
                <a:latin typeface="Times New Roman" panose="02020603050405020304" pitchFamily="18" charset="0"/>
                <a:cs typeface="Times New Roman" panose="02020603050405020304" pitchFamily="18" charset="0"/>
              </a:rPr>
              <a:t>B</a:t>
            </a:r>
            <a:r>
              <a:rPr lang="en-US" sz="1100" dirty="0" smtClean="0">
                <a:latin typeface="Times New Roman" panose="02020603050405020304" pitchFamily="18" charset="0"/>
                <a:cs typeface="Times New Roman" panose="02020603050405020304" pitchFamily="18" charset="0"/>
              </a:rPr>
              <a:t>) The average length of the branches after cutting at various distances in three mature AXB positions, above AXB number 10, 20 and 30, showed that all AXBs were able to produce branches, although at lower positions branch elongation </a:t>
            </a:r>
            <a:r>
              <a:rPr lang="en-US" sz="1100" smtClean="0">
                <a:latin typeface="Times New Roman" panose="02020603050405020304" pitchFamily="18" charset="0"/>
                <a:cs typeface="Times New Roman" panose="02020603050405020304" pitchFamily="18" charset="0"/>
              </a:rPr>
              <a:t>was </a:t>
            </a:r>
            <a:r>
              <a:rPr lang="en-US" sz="1100" smtClean="0">
                <a:latin typeface="Times New Roman" panose="02020603050405020304" pitchFamily="18" charset="0"/>
                <a:cs typeface="Times New Roman" panose="02020603050405020304" pitchFamily="18" charset="0"/>
              </a:rPr>
              <a:t>faster. </a:t>
            </a:r>
            <a:r>
              <a:rPr lang="en-US" sz="1100" dirty="0" smtClean="0">
                <a:latin typeface="Times New Roman" panose="02020603050405020304" pitchFamily="18" charset="0"/>
                <a:cs typeface="Times New Roman" panose="02020603050405020304" pitchFamily="18" charset="0"/>
              </a:rPr>
              <a:t>Values represent means ± SE (</a:t>
            </a:r>
            <a:r>
              <a:rPr lang="en-US" sz="1100" i="1" dirty="0" smtClean="0">
                <a:latin typeface="Times New Roman" panose="02020603050405020304" pitchFamily="18" charset="0"/>
                <a:cs typeface="Times New Roman" panose="02020603050405020304" pitchFamily="18" charset="0"/>
              </a:rPr>
              <a:t>n</a:t>
            </a:r>
            <a:r>
              <a:rPr lang="en-US" sz="1100" dirty="0" smtClean="0">
                <a:latin typeface="Times New Roman" panose="02020603050405020304" pitchFamily="18" charset="0"/>
                <a:cs typeface="Times New Roman" panose="02020603050405020304" pitchFamily="18" charset="0"/>
              </a:rPr>
              <a:t> = 10 plants per treatment).</a:t>
            </a:r>
          </a:p>
          <a:p>
            <a:pPr algn="just"/>
            <a:endParaRPr lang="en-US" sz="1100" dirty="0">
              <a:latin typeface="Times New Roman" pitchFamily="18" charset="0"/>
              <a:cs typeface="Times New Roman" pitchFamily="18" charset="0"/>
            </a:endParaRPr>
          </a:p>
        </p:txBody>
      </p:sp>
    </p:spTree>
    <p:extLst>
      <p:ext uri="{BB962C8B-B14F-4D97-AF65-F5344CB8AC3E}">
        <p14:creationId xmlns:p14="http://schemas.microsoft.com/office/powerpoint/2010/main" val="399604063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5</TotalTime>
  <Words>35</Words>
  <Application>Microsoft Office PowerPoint</Application>
  <PresentationFormat>On-screen Show (4:3)</PresentationFormat>
  <Paragraphs>13</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Times New Roman</vt:lpstr>
      <vt:lpstr>Office Theme</vt:lpstr>
      <vt:lpstr>PowerPoint Presentation</vt:lpstr>
    </vt:vector>
  </TitlesOfParts>
  <Company>UMB</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aivi Liisa Rinne</dc:creator>
  <cp:lastModifiedBy>Christiaan van der Schoot</cp:lastModifiedBy>
  <cp:revision>22</cp:revision>
  <dcterms:created xsi:type="dcterms:W3CDTF">2013-12-04T15:49:46Z</dcterms:created>
  <dcterms:modified xsi:type="dcterms:W3CDTF">2015-07-28T17:12:34Z</dcterms:modified>
</cp:coreProperties>
</file>